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092" r:id="rId2"/>
  </p:sldIdLst>
  <p:sldSz cx="6858000" cy="9906000" type="A4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794"/>
    <p:restoredTop sz="94942"/>
  </p:normalViewPr>
  <p:slideViewPr>
    <p:cSldViewPr snapToGrid="0">
      <p:cViewPr varScale="1">
        <p:scale>
          <a:sx n="89" d="100"/>
          <a:sy n="89" d="100"/>
        </p:scale>
        <p:origin x="992" y="1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3454;&#39564;&#23460;\CHIP\&#32508;&#21512;CHIP&#25968;&#25454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3454;&#39564;&#23460;\CHIP\&#32508;&#21512;CHIP&#25968;&#25454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3454;&#39564;&#23460;\CHIP\&#32508;&#21512;CHIP&#25968;&#2545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Q$14</c:f>
              <c:strCache>
                <c:ptCount val="1"/>
                <c:pt idx="0">
                  <c:v>cnt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Q$21:$Q$23</c:f>
                <c:numCache>
                  <c:formatCode>General</c:formatCode>
                  <c:ptCount val="3"/>
                  <c:pt idx="0">
                    <c:v>0.10484621215421737</c:v>
                  </c:pt>
                  <c:pt idx="1">
                    <c:v>0.673869772930027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cat>
            <c:strRef>
              <c:f>Sheet2!$P$15:$P$16</c:f>
              <c:strCache>
                <c:ptCount val="2"/>
                <c:pt idx="0">
                  <c:v>D</c:v>
                </c:pt>
                <c:pt idx="1">
                  <c:v>C</c:v>
                </c:pt>
              </c:strCache>
            </c:strRef>
          </c:cat>
          <c:val>
            <c:numRef>
              <c:f>Sheet2!$Q$15:$Q$16</c:f>
              <c:numCache>
                <c:formatCode>0.0</c:formatCode>
                <c:ptCount val="2"/>
                <c:pt idx="0">
                  <c:v>1.6220483745182435</c:v>
                </c:pt>
                <c:pt idx="1">
                  <c:v>4.0540018651623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EA-DC48-9060-E48A5CE050B6}"/>
            </c:ext>
          </c:extLst>
        </c:ser>
        <c:ser>
          <c:idx val="1"/>
          <c:order val="1"/>
          <c:tx>
            <c:strRef>
              <c:f>Sheet2!$R$14</c:f>
              <c:strCache>
                <c:ptCount val="1"/>
                <c:pt idx="0">
                  <c:v>imr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9050"/>
          </c:spPr>
          <c:invertIfNegative val="0"/>
          <c:errBars>
            <c:errBarType val="plus"/>
            <c:errValType val="cust"/>
            <c:noEndCap val="0"/>
            <c:plus>
              <c:numRef>
                <c:f>Sheet2!$R$21:$R$23</c:f>
                <c:numCache>
                  <c:formatCode>General</c:formatCode>
                  <c:ptCount val="3"/>
                  <c:pt idx="0">
                    <c:v>0.13494832675210588</c:v>
                  </c:pt>
                  <c:pt idx="1">
                    <c:v>0.315689255683075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cat>
            <c:strRef>
              <c:f>Sheet2!$P$15:$P$16</c:f>
              <c:strCache>
                <c:ptCount val="2"/>
                <c:pt idx="0">
                  <c:v>D</c:v>
                </c:pt>
                <c:pt idx="1">
                  <c:v>C</c:v>
                </c:pt>
              </c:strCache>
            </c:strRef>
          </c:cat>
          <c:val>
            <c:numRef>
              <c:f>Sheet2!$R$15:$R$16</c:f>
              <c:numCache>
                <c:formatCode>0.0</c:formatCode>
                <c:ptCount val="2"/>
                <c:pt idx="0">
                  <c:v>1.2511617335282128</c:v>
                </c:pt>
                <c:pt idx="1">
                  <c:v>2.92083547695777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EA-DC48-9060-E48A5CE050B6}"/>
            </c:ext>
          </c:extLst>
        </c:ser>
        <c:ser>
          <c:idx val="2"/>
          <c:order val="2"/>
          <c:tx>
            <c:strRef>
              <c:f>Sheet2!$S$14</c:f>
              <c:strCache>
                <c:ptCount val="1"/>
                <c:pt idx="0">
                  <c:v>d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S$21:$S$23</c:f>
                <c:numCache>
                  <c:formatCode>General</c:formatCode>
                  <c:ptCount val="3"/>
                  <c:pt idx="0">
                    <c:v>5.6779603804547996E-2</c:v>
                  </c:pt>
                  <c:pt idx="1">
                    <c:v>0.116234919288718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cat>
            <c:strRef>
              <c:f>Sheet2!$P$15:$P$16</c:f>
              <c:strCache>
                <c:ptCount val="2"/>
                <c:pt idx="0">
                  <c:v>D</c:v>
                </c:pt>
                <c:pt idx="1">
                  <c:v>C</c:v>
                </c:pt>
              </c:strCache>
            </c:strRef>
          </c:cat>
          <c:val>
            <c:numRef>
              <c:f>Sheet2!$S$15:$S$16</c:f>
              <c:numCache>
                <c:formatCode>0.0</c:formatCode>
                <c:ptCount val="2"/>
                <c:pt idx="0">
                  <c:v>0.15020447911270032</c:v>
                </c:pt>
                <c:pt idx="1">
                  <c:v>0.68129900431793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6EA-DC48-9060-E48A5CE050B6}"/>
            </c:ext>
          </c:extLst>
        </c:ser>
        <c:ser>
          <c:idx val="3"/>
          <c:order val="3"/>
          <c:tx>
            <c:strRef>
              <c:f>Sheet2!$T$14</c:f>
              <c:strCache>
                <c:ptCount val="1"/>
                <c:pt idx="0">
                  <c:v>d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T$21:$T$23</c:f>
                <c:numCache>
                  <c:formatCode>General</c:formatCode>
                  <c:ptCount val="3"/>
                  <c:pt idx="0">
                    <c:v>0.2078097806661843</c:v>
                  </c:pt>
                  <c:pt idx="1">
                    <c:v>9.031163962143386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cat>
            <c:strRef>
              <c:f>Sheet2!$P$15:$P$16</c:f>
              <c:strCache>
                <c:ptCount val="2"/>
                <c:pt idx="0">
                  <c:v>D</c:v>
                </c:pt>
                <c:pt idx="1">
                  <c:v>C</c:v>
                </c:pt>
              </c:strCache>
            </c:strRef>
          </c:cat>
          <c:val>
            <c:numRef>
              <c:f>Sheet2!$T$15:$T$16</c:f>
              <c:numCache>
                <c:formatCode>0.0</c:formatCode>
                <c:ptCount val="2"/>
                <c:pt idx="0">
                  <c:v>0.67589103006632867</c:v>
                </c:pt>
                <c:pt idx="1">
                  <c:v>1.1308381923680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6EA-DC48-9060-E48A5CE050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0"/>
        <c:axId val="204038144"/>
        <c:axId val="203758912"/>
      </c:barChart>
      <c:catAx>
        <c:axId val="20403814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03758912"/>
        <c:crosses val="autoZero"/>
        <c:auto val="1"/>
        <c:lblAlgn val="ctr"/>
        <c:lblOffset val="100"/>
        <c:noMultiLvlLbl val="0"/>
      </c:catAx>
      <c:valAx>
        <c:axId val="203758912"/>
        <c:scaling>
          <c:orientation val="minMax"/>
          <c:max val="5"/>
          <c:min val="0"/>
        </c:scaling>
        <c:delete val="0"/>
        <c:axPos val="l"/>
        <c:numFmt formatCode="0.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Helvetica" pitchFamily="2" charset="0"/>
              </a:defRPr>
            </a:pPr>
            <a:endParaRPr lang="ja-CN"/>
          </a:p>
        </c:txPr>
        <c:crossAx val="204038144"/>
        <c:crosses val="autoZero"/>
        <c:crossBetween val="between"/>
        <c:majorUnit val="1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Y$14</c:f>
              <c:strCache>
                <c:ptCount val="1"/>
                <c:pt idx="0">
                  <c:v>cnt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Y$19:$Y$20</c:f>
                <c:numCache>
                  <c:formatCode>General</c:formatCode>
                  <c:ptCount val="2"/>
                  <c:pt idx="0">
                    <c:v>0.17153324356305438</c:v>
                  </c:pt>
                  <c:pt idx="1">
                    <c:v>0.790505136738057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Y$15:$Y$16</c:f>
              <c:numCache>
                <c:formatCode>0.0</c:formatCode>
                <c:ptCount val="2"/>
                <c:pt idx="0">
                  <c:v>1.9964944502292734</c:v>
                </c:pt>
                <c:pt idx="1">
                  <c:v>4.02448013703315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83-8D4E-8B56-B2ABC5677A38}"/>
            </c:ext>
          </c:extLst>
        </c:ser>
        <c:ser>
          <c:idx val="1"/>
          <c:order val="1"/>
          <c:tx>
            <c:strRef>
              <c:f>Sheet1!$Z$14</c:f>
              <c:strCache>
                <c:ptCount val="1"/>
                <c:pt idx="0">
                  <c:v>imr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Z$19:$Z$20</c:f>
                <c:numCache>
                  <c:formatCode>General</c:formatCode>
                  <c:ptCount val="2"/>
                  <c:pt idx="0">
                    <c:v>0.14639884564900482</c:v>
                  </c:pt>
                  <c:pt idx="1">
                    <c:v>0.199962682845061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Z$15:$Z$16</c:f>
              <c:numCache>
                <c:formatCode>0.0</c:formatCode>
                <c:ptCount val="2"/>
                <c:pt idx="0">
                  <c:v>1.5652124058962791</c:v>
                </c:pt>
                <c:pt idx="1">
                  <c:v>3.2874727280333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983-8D4E-8B56-B2ABC5677A38}"/>
            </c:ext>
          </c:extLst>
        </c:ser>
        <c:ser>
          <c:idx val="2"/>
          <c:order val="2"/>
          <c:tx>
            <c:strRef>
              <c:f>Sheet1!$AA$14</c:f>
              <c:strCache>
                <c:ptCount val="1"/>
                <c:pt idx="0">
                  <c:v>d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AA$19:$AA$20</c:f>
                <c:numCache>
                  <c:formatCode>General</c:formatCode>
                  <c:ptCount val="2"/>
                  <c:pt idx="0">
                    <c:v>0.1681520242541327</c:v>
                  </c:pt>
                  <c:pt idx="1">
                    <c:v>0.193310421920605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AA$15:$AA$16</c:f>
              <c:numCache>
                <c:formatCode>0.0</c:formatCode>
                <c:ptCount val="2"/>
                <c:pt idx="0">
                  <c:v>1.1071153273010466</c:v>
                </c:pt>
                <c:pt idx="1">
                  <c:v>2.181552445978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983-8D4E-8B56-B2ABC5677A38}"/>
            </c:ext>
          </c:extLst>
        </c:ser>
        <c:ser>
          <c:idx val="3"/>
          <c:order val="3"/>
          <c:tx>
            <c:strRef>
              <c:f>Sheet1!$AB$14</c:f>
              <c:strCache>
                <c:ptCount val="1"/>
                <c:pt idx="0">
                  <c:v>d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AB$19:$AB$20</c:f>
                <c:numCache>
                  <c:formatCode>General</c:formatCode>
                  <c:ptCount val="2"/>
                  <c:pt idx="0">
                    <c:v>0.27076225289495742</c:v>
                  </c:pt>
                  <c:pt idx="1">
                    <c:v>0.32974660977673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AB$15:$AB$16</c:f>
              <c:numCache>
                <c:formatCode>0.0</c:formatCode>
                <c:ptCount val="2"/>
                <c:pt idx="0">
                  <c:v>1.5648020229000681</c:v>
                </c:pt>
                <c:pt idx="1">
                  <c:v>3.07287518432967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983-8D4E-8B56-B2ABC5677A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0"/>
        <c:axId val="282080768"/>
        <c:axId val="226587136"/>
      </c:barChart>
      <c:catAx>
        <c:axId val="282080768"/>
        <c:scaling>
          <c:orientation val="minMax"/>
        </c:scaling>
        <c:delete val="1"/>
        <c:axPos val="b"/>
        <c:majorTickMark val="out"/>
        <c:minorTickMark val="none"/>
        <c:tickLblPos val="nextTo"/>
        <c:crossAx val="226587136"/>
        <c:crosses val="autoZero"/>
        <c:auto val="1"/>
        <c:lblAlgn val="ctr"/>
        <c:lblOffset val="100"/>
        <c:noMultiLvlLbl val="0"/>
      </c:catAx>
      <c:valAx>
        <c:axId val="226587136"/>
        <c:scaling>
          <c:orientation val="minMax"/>
          <c:max val="5"/>
        </c:scaling>
        <c:delete val="0"/>
        <c:axPos val="l"/>
        <c:numFmt formatCode="0.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  <a:effectLst/>
        </c:spPr>
        <c:txPr>
          <a:bodyPr/>
          <a:lstStyle/>
          <a:p>
            <a:pPr>
              <a:defRPr sz="800" b="0">
                <a:latin typeface="Helvetica" pitchFamily="2" charset="0"/>
              </a:defRPr>
            </a:pPr>
            <a:endParaRPr lang="ja-CN"/>
          </a:p>
        </c:txPr>
        <c:crossAx val="282080768"/>
        <c:crosses val="autoZero"/>
        <c:crossBetween val="between"/>
        <c:majorUnit val="1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46175401723401"/>
          <c:y val="8.4350531100409132E-2"/>
          <c:w val="0.80250492207699786"/>
          <c:h val="0.831298937799181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Y$25</c:f>
              <c:strCache>
                <c:ptCount val="1"/>
                <c:pt idx="0">
                  <c:v>cnt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Y$30:$Y$31</c:f>
                <c:numCache>
                  <c:formatCode>General</c:formatCode>
                  <c:ptCount val="2"/>
                  <c:pt idx="0">
                    <c:v>0.33156249736815818</c:v>
                  </c:pt>
                  <c:pt idx="1">
                    <c:v>0.205234369838918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Y$26:$Y$27</c:f>
              <c:numCache>
                <c:formatCode>0.0</c:formatCode>
                <c:ptCount val="2"/>
                <c:pt idx="0">
                  <c:v>1.0615367288074331</c:v>
                </c:pt>
                <c:pt idx="1">
                  <c:v>0.546057594535226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D9-9147-A789-B309DCD9F603}"/>
            </c:ext>
          </c:extLst>
        </c:ser>
        <c:ser>
          <c:idx val="1"/>
          <c:order val="1"/>
          <c:tx>
            <c:strRef>
              <c:f>Sheet1!$Z$25</c:f>
              <c:strCache>
                <c:ptCount val="1"/>
                <c:pt idx="0">
                  <c:v>imr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Z$30:$Z$31</c:f>
                <c:numCache>
                  <c:formatCode>General</c:formatCode>
                  <c:ptCount val="2"/>
                  <c:pt idx="0">
                    <c:v>6.4029250025274209E-2</c:v>
                  </c:pt>
                  <c:pt idx="1">
                    <c:v>7.251212065138033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Z$26:$Z$27</c:f>
              <c:numCache>
                <c:formatCode>0.0</c:formatCode>
                <c:ptCount val="2"/>
                <c:pt idx="0">
                  <c:v>0.63536749955361227</c:v>
                </c:pt>
                <c:pt idx="1">
                  <c:v>0.690230298664628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D9-9147-A789-B309DCD9F603}"/>
            </c:ext>
          </c:extLst>
        </c:ser>
        <c:ser>
          <c:idx val="2"/>
          <c:order val="2"/>
          <c:tx>
            <c:strRef>
              <c:f>Sheet1!$AA$25</c:f>
              <c:strCache>
                <c:ptCount val="1"/>
                <c:pt idx="0">
                  <c:v>d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AA$30:$AA$31</c:f>
                <c:numCache>
                  <c:formatCode>General</c:formatCode>
                  <c:ptCount val="2"/>
                  <c:pt idx="0">
                    <c:v>9.7670287050670074E-2</c:v>
                  </c:pt>
                  <c:pt idx="1">
                    <c:v>0.194755111569968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AA$26:$AA$27</c:f>
              <c:numCache>
                <c:formatCode>0.0</c:formatCode>
                <c:ptCount val="2"/>
                <c:pt idx="0">
                  <c:v>1.0192031512887487</c:v>
                </c:pt>
                <c:pt idx="1">
                  <c:v>1.10353749193549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D9-9147-A789-B309DCD9F603}"/>
            </c:ext>
          </c:extLst>
        </c:ser>
        <c:ser>
          <c:idx val="3"/>
          <c:order val="3"/>
          <c:tx>
            <c:strRef>
              <c:f>Sheet1!$AB$25</c:f>
              <c:strCache>
                <c:ptCount val="1"/>
                <c:pt idx="0">
                  <c:v>d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AB$30:$AB$31</c:f>
                <c:numCache>
                  <c:formatCode>General</c:formatCode>
                  <c:ptCount val="2"/>
                  <c:pt idx="0">
                    <c:v>0.14646298307679601</c:v>
                  </c:pt>
                  <c:pt idx="1">
                    <c:v>5.86237828569983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val>
            <c:numRef>
              <c:f>Sheet1!$AB$26:$AB$27</c:f>
              <c:numCache>
                <c:formatCode>0.0</c:formatCode>
                <c:ptCount val="2"/>
                <c:pt idx="0">
                  <c:v>1.155576482959219</c:v>
                </c:pt>
                <c:pt idx="1">
                  <c:v>0.983377023509335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0D9-9147-A789-B309DCD9F6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0"/>
        <c:axId val="247579136"/>
        <c:axId val="205131712"/>
      </c:barChart>
      <c:catAx>
        <c:axId val="247579136"/>
        <c:scaling>
          <c:orientation val="minMax"/>
        </c:scaling>
        <c:delete val="1"/>
        <c:axPos val="b"/>
        <c:majorTickMark val="out"/>
        <c:minorTickMark val="none"/>
        <c:tickLblPos val="nextTo"/>
        <c:crossAx val="205131712"/>
        <c:crosses val="autoZero"/>
        <c:auto val="1"/>
        <c:lblAlgn val="ctr"/>
        <c:lblOffset val="100"/>
        <c:noMultiLvlLbl val="0"/>
      </c:catAx>
      <c:valAx>
        <c:axId val="205131712"/>
        <c:scaling>
          <c:orientation val="minMax"/>
          <c:max val="5"/>
        </c:scaling>
        <c:delete val="0"/>
        <c:axPos val="l"/>
        <c:numFmt formatCode="0.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Helvetica" pitchFamily="2" charset="0"/>
              </a:defRPr>
            </a:pPr>
            <a:endParaRPr lang="ja-CN"/>
          </a:p>
        </c:txPr>
        <c:crossAx val="247579136"/>
        <c:crosses val="autoZero"/>
        <c:crossBetween val="between"/>
        <c:majorUnit val="1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CN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383770-218B-2E43-875B-2F00AC76ACE0}" type="datetimeFigureOut">
              <a:rPr kumimoji="1" lang="ja-CN" altLang="en-US" smtClean="0"/>
              <a:t>2024/2/27</a:t>
            </a:fld>
            <a:endParaRPr kumimoji="1" lang="ja-CN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1243013"/>
            <a:ext cx="2322513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CN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3537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CN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CN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EE397A-D2E9-D340-B759-67953A379D1F}" type="slidenum">
              <a:rPr kumimoji="1" lang="ja-CN" altLang="en-US" smtClean="0"/>
              <a:t>‹#›</a:t>
            </a:fld>
            <a:endParaRPr kumimoji="1" lang="ja-CN" altLang="en-US"/>
          </a:p>
        </p:txBody>
      </p:sp>
    </p:spTree>
    <p:extLst>
      <p:ext uri="{BB962C8B-B14F-4D97-AF65-F5344CB8AC3E}">
        <p14:creationId xmlns:p14="http://schemas.microsoft.com/office/powerpoint/2010/main" val="26930213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CF301-0CAD-496C-B260-AFD2F8CF6B41}" type="datetimeFigureOut">
              <a:rPr kumimoji="1" lang="ja-JP" altLang="en-US" smtClean="0"/>
              <a:pPr/>
              <a:t>202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3267C-BDFD-4F65-982E-1E72DF2EBDA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CC09D37-D3EF-3322-D0AD-B089712CE535}"/>
              </a:ext>
            </a:extLst>
          </p:cNvPr>
          <p:cNvSpPr txBox="1"/>
          <p:nvPr/>
        </p:nvSpPr>
        <p:spPr>
          <a:xfrm>
            <a:off x="210040" y="186267"/>
            <a:ext cx="9829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CN" sz="1600" b="1" dirty="0">
                <a:latin typeface="Helvetica" pitchFamily="2" charset="0"/>
              </a:rPr>
              <a:t>Figure 1</a:t>
            </a:r>
            <a:endParaRPr kumimoji="1" lang="ja-CN" altLang="en-US" sz="1600" dirty="0"/>
          </a:p>
        </p:txBody>
      </p:sp>
      <p:grpSp>
        <p:nvGrpSpPr>
          <p:cNvPr id="306" name="グループ化 305">
            <a:extLst>
              <a:ext uri="{FF2B5EF4-FFF2-40B4-BE49-F238E27FC236}">
                <a16:creationId xmlns:a16="http://schemas.microsoft.com/office/drawing/2014/main" id="{28545234-2F41-9085-7977-A52C604F4FCE}"/>
              </a:ext>
            </a:extLst>
          </p:cNvPr>
          <p:cNvGrpSpPr/>
          <p:nvPr/>
        </p:nvGrpSpPr>
        <p:grpSpPr>
          <a:xfrm>
            <a:off x="1208551" y="1404282"/>
            <a:ext cx="1896157" cy="2565844"/>
            <a:chOff x="492664" y="5827232"/>
            <a:chExt cx="2495118" cy="3376346"/>
          </a:xfrm>
        </p:grpSpPr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3426A3AF-0166-0F0A-9598-DA406EF50518}"/>
                </a:ext>
              </a:extLst>
            </p:cNvPr>
            <p:cNvSpPr txBox="1"/>
            <p:nvPr/>
          </p:nvSpPr>
          <p:spPr>
            <a:xfrm>
              <a:off x="492664" y="5827232"/>
              <a:ext cx="295275" cy="277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CN" sz="1200" b="1" dirty="0">
                  <a:latin typeface="Helvetica" pitchFamily="2" charset="0"/>
                </a:rPr>
                <a:t>A</a:t>
              </a:r>
              <a:endParaRPr kumimoji="1" lang="ja-CN" altLang="en-US" sz="1200" b="1" dirty="0">
                <a:latin typeface="Helvetica" pitchFamily="2" charset="0"/>
              </a:endParaRPr>
            </a:p>
          </p:txBody>
        </p:sp>
        <p:sp>
          <p:nvSpPr>
            <p:cNvPr id="298" name="フリーフォーム 297">
              <a:extLst>
                <a:ext uri="{FF2B5EF4-FFF2-40B4-BE49-F238E27FC236}">
                  <a16:creationId xmlns:a16="http://schemas.microsoft.com/office/drawing/2014/main" id="{662A14E0-98D0-5619-3FB7-EF24BF8A4FC3}"/>
                </a:ext>
              </a:extLst>
            </p:cNvPr>
            <p:cNvSpPr/>
            <p:nvPr/>
          </p:nvSpPr>
          <p:spPr>
            <a:xfrm>
              <a:off x="1057641" y="8161775"/>
              <a:ext cx="1099646" cy="737059"/>
            </a:xfrm>
            <a:custGeom>
              <a:avLst/>
              <a:gdLst>
                <a:gd name="connsiteX0" fmla="*/ 526489 w 1224327"/>
                <a:gd name="connsiteY0" fmla="*/ 312990 h 830650"/>
                <a:gd name="connsiteX1" fmla="*/ 278011 w 1224327"/>
                <a:gd name="connsiteY1" fmla="*/ 183781 h 830650"/>
                <a:gd name="connsiteX2" fmla="*/ 69289 w 1224327"/>
                <a:gd name="connsiteY2" fmla="*/ 213598 h 830650"/>
                <a:gd name="connsiteX3" fmla="*/ 9654 w 1224327"/>
                <a:gd name="connsiteY3" fmla="*/ 462077 h 830650"/>
                <a:gd name="connsiteX4" fmla="*/ 248193 w 1224327"/>
                <a:gd name="connsiteY4" fmla="*/ 760251 h 830650"/>
                <a:gd name="connsiteX5" fmla="*/ 953872 w 1224327"/>
                <a:gd name="connsiteY5" fmla="*/ 809946 h 830650"/>
                <a:gd name="connsiteX6" fmla="*/ 1222228 w 1224327"/>
                <a:gd name="connsiteY6" fmla="*/ 481955 h 830650"/>
                <a:gd name="connsiteX7" fmla="*/ 1063202 w 1224327"/>
                <a:gd name="connsiteY7" fmla="*/ 14816 h 830650"/>
                <a:gd name="connsiteX8" fmla="*/ 784906 w 1224327"/>
                <a:gd name="connsiteY8" fmla="*/ 144025 h 830650"/>
                <a:gd name="connsiteX9" fmla="*/ 844541 w 1224327"/>
                <a:gd name="connsiteY9" fmla="*/ 422320 h 830650"/>
                <a:gd name="connsiteX10" fmla="*/ 576185 w 1224327"/>
                <a:gd name="connsiteY10" fmla="*/ 531651 h 830650"/>
                <a:gd name="connsiteX11" fmla="*/ 556306 w 1224327"/>
                <a:gd name="connsiteY11" fmla="*/ 362685 h 830650"/>
                <a:gd name="connsiteX12" fmla="*/ 526489 w 1224327"/>
                <a:gd name="connsiteY12" fmla="*/ 312990 h 8306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224327" h="830650">
                  <a:moveTo>
                    <a:pt x="526489" y="312990"/>
                  </a:moveTo>
                  <a:cubicBezTo>
                    <a:pt x="480107" y="283173"/>
                    <a:pt x="354211" y="200346"/>
                    <a:pt x="278011" y="183781"/>
                  </a:cubicBezTo>
                  <a:cubicBezTo>
                    <a:pt x="201811" y="167216"/>
                    <a:pt x="114015" y="167215"/>
                    <a:pt x="69289" y="213598"/>
                  </a:cubicBezTo>
                  <a:cubicBezTo>
                    <a:pt x="24563" y="259981"/>
                    <a:pt x="-20163" y="370968"/>
                    <a:pt x="9654" y="462077"/>
                  </a:cubicBezTo>
                  <a:cubicBezTo>
                    <a:pt x="39471" y="553186"/>
                    <a:pt x="90823" y="702273"/>
                    <a:pt x="248193" y="760251"/>
                  </a:cubicBezTo>
                  <a:cubicBezTo>
                    <a:pt x="405563" y="818229"/>
                    <a:pt x="791533" y="856329"/>
                    <a:pt x="953872" y="809946"/>
                  </a:cubicBezTo>
                  <a:cubicBezTo>
                    <a:pt x="1116211" y="763563"/>
                    <a:pt x="1204006" y="614477"/>
                    <a:pt x="1222228" y="481955"/>
                  </a:cubicBezTo>
                  <a:cubicBezTo>
                    <a:pt x="1240450" y="349433"/>
                    <a:pt x="1136089" y="71138"/>
                    <a:pt x="1063202" y="14816"/>
                  </a:cubicBezTo>
                  <a:cubicBezTo>
                    <a:pt x="990315" y="-41506"/>
                    <a:pt x="821349" y="76108"/>
                    <a:pt x="784906" y="144025"/>
                  </a:cubicBezTo>
                  <a:cubicBezTo>
                    <a:pt x="748463" y="211942"/>
                    <a:pt x="879328" y="357716"/>
                    <a:pt x="844541" y="422320"/>
                  </a:cubicBezTo>
                  <a:cubicBezTo>
                    <a:pt x="809754" y="486924"/>
                    <a:pt x="624224" y="541590"/>
                    <a:pt x="576185" y="531651"/>
                  </a:cubicBezTo>
                  <a:cubicBezTo>
                    <a:pt x="528146" y="521712"/>
                    <a:pt x="556306" y="362685"/>
                    <a:pt x="556306" y="362685"/>
                  </a:cubicBezTo>
                  <a:cubicBezTo>
                    <a:pt x="549680" y="327898"/>
                    <a:pt x="572871" y="342807"/>
                    <a:pt x="526489" y="312990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CN" altLang="en-US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4AA7F0C5-2EA8-A127-25DA-6807DF424DC3}"/>
                </a:ext>
              </a:extLst>
            </p:cNvPr>
            <p:cNvSpPr txBox="1"/>
            <p:nvPr/>
          </p:nvSpPr>
          <p:spPr>
            <a:xfrm>
              <a:off x="1915867" y="5900773"/>
              <a:ext cx="682580" cy="283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CN" sz="800" b="1" dirty="0">
                  <a:solidFill>
                    <a:schemeClr val="accent5"/>
                  </a:solidFill>
                  <a:latin typeface="Helvetica" pitchFamily="2" charset="0"/>
                </a:rPr>
                <a:t>Psm1</a:t>
              </a:r>
              <a:endParaRPr kumimoji="1" lang="ja-CN" altLang="en-US" sz="800" b="1" dirty="0">
                <a:solidFill>
                  <a:schemeClr val="accent5"/>
                </a:solidFill>
                <a:latin typeface="Helvetica" pitchFamily="2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680F8E4E-A1AA-11E1-A4CA-17503D024A4A}"/>
                </a:ext>
              </a:extLst>
            </p:cNvPr>
            <p:cNvSpPr txBox="1"/>
            <p:nvPr/>
          </p:nvSpPr>
          <p:spPr>
            <a:xfrm>
              <a:off x="1265605" y="8920079"/>
              <a:ext cx="728152" cy="283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oading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49" name="右矢印 48">
              <a:extLst>
                <a:ext uri="{FF2B5EF4-FFF2-40B4-BE49-F238E27FC236}">
                  <a16:creationId xmlns:a16="http://schemas.microsoft.com/office/drawing/2014/main" id="{49C8B202-9BE4-C08B-8E61-A18C89CAE66D}"/>
                </a:ext>
              </a:extLst>
            </p:cNvPr>
            <p:cNvSpPr/>
            <p:nvPr/>
          </p:nvSpPr>
          <p:spPr>
            <a:xfrm>
              <a:off x="2378290" y="7470030"/>
              <a:ext cx="609492" cy="361574"/>
            </a:xfrm>
            <a:prstGeom prst="rightArrow">
              <a:avLst>
                <a:gd name="adj1" fmla="val 25000"/>
                <a:gd name="adj2" fmla="val 50000"/>
              </a:avLst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grpSp>
          <p:nvGrpSpPr>
            <p:cNvPr id="168" name="グループ化 167">
              <a:extLst>
                <a:ext uri="{FF2B5EF4-FFF2-40B4-BE49-F238E27FC236}">
                  <a16:creationId xmlns:a16="http://schemas.microsoft.com/office/drawing/2014/main" id="{98B5A7F5-4942-5B58-B362-07EA48404822}"/>
                </a:ext>
              </a:extLst>
            </p:cNvPr>
            <p:cNvGrpSpPr/>
            <p:nvPr/>
          </p:nvGrpSpPr>
          <p:grpSpPr>
            <a:xfrm>
              <a:off x="919432" y="5923669"/>
              <a:ext cx="1482429" cy="2426828"/>
              <a:chOff x="3807215" y="1058934"/>
              <a:chExt cx="1348422" cy="2207450"/>
            </a:xfrm>
          </p:grpSpPr>
          <p:sp>
            <p:nvSpPr>
              <p:cNvPr id="186" name="フリーフォーム 185">
                <a:extLst>
                  <a:ext uri="{FF2B5EF4-FFF2-40B4-BE49-F238E27FC236}">
                    <a16:creationId xmlns:a16="http://schemas.microsoft.com/office/drawing/2014/main" id="{BB1B6678-6AA5-7FC9-E49F-024CF076617F}"/>
                  </a:ext>
                </a:extLst>
              </p:cNvPr>
              <p:cNvSpPr/>
              <p:nvPr/>
            </p:nvSpPr>
            <p:spPr>
              <a:xfrm rot="21263862">
                <a:off x="3807215" y="2090726"/>
                <a:ext cx="1036959" cy="1175658"/>
              </a:xfrm>
              <a:custGeom>
                <a:avLst/>
                <a:gdLst>
                  <a:gd name="connsiteX0" fmla="*/ 548384 w 1083438"/>
                  <a:gd name="connsiteY0" fmla="*/ 1052454 h 1352588"/>
                  <a:gd name="connsiteX1" fmla="*/ 646355 w 1083438"/>
                  <a:gd name="connsiteY1" fmla="*/ 1030683 h 1352588"/>
                  <a:gd name="connsiteX2" fmla="*/ 689898 w 1083438"/>
                  <a:gd name="connsiteY2" fmla="*/ 910940 h 1352588"/>
                  <a:gd name="connsiteX3" fmla="*/ 689898 w 1083438"/>
                  <a:gd name="connsiteY3" fmla="*/ 769426 h 1352588"/>
                  <a:gd name="connsiteX4" fmla="*/ 722555 w 1083438"/>
                  <a:gd name="connsiteY4" fmla="*/ 617026 h 1352588"/>
                  <a:gd name="connsiteX5" fmla="*/ 755213 w 1083438"/>
                  <a:gd name="connsiteY5" fmla="*/ 551711 h 1352588"/>
                  <a:gd name="connsiteX6" fmla="*/ 874955 w 1083438"/>
                  <a:gd name="connsiteY6" fmla="*/ 529940 h 1352588"/>
                  <a:gd name="connsiteX7" fmla="*/ 1016470 w 1083438"/>
                  <a:gd name="connsiteY7" fmla="*/ 562597 h 1352588"/>
                  <a:gd name="connsiteX8" fmla="*/ 1081784 w 1083438"/>
                  <a:gd name="connsiteY8" fmla="*/ 682340 h 1352588"/>
                  <a:gd name="connsiteX9" fmla="*/ 1049127 w 1083438"/>
                  <a:gd name="connsiteY9" fmla="*/ 802083 h 1352588"/>
                  <a:gd name="connsiteX10" fmla="*/ 896727 w 1083438"/>
                  <a:gd name="connsiteY10" fmla="*/ 878283 h 1352588"/>
                  <a:gd name="connsiteX11" fmla="*/ 842298 w 1083438"/>
                  <a:gd name="connsiteY11" fmla="*/ 921826 h 1352588"/>
                  <a:gd name="connsiteX12" fmla="*/ 820527 w 1083438"/>
                  <a:gd name="connsiteY12" fmla="*/ 1074226 h 1352588"/>
                  <a:gd name="connsiteX13" fmla="*/ 787870 w 1083438"/>
                  <a:gd name="connsiteY13" fmla="*/ 1226626 h 1352588"/>
                  <a:gd name="connsiteX14" fmla="*/ 613698 w 1083438"/>
                  <a:gd name="connsiteY14" fmla="*/ 1346368 h 1352588"/>
                  <a:gd name="connsiteX15" fmla="*/ 395984 w 1083438"/>
                  <a:gd name="connsiteY15" fmla="*/ 1313711 h 1352588"/>
                  <a:gd name="connsiteX16" fmla="*/ 276241 w 1083438"/>
                  <a:gd name="connsiteY16" fmla="*/ 1128654 h 1352588"/>
                  <a:gd name="connsiteX17" fmla="*/ 308898 w 1083438"/>
                  <a:gd name="connsiteY17" fmla="*/ 910940 h 1352588"/>
                  <a:gd name="connsiteX18" fmla="*/ 406870 w 1083438"/>
                  <a:gd name="connsiteY18" fmla="*/ 704111 h 1352588"/>
                  <a:gd name="connsiteX19" fmla="*/ 287127 w 1083438"/>
                  <a:gd name="connsiteY19" fmla="*/ 486397 h 1352588"/>
                  <a:gd name="connsiteX20" fmla="*/ 80298 w 1083438"/>
                  <a:gd name="connsiteY20" fmla="*/ 301340 h 1352588"/>
                  <a:gd name="connsiteX21" fmla="*/ 4098 w 1083438"/>
                  <a:gd name="connsiteY21" fmla="*/ 138054 h 1352588"/>
                  <a:gd name="connsiteX22" fmla="*/ 25870 w 1083438"/>
                  <a:gd name="connsiteY22" fmla="*/ 29197 h 1352588"/>
                  <a:gd name="connsiteX23" fmla="*/ 156498 w 1083438"/>
                  <a:gd name="connsiteY23" fmla="*/ 7426 h 1352588"/>
                  <a:gd name="connsiteX24" fmla="*/ 352441 w 1083438"/>
                  <a:gd name="connsiteY24" fmla="*/ 138054 h 1352588"/>
                  <a:gd name="connsiteX25" fmla="*/ 537498 w 1083438"/>
                  <a:gd name="connsiteY25" fmla="*/ 410197 h 1352588"/>
                  <a:gd name="connsiteX26" fmla="*/ 570155 w 1083438"/>
                  <a:gd name="connsiteY26" fmla="*/ 562597 h 1352588"/>
                  <a:gd name="connsiteX27" fmla="*/ 570155 w 1083438"/>
                  <a:gd name="connsiteY27" fmla="*/ 758540 h 1352588"/>
                  <a:gd name="connsiteX28" fmla="*/ 504841 w 1083438"/>
                  <a:gd name="connsiteY28" fmla="*/ 965368 h 1352588"/>
                  <a:gd name="connsiteX29" fmla="*/ 548384 w 1083438"/>
                  <a:gd name="connsiteY29" fmla="*/ 1052454 h 13525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1083438" h="1352588">
                    <a:moveTo>
                      <a:pt x="548384" y="1052454"/>
                    </a:moveTo>
                    <a:cubicBezTo>
                      <a:pt x="571970" y="1063340"/>
                      <a:pt x="622769" y="1054269"/>
                      <a:pt x="646355" y="1030683"/>
                    </a:cubicBezTo>
                    <a:cubicBezTo>
                      <a:pt x="669941" y="1007097"/>
                      <a:pt x="682641" y="954483"/>
                      <a:pt x="689898" y="910940"/>
                    </a:cubicBezTo>
                    <a:cubicBezTo>
                      <a:pt x="697155" y="867397"/>
                      <a:pt x="684455" y="818412"/>
                      <a:pt x="689898" y="769426"/>
                    </a:cubicBezTo>
                    <a:cubicBezTo>
                      <a:pt x="695341" y="720440"/>
                      <a:pt x="722555" y="617026"/>
                      <a:pt x="722555" y="617026"/>
                    </a:cubicBezTo>
                    <a:cubicBezTo>
                      <a:pt x="733441" y="580740"/>
                      <a:pt x="729813" y="566225"/>
                      <a:pt x="755213" y="551711"/>
                    </a:cubicBezTo>
                    <a:cubicBezTo>
                      <a:pt x="780613" y="537197"/>
                      <a:pt x="831412" y="528126"/>
                      <a:pt x="874955" y="529940"/>
                    </a:cubicBezTo>
                    <a:cubicBezTo>
                      <a:pt x="918498" y="531754"/>
                      <a:pt x="981999" y="537197"/>
                      <a:pt x="1016470" y="562597"/>
                    </a:cubicBezTo>
                    <a:cubicBezTo>
                      <a:pt x="1050941" y="587997"/>
                      <a:pt x="1076341" y="642426"/>
                      <a:pt x="1081784" y="682340"/>
                    </a:cubicBezTo>
                    <a:cubicBezTo>
                      <a:pt x="1087227" y="722254"/>
                      <a:pt x="1079970" y="769426"/>
                      <a:pt x="1049127" y="802083"/>
                    </a:cubicBezTo>
                    <a:cubicBezTo>
                      <a:pt x="1018284" y="834740"/>
                      <a:pt x="896727" y="878283"/>
                      <a:pt x="896727" y="878283"/>
                    </a:cubicBezTo>
                    <a:cubicBezTo>
                      <a:pt x="862256" y="898240"/>
                      <a:pt x="854998" y="889169"/>
                      <a:pt x="842298" y="921826"/>
                    </a:cubicBezTo>
                    <a:cubicBezTo>
                      <a:pt x="829598" y="954483"/>
                      <a:pt x="829598" y="1023426"/>
                      <a:pt x="820527" y="1074226"/>
                    </a:cubicBezTo>
                    <a:cubicBezTo>
                      <a:pt x="811456" y="1125026"/>
                      <a:pt x="822341" y="1181269"/>
                      <a:pt x="787870" y="1226626"/>
                    </a:cubicBezTo>
                    <a:cubicBezTo>
                      <a:pt x="753399" y="1271983"/>
                      <a:pt x="679012" y="1331854"/>
                      <a:pt x="613698" y="1346368"/>
                    </a:cubicBezTo>
                    <a:cubicBezTo>
                      <a:pt x="548384" y="1360882"/>
                      <a:pt x="452227" y="1349997"/>
                      <a:pt x="395984" y="1313711"/>
                    </a:cubicBezTo>
                    <a:cubicBezTo>
                      <a:pt x="339741" y="1277425"/>
                      <a:pt x="290755" y="1195782"/>
                      <a:pt x="276241" y="1128654"/>
                    </a:cubicBezTo>
                    <a:cubicBezTo>
                      <a:pt x="261727" y="1061526"/>
                      <a:pt x="287127" y="981697"/>
                      <a:pt x="308898" y="910940"/>
                    </a:cubicBezTo>
                    <a:cubicBezTo>
                      <a:pt x="330669" y="840183"/>
                      <a:pt x="410498" y="774868"/>
                      <a:pt x="406870" y="704111"/>
                    </a:cubicBezTo>
                    <a:cubicBezTo>
                      <a:pt x="403242" y="633354"/>
                      <a:pt x="341556" y="553525"/>
                      <a:pt x="287127" y="486397"/>
                    </a:cubicBezTo>
                    <a:cubicBezTo>
                      <a:pt x="232698" y="419269"/>
                      <a:pt x="127469" y="359397"/>
                      <a:pt x="80298" y="301340"/>
                    </a:cubicBezTo>
                    <a:cubicBezTo>
                      <a:pt x="33126" y="243283"/>
                      <a:pt x="13169" y="183411"/>
                      <a:pt x="4098" y="138054"/>
                    </a:cubicBezTo>
                    <a:cubicBezTo>
                      <a:pt x="-4973" y="92697"/>
                      <a:pt x="470" y="50968"/>
                      <a:pt x="25870" y="29197"/>
                    </a:cubicBezTo>
                    <a:cubicBezTo>
                      <a:pt x="51270" y="7426"/>
                      <a:pt x="102069" y="-10717"/>
                      <a:pt x="156498" y="7426"/>
                    </a:cubicBezTo>
                    <a:cubicBezTo>
                      <a:pt x="210926" y="25569"/>
                      <a:pt x="288941" y="70926"/>
                      <a:pt x="352441" y="138054"/>
                    </a:cubicBezTo>
                    <a:cubicBezTo>
                      <a:pt x="415941" y="205182"/>
                      <a:pt x="501212" y="339440"/>
                      <a:pt x="537498" y="410197"/>
                    </a:cubicBezTo>
                    <a:cubicBezTo>
                      <a:pt x="573784" y="480954"/>
                      <a:pt x="564712" y="504540"/>
                      <a:pt x="570155" y="562597"/>
                    </a:cubicBezTo>
                    <a:cubicBezTo>
                      <a:pt x="575598" y="620654"/>
                      <a:pt x="581041" y="691411"/>
                      <a:pt x="570155" y="758540"/>
                    </a:cubicBezTo>
                    <a:cubicBezTo>
                      <a:pt x="559269" y="825668"/>
                      <a:pt x="512098" y="918197"/>
                      <a:pt x="504841" y="965368"/>
                    </a:cubicBezTo>
                    <a:cubicBezTo>
                      <a:pt x="497584" y="1012539"/>
                      <a:pt x="524798" y="1041568"/>
                      <a:pt x="548384" y="1052454"/>
                    </a:cubicBezTo>
                    <a:close/>
                  </a:path>
                </a:pathLst>
              </a:custGeom>
              <a:solidFill>
                <a:schemeClr val="accent6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 dirty="0">
                  <a:latin typeface="Helvetica" pitchFamily="2" charset="0"/>
                </a:endParaRPr>
              </a:p>
            </p:txBody>
          </p:sp>
          <p:grpSp>
            <p:nvGrpSpPr>
              <p:cNvPr id="187" name="グループ化 186">
                <a:extLst>
                  <a:ext uri="{FF2B5EF4-FFF2-40B4-BE49-F238E27FC236}">
                    <a16:creationId xmlns:a16="http://schemas.microsoft.com/office/drawing/2014/main" id="{A6DEA216-2D5F-5612-F865-D872DC505528}"/>
                  </a:ext>
                </a:extLst>
              </p:cNvPr>
              <p:cNvGrpSpPr/>
              <p:nvPr/>
            </p:nvGrpSpPr>
            <p:grpSpPr>
              <a:xfrm rot="221016">
                <a:off x="4017723" y="1245123"/>
                <a:ext cx="499429" cy="992071"/>
                <a:chOff x="2548152" y="853236"/>
                <a:chExt cx="499429" cy="992071"/>
              </a:xfrm>
            </p:grpSpPr>
            <p:grpSp>
              <p:nvGrpSpPr>
                <p:cNvPr id="241" name="グループ化 240">
                  <a:extLst>
                    <a:ext uri="{FF2B5EF4-FFF2-40B4-BE49-F238E27FC236}">
                      <a16:creationId xmlns:a16="http://schemas.microsoft.com/office/drawing/2014/main" id="{9BF1FD04-A419-F92B-F33E-DEE8D0FD801C}"/>
                    </a:ext>
                  </a:extLst>
                </p:cNvPr>
                <p:cNvGrpSpPr/>
                <p:nvPr/>
              </p:nvGrpSpPr>
              <p:grpSpPr>
                <a:xfrm>
                  <a:off x="2595132" y="853236"/>
                  <a:ext cx="425746" cy="498593"/>
                  <a:chOff x="2595132" y="853236"/>
                  <a:chExt cx="425746" cy="498593"/>
                </a:xfrm>
              </p:grpSpPr>
              <p:grpSp>
                <p:nvGrpSpPr>
                  <p:cNvPr id="265" name="グループ化 264">
                    <a:extLst>
                      <a:ext uri="{FF2B5EF4-FFF2-40B4-BE49-F238E27FC236}">
                        <a16:creationId xmlns:a16="http://schemas.microsoft.com/office/drawing/2014/main" id="{3F9FB319-4ED4-18E8-3F9B-806CE2915B70}"/>
                      </a:ext>
                    </a:extLst>
                  </p:cNvPr>
                  <p:cNvGrpSpPr/>
                  <p:nvPr/>
                </p:nvGrpSpPr>
                <p:grpSpPr>
                  <a:xfrm rot="20918512">
                    <a:off x="2694936" y="853236"/>
                    <a:ext cx="325942" cy="149594"/>
                    <a:chOff x="2338703" y="527862"/>
                    <a:chExt cx="325942" cy="149594"/>
                  </a:xfrm>
                </p:grpSpPr>
                <p:grpSp>
                  <p:nvGrpSpPr>
                    <p:cNvPr id="277" name="グループ化 276">
                      <a:extLst>
                        <a:ext uri="{FF2B5EF4-FFF2-40B4-BE49-F238E27FC236}">
                          <a16:creationId xmlns:a16="http://schemas.microsoft.com/office/drawing/2014/main" id="{11F88290-FD70-D115-869A-2E0491698422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703" y="562564"/>
                      <a:ext cx="214128" cy="114892"/>
                      <a:chOff x="2907756" y="776944"/>
                      <a:chExt cx="199382" cy="108230"/>
                    </a:xfrm>
                  </p:grpSpPr>
                  <p:grpSp>
                    <p:nvGrpSpPr>
                      <p:cNvPr id="281" name="グループ化 280">
                        <a:extLst>
                          <a:ext uri="{FF2B5EF4-FFF2-40B4-BE49-F238E27FC236}">
                            <a16:creationId xmlns:a16="http://schemas.microsoft.com/office/drawing/2014/main" id="{9E059CEA-9DE3-742B-B654-5CECE7582023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85" name="曲線コネクタ 284">
                          <a:extLst>
                            <a:ext uri="{FF2B5EF4-FFF2-40B4-BE49-F238E27FC236}">
                              <a16:creationId xmlns:a16="http://schemas.microsoft.com/office/drawing/2014/main" id="{9749609D-A975-068C-BE66-0F3448DBC53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86" name="曲線コネクタ 285">
                          <a:extLst>
                            <a:ext uri="{FF2B5EF4-FFF2-40B4-BE49-F238E27FC236}">
                              <a16:creationId xmlns:a16="http://schemas.microsoft.com/office/drawing/2014/main" id="{56AC3EE9-E8B0-EDF5-3434-4FC06997A40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82" name="グループ化 281">
                        <a:extLst>
                          <a:ext uri="{FF2B5EF4-FFF2-40B4-BE49-F238E27FC236}">
                            <a16:creationId xmlns:a16="http://schemas.microsoft.com/office/drawing/2014/main" id="{40A7F2C9-61DA-A8D7-E4F8-B78A20EF75E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0023" y="776944"/>
                        <a:ext cx="117115" cy="60447"/>
                        <a:chOff x="3014737" y="791772"/>
                        <a:chExt cx="117115" cy="60447"/>
                      </a:xfrm>
                    </p:grpSpPr>
                    <p:cxnSp>
                      <p:nvCxnSpPr>
                        <p:cNvPr id="283" name="曲線コネクタ 282">
                          <a:extLst>
                            <a:ext uri="{FF2B5EF4-FFF2-40B4-BE49-F238E27FC236}">
                              <a16:creationId xmlns:a16="http://schemas.microsoft.com/office/drawing/2014/main" id="{38D5C308-5C20-6F52-ABB7-119AFCFE308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84" name="曲線コネクタ 283">
                          <a:extLst>
                            <a:ext uri="{FF2B5EF4-FFF2-40B4-BE49-F238E27FC236}">
                              <a16:creationId xmlns:a16="http://schemas.microsoft.com/office/drawing/2014/main" id="{5B550815-4AAE-26BF-707E-6510DDC5F15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4737" y="791772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78" name="グループ化 277">
                      <a:extLst>
                        <a:ext uri="{FF2B5EF4-FFF2-40B4-BE49-F238E27FC236}">
                          <a16:creationId xmlns:a16="http://schemas.microsoft.com/office/drawing/2014/main" id="{2A08F314-75A0-D401-9865-5BFA41690403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79" name="曲線コネクタ 278">
                        <a:extLst>
                          <a:ext uri="{FF2B5EF4-FFF2-40B4-BE49-F238E27FC236}">
                            <a16:creationId xmlns:a16="http://schemas.microsoft.com/office/drawing/2014/main" id="{4A9302D1-51E1-836C-0F35-B3BCA6FA8B6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0" name="曲線コネクタ 279">
                        <a:extLst>
                          <a:ext uri="{FF2B5EF4-FFF2-40B4-BE49-F238E27FC236}">
                            <a16:creationId xmlns:a16="http://schemas.microsoft.com/office/drawing/2014/main" id="{BD58D46D-8BF0-6206-AE67-BF53DEE08B1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66" name="グループ化 265">
                    <a:extLst>
                      <a:ext uri="{FF2B5EF4-FFF2-40B4-BE49-F238E27FC236}">
                        <a16:creationId xmlns:a16="http://schemas.microsoft.com/office/drawing/2014/main" id="{82ECAB1F-F18A-143A-8B95-E497E844E5E6}"/>
                      </a:ext>
                    </a:extLst>
                  </p:cNvPr>
                  <p:cNvGrpSpPr/>
                  <p:nvPr/>
                </p:nvGrpSpPr>
                <p:grpSpPr>
                  <a:xfrm rot="15812476" flipH="1">
                    <a:off x="2506959" y="1114056"/>
                    <a:ext cx="325946" cy="149599"/>
                    <a:chOff x="2338699" y="527862"/>
                    <a:chExt cx="325946" cy="149599"/>
                  </a:xfrm>
                </p:grpSpPr>
                <p:grpSp>
                  <p:nvGrpSpPr>
                    <p:cNvPr id="267" name="グループ化 266">
                      <a:extLst>
                        <a:ext uri="{FF2B5EF4-FFF2-40B4-BE49-F238E27FC236}">
                          <a16:creationId xmlns:a16="http://schemas.microsoft.com/office/drawing/2014/main" id="{962EEBA3-6F74-E1EA-75CD-17E198946CCC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699" y="562852"/>
                      <a:ext cx="214216" cy="114609"/>
                      <a:chOff x="2907756" y="777212"/>
                      <a:chExt cx="199464" cy="107963"/>
                    </a:xfrm>
                  </p:grpSpPr>
                  <p:grpSp>
                    <p:nvGrpSpPr>
                      <p:cNvPr id="271" name="グループ化 270">
                        <a:extLst>
                          <a:ext uri="{FF2B5EF4-FFF2-40B4-BE49-F238E27FC236}">
                            <a16:creationId xmlns:a16="http://schemas.microsoft.com/office/drawing/2014/main" id="{435E4485-B72B-79F6-916A-AFC97E447049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2" cy="60116"/>
                        <a:chOff x="2907756" y="825059"/>
                        <a:chExt cx="115852" cy="60116"/>
                      </a:xfrm>
                    </p:grpSpPr>
                    <p:cxnSp>
                      <p:nvCxnSpPr>
                        <p:cNvPr id="275" name="曲線コネクタ 274">
                          <a:extLst>
                            <a:ext uri="{FF2B5EF4-FFF2-40B4-BE49-F238E27FC236}">
                              <a16:creationId xmlns:a16="http://schemas.microsoft.com/office/drawing/2014/main" id="{AE14183B-F64F-E033-48F6-FB3B8D3FDE4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76" name="曲線コネクタ 275">
                          <a:extLst>
                            <a:ext uri="{FF2B5EF4-FFF2-40B4-BE49-F238E27FC236}">
                              <a16:creationId xmlns:a16="http://schemas.microsoft.com/office/drawing/2014/main" id="{BDD84182-15D6-F0B6-C6B0-A030340500D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0" y="825446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72" name="グループ化 271">
                        <a:extLst>
                          <a:ext uri="{FF2B5EF4-FFF2-40B4-BE49-F238E27FC236}">
                            <a16:creationId xmlns:a16="http://schemas.microsoft.com/office/drawing/2014/main" id="{CE5F8ED9-E315-ECE7-33E1-3CCF22347C4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7212"/>
                        <a:ext cx="114340" cy="60179"/>
                        <a:chOff x="3017594" y="792040"/>
                        <a:chExt cx="114340" cy="60179"/>
                      </a:xfrm>
                    </p:grpSpPr>
                    <p:cxnSp>
                      <p:nvCxnSpPr>
                        <p:cNvPr id="273" name="曲線コネクタ 272">
                          <a:extLst>
                            <a:ext uri="{FF2B5EF4-FFF2-40B4-BE49-F238E27FC236}">
                              <a16:creationId xmlns:a16="http://schemas.microsoft.com/office/drawing/2014/main" id="{D1AF33EA-562C-8BF2-F2B0-D38D47FCF7D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7676" y="79204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74" name="曲線コネクタ 273">
                          <a:extLst>
                            <a:ext uri="{FF2B5EF4-FFF2-40B4-BE49-F238E27FC236}">
                              <a16:creationId xmlns:a16="http://schemas.microsoft.com/office/drawing/2014/main" id="{83D1294E-3447-E1BA-5285-60CE307438C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68" name="グループ化 267">
                      <a:extLst>
                        <a:ext uri="{FF2B5EF4-FFF2-40B4-BE49-F238E27FC236}">
                          <a16:creationId xmlns:a16="http://schemas.microsoft.com/office/drawing/2014/main" id="{CCD43393-B635-21C4-ADD0-357ABDF2289E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69" name="曲線コネクタ 268">
                        <a:extLst>
                          <a:ext uri="{FF2B5EF4-FFF2-40B4-BE49-F238E27FC236}">
                            <a16:creationId xmlns:a16="http://schemas.microsoft.com/office/drawing/2014/main" id="{C915A4C0-8C61-56B9-D0D4-A01232213FA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0" name="曲線コネクタ 269">
                        <a:extLst>
                          <a:ext uri="{FF2B5EF4-FFF2-40B4-BE49-F238E27FC236}">
                            <a16:creationId xmlns:a16="http://schemas.microsoft.com/office/drawing/2014/main" id="{DB3F01E3-36ED-6970-E9F3-1975834828D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242" name="グループ化 241">
                  <a:extLst>
                    <a:ext uri="{FF2B5EF4-FFF2-40B4-BE49-F238E27FC236}">
                      <a16:creationId xmlns:a16="http://schemas.microsoft.com/office/drawing/2014/main" id="{37EB88EC-53B0-D2A4-B514-822AE04DF537}"/>
                    </a:ext>
                  </a:extLst>
                </p:cNvPr>
                <p:cNvGrpSpPr/>
                <p:nvPr/>
              </p:nvGrpSpPr>
              <p:grpSpPr>
                <a:xfrm rot="17579374">
                  <a:off x="2583369" y="1381095"/>
                  <a:ext cx="428995" cy="499429"/>
                  <a:chOff x="2595132" y="852400"/>
                  <a:chExt cx="428995" cy="499429"/>
                </a:xfrm>
              </p:grpSpPr>
              <p:grpSp>
                <p:nvGrpSpPr>
                  <p:cNvPr id="243" name="グループ化 242">
                    <a:extLst>
                      <a:ext uri="{FF2B5EF4-FFF2-40B4-BE49-F238E27FC236}">
                        <a16:creationId xmlns:a16="http://schemas.microsoft.com/office/drawing/2014/main" id="{1182C05E-7471-F040-E0D5-032A8C78B5B6}"/>
                      </a:ext>
                    </a:extLst>
                  </p:cNvPr>
                  <p:cNvGrpSpPr/>
                  <p:nvPr/>
                </p:nvGrpSpPr>
                <p:grpSpPr>
                  <a:xfrm rot="20918512">
                    <a:off x="2694883" y="852400"/>
                    <a:ext cx="329244" cy="150117"/>
                    <a:chOff x="2338732" y="527352"/>
                    <a:chExt cx="329244" cy="150117"/>
                  </a:xfrm>
                </p:grpSpPr>
                <p:grpSp>
                  <p:nvGrpSpPr>
                    <p:cNvPr id="255" name="グループ化 254">
                      <a:extLst>
                        <a:ext uri="{FF2B5EF4-FFF2-40B4-BE49-F238E27FC236}">
                          <a16:creationId xmlns:a16="http://schemas.microsoft.com/office/drawing/2014/main" id="{15514FE2-BCB4-4B34-9B29-2762B18DDA3E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732" y="559770"/>
                      <a:ext cx="215075" cy="117699"/>
                      <a:chOff x="2907756" y="774300"/>
                      <a:chExt cx="200264" cy="110874"/>
                    </a:xfrm>
                  </p:grpSpPr>
                  <p:grpSp>
                    <p:nvGrpSpPr>
                      <p:cNvPr id="259" name="グループ化 258">
                        <a:extLst>
                          <a:ext uri="{FF2B5EF4-FFF2-40B4-BE49-F238E27FC236}">
                            <a16:creationId xmlns:a16="http://schemas.microsoft.com/office/drawing/2014/main" id="{2236B20A-89D2-58EB-7EF0-5F3A414BAE14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63" name="曲線コネクタ 262">
                          <a:extLst>
                            <a:ext uri="{FF2B5EF4-FFF2-40B4-BE49-F238E27FC236}">
                              <a16:creationId xmlns:a16="http://schemas.microsoft.com/office/drawing/2014/main" id="{A5C7D2B5-B7E7-51D7-57F8-0EF5201DF28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64" name="曲線コネクタ 263">
                          <a:extLst>
                            <a:ext uri="{FF2B5EF4-FFF2-40B4-BE49-F238E27FC236}">
                              <a16:creationId xmlns:a16="http://schemas.microsoft.com/office/drawing/2014/main" id="{48D6A3A5-53B7-A633-42F3-5BB07E3DA4C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60" name="グループ化 259">
                        <a:extLst>
                          <a:ext uri="{FF2B5EF4-FFF2-40B4-BE49-F238E27FC236}">
                            <a16:creationId xmlns:a16="http://schemas.microsoft.com/office/drawing/2014/main" id="{FBCF4A01-C82A-F1F9-9405-38129F2E0CA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4300"/>
                        <a:ext cx="115140" cy="63091"/>
                        <a:chOff x="3017594" y="789128"/>
                        <a:chExt cx="115140" cy="63091"/>
                      </a:xfrm>
                    </p:grpSpPr>
                    <p:cxnSp>
                      <p:nvCxnSpPr>
                        <p:cNvPr id="261" name="曲線コネクタ 260">
                          <a:extLst>
                            <a:ext uri="{FF2B5EF4-FFF2-40B4-BE49-F238E27FC236}">
                              <a16:creationId xmlns:a16="http://schemas.microsoft.com/office/drawing/2014/main" id="{81F93E51-6CBA-504B-2EE9-7A14BE91D77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62" name="曲線コネクタ 261">
                          <a:extLst>
                            <a:ext uri="{FF2B5EF4-FFF2-40B4-BE49-F238E27FC236}">
                              <a16:creationId xmlns:a16="http://schemas.microsoft.com/office/drawing/2014/main" id="{B20A15D2-BF25-0A30-CCD6-BC6356C4F65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8476" y="789128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56" name="グループ化 255">
                      <a:extLst>
                        <a:ext uri="{FF2B5EF4-FFF2-40B4-BE49-F238E27FC236}">
                          <a16:creationId xmlns:a16="http://schemas.microsoft.com/office/drawing/2014/main" id="{483A4E4B-B04D-037A-7B08-A9F2870C2E30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89" y="527352"/>
                      <a:ext cx="127687" cy="64152"/>
                      <a:chOff x="2907756" y="824356"/>
                      <a:chExt cx="118893" cy="60432"/>
                    </a:xfrm>
                  </p:grpSpPr>
                  <p:cxnSp>
                    <p:nvCxnSpPr>
                      <p:cNvPr id="257" name="曲線コネクタ 256">
                        <a:extLst>
                          <a:ext uri="{FF2B5EF4-FFF2-40B4-BE49-F238E27FC236}">
                            <a16:creationId xmlns:a16="http://schemas.microsoft.com/office/drawing/2014/main" id="{8F255F1B-D2FA-47DE-13DA-E55D5A22AF3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12391" y="824356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58" name="曲線コネクタ 257">
                        <a:extLst>
                          <a:ext uri="{FF2B5EF4-FFF2-40B4-BE49-F238E27FC236}">
                            <a16:creationId xmlns:a16="http://schemas.microsoft.com/office/drawing/2014/main" id="{C2E47559-0E35-F65E-DC5E-70A1A896D8A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44" name="グループ化 243">
                    <a:extLst>
                      <a:ext uri="{FF2B5EF4-FFF2-40B4-BE49-F238E27FC236}">
                        <a16:creationId xmlns:a16="http://schemas.microsoft.com/office/drawing/2014/main" id="{2B2AFE08-933C-850C-5CD6-887D30017BC8}"/>
                      </a:ext>
                    </a:extLst>
                  </p:cNvPr>
                  <p:cNvGrpSpPr/>
                  <p:nvPr/>
                </p:nvGrpSpPr>
                <p:grpSpPr>
                  <a:xfrm rot="15812476" flipH="1">
                    <a:off x="2506959" y="1114056"/>
                    <a:ext cx="325946" cy="149599"/>
                    <a:chOff x="2338699" y="527862"/>
                    <a:chExt cx="325946" cy="149599"/>
                  </a:xfrm>
                </p:grpSpPr>
                <p:grpSp>
                  <p:nvGrpSpPr>
                    <p:cNvPr id="245" name="グループ化 244">
                      <a:extLst>
                        <a:ext uri="{FF2B5EF4-FFF2-40B4-BE49-F238E27FC236}">
                          <a16:creationId xmlns:a16="http://schemas.microsoft.com/office/drawing/2014/main" id="{13C36FBE-923B-15AF-6D11-06A7DFCFBF60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699" y="562853"/>
                      <a:ext cx="214216" cy="114608"/>
                      <a:chOff x="2907756" y="777212"/>
                      <a:chExt cx="199464" cy="107962"/>
                    </a:xfrm>
                  </p:grpSpPr>
                  <p:grpSp>
                    <p:nvGrpSpPr>
                      <p:cNvPr id="249" name="グループ化 248">
                        <a:extLst>
                          <a:ext uri="{FF2B5EF4-FFF2-40B4-BE49-F238E27FC236}">
                            <a16:creationId xmlns:a16="http://schemas.microsoft.com/office/drawing/2014/main" id="{5E5ED330-6767-25EE-B3AC-62298121A240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53" name="曲線コネクタ 252">
                          <a:extLst>
                            <a:ext uri="{FF2B5EF4-FFF2-40B4-BE49-F238E27FC236}">
                              <a16:creationId xmlns:a16="http://schemas.microsoft.com/office/drawing/2014/main" id="{72024F1A-C83F-A7B3-9456-882FAACF5B7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54" name="曲線コネクタ 253">
                          <a:extLst>
                            <a:ext uri="{FF2B5EF4-FFF2-40B4-BE49-F238E27FC236}">
                              <a16:creationId xmlns:a16="http://schemas.microsoft.com/office/drawing/2014/main" id="{8C6FA02E-C1D9-EC2F-2E76-846D7D31555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50" name="グループ化 249">
                        <a:extLst>
                          <a:ext uri="{FF2B5EF4-FFF2-40B4-BE49-F238E27FC236}">
                            <a16:creationId xmlns:a16="http://schemas.microsoft.com/office/drawing/2014/main" id="{DDB4E121-CEC9-BA35-6D24-302A9555403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7212"/>
                        <a:ext cx="114340" cy="60179"/>
                        <a:chOff x="3017594" y="792040"/>
                        <a:chExt cx="114340" cy="60179"/>
                      </a:xfrm>
                    </p:grpSpPr>
                    <p:cxnSp>
                      <p:nvCxnSpPr>
                        <p:cNvPr id="251" name="曲線コネクタ 250">
                          <a:extLst>
                            <a:ext uri="{FF2B5EF4-FFF2-40B4-BE49-F238E27FC236}">
                              <a16:creationId xmlns:a16="http://schemas.microsoft.com/office/drawing/2014/main" id="{3379B4C2-E13A-DD04-8023-C3A75C8DD11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7676" y="79204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52" name="曲線コネクタ 251">
                          <a:extLst>
                            <a:ext uri="{FF2B5EF4-FFF2-40B4-BE49-F238E27FC236}">
                              <a16:creationId xmlns:a16="http://schemas.microsoft.com/office/drawing/2014/main" id="{3C93209B-C2E3-4478-53B7-81078162FFE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46" name="グループ化 245">
                      <a:extLst>
                        <a:ext uri="{FF2B5EF4-FFF2-40B4-BE49-F238E27FC236}">
                          <a16:creationId xmlns:a16="http://schemas.microsoft.com/office/drawing/2014/main" id="{FC2F2BDD-33EC-6AE4-C305-CB607BC0D18D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47" name="曲線コネクタ 246">
                        <a:extLst>
                          <a:ext uri="{FF2B5EF4-FFF2-40B4-BE49-F238E27FC236}">
                            <a16:creationId xmlns:a16="http://schemas.microsoft.com/office/drawing/2014/main" id="{90FC5561-6F5E-37DD-4E56-0B62D92FB9C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>
                            <a:lumMod val="40000"/>
                            <a:lumOff val="6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48" name="曲線コネクタ 247">
                        <a:extLst>
                          <a:ext uri="{FF2B5EF4-FFF2-40B4-BE49-F238E27FC236}">
                            <a16:creationId xmlns:a16="http://schemas.microsoft.com/office/drawing/2014/main" id="{AC4E2AFD-BC42-FE5A-38A5-8F2DD538D7D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4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  <p:grpSp>
            <p:nvGrpSpPr>
              <p:cNvPr id="188" name="グループ化 187">
                <a:extLst>
                  <a:ext uri="{FF2B5EF4-FFF2-40B4-BE49-F238E27FC236}">
                    <a16:creationId xmlns:a16="http://schemas.microsoft.com/office/drawing/2014/main" id="{E7F2EC85-7B65-1FA6-358A-6F233F6A665D}"/>
                  </a:ext>
                </a:extLst>
              </p:cNvPr>
              <p:cNvGrpSpPr/>
              <p:nvPr/>
            </p:nvGrpSpPr>
            <p:grpSpPr>
              <a:xfrm flipH="1">
                <a:off x="4656208" y="1281244"/>
                <a:ext cx="499429" cy="992071"/>
                <a:chOff x="2548152" y="853236"/>
                <a:chExt cx="499429" cy="992071"/>
              </a:xfrm>
            </p:grpSpPr>
            <p:grpSp>
              <p:nvGrpSpPr>
                <p:cNvPr id="195" name="グループ化 194">
                  <a:extLst>
                    <a:ext uri="{FF2B5EF4-FFF2-40B4-BE49-F238E27FC236}">
                      <a16:creationId xmlns:a16="http://schemas.microsoft.com/office/drawing/2014/main" id="{DCA5DE7A-3CBE-1BB1-DB7E-3E54217FE3E8}"/>
                    </a:ext>
                  </a:extLst>
                </p:cNvPr>
                <p:cNvGrpSpPr/>
                <p:nvPr/>
              </p:nvGrpSpPr>
              <p:grpSpPr>
                <a:xfrm>
                  <a:off x="2595132" y="853236"/>
                  <a:ext cx="425746" cy="498593"/>
                  <a:chOff x="2595132" y="853236"/>
                  <a:chExt cx="425746" cy="498593"/>
                </a:xfrm>
              </p:grpSpPr>
              <p:grpSp>
                <p:nvGrpSpPr>
                  <p:cNvPr id="219" name="グループ化 218">
                    <a:extLst>
                      <a:ext uri="{FF2B5EF4-FFF2-40B4-BE49-F238E27FC236}">
                        <a16:creationId xmlns:a16="http://schemas.microsoft.com/office/drawing/2014/main" id="{EBC6E8CA-9426-E7DD-96AA-F33EFD424B8A}"/>
                      </a:ext>
                    </a:extLst>
                  </p:cNvPr>
                  <p:cNvGrpSpPr/>
                  <p:nvPr/>
                </p:nvGrpSpPr>
                <p:grpSpPr>
                  <a:xfrm rot="20918512">
                    <a:off x="2694936" y="853236"/>
                    <a:ext cx="325942" cy="149594"/>
                    <a:chOff x="2338703" y="527862"/>
                    <a:chExt cx="325942" cy="149594"/>
                  </a:xfrm>
                </p:grpSpPr>
                <p:grpSp>
                  <p:nvGrpSpPr>
                    <p:cNvPr id="231" name="グループ化 230">
                      <a:extLst>
                        <a:ext uri="{FF2B5EF4-FFF2-40B4-BE49-F238E27FC236}">
                          <a16:creationId xmlns:a16="http://schemas.microsoft.com/office/drawing/2014/main" id="{59536E0D-78DA-ADA4-9D8F-8D96C2B78C57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703" y="562564"/>
                      <a:ext cx="214128" cy="114892"/>
                      <a:chOff x="2907756" y="776944"/>
                      <a:chExt cx="199382" cy="108230"/>
                    </a:xfrm>
                  </p:grpSpPr>
                  <p:grpSp>
                    <p:nvGrpSpPr>
                      <p:cNvPr id="235" name="グループ化 234">
                        <a:extLst>
                          <a:ext uri="{FF2B5EF4-FFF2-40B4-BE49-F238E27FC236}">
                            <a16:creationId xmlns:a16="http://schemas.microsoft.com/office/drawing/2014/main" id="{3AC7F358-C7BB-9051-A4FB-205305A24680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39" name="曲線コネクタ 238">
                          <a:extLst>
                            <a:ext uri="{FF2B5EF4-FFF2-40B4-BE49-F238E27FC236}">
                              <a16:creationId xmlns:a16="http://schemas.microsoft.com/office/drawing/2014/main" id="{6AD24221-A128-E72B-3C8E-819C0A5466D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40" name="曲線コネクタ 239">
                          <a:extLst>
                            <a:ext uri="{FF2B5EF4-FFF2-40B4-BE49-F238E27FC236}">
                              <a16:creationId xmlns:a16="http://schemas.microsoft.com/office/drawing/2014/main" id="{6A4C8068-1542-B353-69E3-808358D99D89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36" name="グループ化 235">
                        <a:extLst>
                          <a:ext uri="{FF2B5EF4-FFF2-40B4-BE49-F238E27FC236}">
                            <a16:creationId xmlns:a16="http://schemas.microsoft.com/office/drawing/2014/main" id="{A9684E32-A9A5-7F8E-6464-9A56387F5D1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0023" y="776944"/>
                        <a:ext cx="117115" cy="60447"/>
                        <a:chOff x="3014737" y="791772"/>
                        <a:chExt cx="117115" cy="60447"/>
                      </a:xfrm>
                    </p:grpSpPr>
                    <p:cxnSp>
                      <p:nvCxnSpPr>
                        <p:cNvPr id="237" name="曲線コネクタ 236">
                          <a:extLst>
                            <a:ext uri="{FF2B5EF4-FFF2-40B4-BE49-F238E27FC236}">
                              <a16:creationId xmlns:a16="http://schemas.microsoft.com/office/drawing/2014/main" id="{E1E54082-3933-B97D-BB8B-932AFEA6ED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38" name="曲線コネクタ 237">
                          <a:extLst>
                            <a:ext uri="{FF2B5EF4-FFF2-40B4-BE49-F238E27FC236}">
                              <a16:creationId xmlns:a16="http://schemas.microsoft.com/office/drawing/2014/main" id="{D44A8673-EBE3-CC6B-3936-3E97D05F289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4737" y="791772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32" name="グループ化 231">
                      <a:extLst>
                        <a:ext uri="{FF2B5EF4-FFF2-40B4-BE49-F238E27FC236}">
                          <a16:creationId xmlns:a16="http://schemas.microsoft.com/office/drawing/2014/main" id="{21AD225F-4711-08BF-25A5-071DD7E7AC88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33" name="曲線コネクタ 232">
                        <a:extLst>
                          <a:ext uri="{FF2B5EF4-FFF2-40B4-BE49-F238E27FC236}">
                            <a16:creationId xmlns:a16="http://schemas.microsoft.com/office/drawing/2014/main" id="{BBCD5021-E24A-058E-A307-9D141DE2116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7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4" name="曲線コネクタ 233">
                        <a:extLst>
                          <a:ext uri="{FF2B5EF4-FFF2-40B4-BE49-F238E27FC236}">
                            <a16:creationId xmlns:a16="http://schemas.microsoft.com/office/drawing/2014/main" id="{00D8DE95-5D08-2D86-9A04-AD3E5C0C5FB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20" name="グループ化 219">
                    <a:extLst>
                      <a:ext uri="{FF2B5EF4-FFF2-40B4-BE49-F238E27FC236}">
                        <a16:creationId xmlns:a16="http://schemas.microsoft.com/office/drawing/2014/main" id="{F0F162D6-9F03-BD86-C237-297F3D8B9720}"/>
                      </a:ext>
                    </a:extLst>
                  </p:cNvPr>
                  <p:cNvGrpSpPr/>
                  <p:nvPr/>
                </p:nvGrpSpPr>
                <p:grpSpPr>
                  <a:xfrm rot="15812476" flipH="1">
                    <a:off x="2506959" y="1114056"/>
                    <a:ext cx="325946" cy="149599"/>
                    <a:chOff x="2338699" y="527862"/>
                    <a:chExt cx="325946" cy="149599"/>
                  </a:xfrm>
                </p:grpSpPr>
                <p:grpSp>
                  <p:nvGrpSpPr>
                    <p:cNvPr id="221" name="グループ化 220">
                      <a:extLst>
                        <a:ext uri="{FF2B5EF4-FFF2-40B4-BE49-F238E27FC236}">
                          <a16:creationId xmlns:a16="http://schemas.microsoft.com/office/drawing/2014/main" id="{1C9AE2E2-F744-5081-D2A3-AE5DB2323E3F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699" y="562852"/>
                      <a:ext cx="214216" cy="114609"/>
                      <a:chOff x="2907756" y="777212"/>
                      <a:chExt cx="199464" cy="107963"/>
                    </a:xfrm>
                  </p:grpSpPr>
                  <p:grpSp>
                    <p:nvGrpSpPr>
                      <p:cNvPr id="225" name="グループ化 224">
                        <a:extLst>
                          <a:ext uri="{FF2B5EF4-FFF2-40B4-BE49-F238E27FC236}">
                            <a16:creationId xmlns:a16="http://schemas.microsoft.com/office/drawing/2014/main" id="{072A8F97-5E54-0CFF-4E5E-8284F9E16B70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2" cy="60116"/>
                        <a:chOff x="2907756" y="825059"/>
                        <a:chExt cx="115852" cy="60116"/>
                      </a:xfrm>
                    </p:grpSpPr>
                    <p:cxnSp>
                      <p:nvCxnSpPr>
                        <p:cNvPr id="229" name="曲線コネクタ 228">
                          <a:extLst>
                            <a:ext uri="{FF2B5EF4-FFF2-40B4-BE49-F238E27FC236}">
                              <a16:creationId xmlns:a16="http://schemas.microsoft.com/office/drawing/2014/main" id="{1616C188-C7F2-8D95-2FB4-4EC08C808B7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30" name="曲線コネクタ 229">
                          <a:extLst>
                            <a:ext uri="{FF2B5EF4-FFF2-40B4-BE49-F238E27FC236}">
                              <a16:creationId xmlns:a16="http://schemas.microsoft.com/office/drawing/2014/main" id="{B9B3862B-D4BF-B6BD-3A08-4BE69C48164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0" y="825446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26" name="グループ化 225">
                        <a:extLst>
                          <a:ext uri="{FF2B5EF4-FFF2-40B4-BE49-F238E27FC236}">
                            <a16:creationId xmlns:a16="http://schemas.microsoft.com/office/drawing/2014/main" id="{7E9AFC2C-7A86-48E7-A1FB-5334E6DACCF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7212"/>
                        <a:ext cx="114340" cy="60179"/>
                        <a:chOff x="3017594" y="792040"/>
                        <a:chExt cx="114340" cy="60179"/>
                      </a:xfrm>
                    </p:grpSpPr>
                    <p:cxnSp>
                      <p:nvCxnSpPr>
                        <p:cNvPr id="227" name="曲線コネクタ 226">
                          <a:extLst>
                            <a:ext uri="{FF2B5EF4-FFF2-40B4-BE49-F238E27FC236}">
                              <a16:creationId xmlns:a16="http://schemas.microsoft.com/office/drawing/2014/main" id="{E77493BB-160B-4EF9-A938-7FD289BAF1F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7676" y="79204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28" name="曲線コネクタ 227">
                          <a:extLst>
                            <a:ext uri="{FF2B5EF4-FFF2-40B4-BE49-F238E27FC236}">
                              <a16:creationId xmlns:a16="http://schemas.microsoft.com/office/drawing/2014/main" id="{26322213-F36E-A269-0EA4-7D88FFDBFC8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22" name="グループ化 221">
                      <a:extLst>
                        <a:ext uri="{FF2B5EF4-FFF2-40B4-BE49-F238E27FC236}">
                          <a16:creationId xmlns:a16="http://schemas.microsoft.com/office/drawing/2014/main" id="{7A428B05-B829-F367-D789-3AF373FF105D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23" name="曲線コネクタ 222">
                        <a:extLst>
                          <a:ext uri="{FF2B5EF4-FFF2-40B4-BE49-F238E27FC236}">
                            <a16:creationId xmlns:a16="http://schemas.microsoft.com/office/drawing/2014/main" id="{B036124F-1EC6-2873-5B6A-47ED25123A5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4" name="曲線コネクタ 223">
                        <a:extLst>
                          <a:ext uri="{FF2B5EF4-FFF2-40B4-BE49-F238E27FC236}">
                            <a16:creationId xmlns:a16="http://schemas.microsoft.com/office/drawing/2014/main" id="{AFA431B3-6A25-166B-AA61-0156FEB9FB7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7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196" name="グループ化 195">
                  <a:extLst>
                    <a:ext uri="{FF2B5EF4-FFF2-40B4-BE49-F238E27FC236}">
                      <a16:creationId xmlns:a16="http://schemas.microsoft.com/office/drawing/2014/main" id="{8BD70268-C218-9B13-CBA1-D112812CE69C}"/>
                    </a:ext>
                  </a:extLst>
                </p:cNvPr>
                <p:cNvGrpSpPr/>
                <p:nvPr/>
              </p:nvGrpSpPr>
              <p:grpSpPr>
                <a:xfrm rot="17579374">
                  <a:off x="2583369" y="1381095"/>
                  <a:ext cx="428995" cy="499429"/>
                  <a:chOff x="2595132" y="852400"/>
                  <a:chExt cx="428995" cy="499429"/>
                </a:xfrm>
              </p:grpSpPr>
              <p:grpSp>
                <p:nvGrpSpPr>
                  <p:cNvPr id="197" name="グループ化 196">
                    <a:extLst>
                      <a:ext uri="{FF2B5EF4-FFF2-40B4-BE49-F238E27FC236}">
                        <a16:creationId xmlns:a16="http://schemas.microsoft.com/office/drawing/2014/main" id="{F92B3290-6DAA-50EA-7D22-EF027167C79F}"/>
                      </a:ext>
                    </a:extLst>
                  </p:cNvPr>
                  <p:cNvGrpSpPr/>
                  <p:nvPr/>
                </p:nvGrpSpPr>
                <p:grpSpPr>
                  <a:xfrm rot="20918512">
                    <a:off x="2694883" y="852400"/>
                    <a:ext cx="329244" cy="150117"/>
                    <a:chOff x="2338732" y="527352"/>
                    <a:chExt cx="329244" cy="150117"/>
                  </a:xfrm>
                </p:grpSpPr>
                <p:grpSp>
                  <p:nvGrpSpPr>
                    <p:cNvPr id="209" name="グループ化 208">
                      <a:extLst>
                        <a:ext uri="{FF2B5EF4-FFF2-40B4-BE49-F238E27FC236}">
                          <a16:creationId xmlns:a16="http://schemas.microsoft.com/office/drawing/2014/main" id="{446C34AE-076D-C69A-BD7B-23F7B6530FD3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732" y="559770"/>
                      <a:ext cx="215075" cy="117699"/>
                      <a:chOff x="2907756" y="774300"/>
                      <a:chExt cx="200264" cy="110874"/>
                    </a:xfrm>
                  </p:grpSpPr>
                  <p:grpSp>
                    <p:nvGrpSpPr>
                      <p:cNvPr id="213" name="グループ化 212">
                        <a:extLst>
                          <a:ext uri="{FF2B5EF4-FFF2-40B4-BE49-F238E27FC236}">
                            <a16:creationId xmlns:a16="http://schemas.microsoft.com/office/drawing/2014/main" id="{42C9F501-9092-9DCF-5062-DB596EF42207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17" name="曲線コネクタ 216">
                          <a:extLst>
                            <a:ext uri="{FF2B5EF4-FFF2-40B4-BE49-F238E27FC236}">
                              <a16:creationId xmlns:a16="http://schemas.microsoft.com/office/drawing/2014/main" id="{1CC4511C-FF46-1605-84ED-537EFE06191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18" name="曲線コネクタ 217">
                          <a:extLst>
                            <a:ext uri="{FF2B5EF4-FFF2-40B4-BE49-F238E27FC236}">
                              <a16:creationId xmlns:a16="http://schemas.microsoft.com/office/drawing/2014/main" id="{EE80C90F-B46F-1215-FB91-3DAE901CF6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14" name="グループ化 213">
                        <a:extLst>
                          <a:ext uri="{FF2B5EF4-FFF2-40B4-BE49-F238E27FC236}">
                            <a16:creationId xmlns:a16="http://schemas.microsoft.com/office/drawing/2014/main" id="{D0FB6C73-E5DA-4C3F-1C4C-75DAB7BC7D7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4300"/>
                        <a:ext cx="115140" cy="63091"/>
                        <a:chOff x="3017594" y="789128"/>
                        <a:chExt cx="115140" cy="63091"/>
                      </a:xfrm>
                    </p:grpSpPr>
                    <p:cxnSp>
                      <p:nvCxnSpPr>
                        <p:cNvPr id="215" name="曲線コネクタ 214">
                          <a:extLst>
                            <a:ext uri="{FF2B5EF4-FFF2-40B4-BE49-F238E27FC236}">
                              <a16:creationId xmlns:a16="http://schemas.microsoft.com/office/drawing/2014/main" id="{662B95A9-3DE3-F5A4-4ED9-A80E3B22440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16" name="曲線コネクタ 215">
                          <a:extLst>
                            <a:ext uri="{FF2B5EF4-FFF2-40B4-BE49-F238E27FC236}">
                              <a16:creationId xmlns:a16="http://schemas.microsoft.com/office/drawing/2014/main" id="{F0200746-588D-2111-6AD6-659B8040DFB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8476" y="789128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10" name="グループ化 209">
                      <a:extLst>
                        <a:ext uri="{FF2B5EF4-FFF2-40B4-BE49-F238E27FC236}">
                          <a16:creationId xmlns:a16="http://schemas.microsoft.com/office/drawing/2014/main" id="{A4D4F459-1B7A-2A9A-05B3-2FC290EC5AA7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89" y="527352"/>
                      <a:ext cx="127687" cy="64152"/>
                      <a:chOff x="2907756" y="824356"/>
                      <a:chExt cx="118893" cy="60432"/>
                    </a:xfrm>
                  </p:grpSpPr>
                  <p:cxnSp>
                    <p:nvCxnSpPr>
                      <p:cNvPr id="211" name="曲線コネクタ 210">
                        <a:extLst>
                          <a:ext uri="{FF2B5EF4-FFF2-40B4-BE49-F238E27FC236}">
                            <a16:creationId xmlns:a16="http://schemas.microsoft.com/office/drawing/2014/main" id="{5D4544CC-B8F3-AE68-94F6-BD21C22C336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12391" y="824356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7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2" name="曲線コネクタ 211">
                        <a:extLst>
                          <a:ext uri="{FF2B5EF4-FFF2-40B4-BE49-F238E27FC236}">
                            <a16:creationId xmlns:a16="http://schemas.microsoft.com/office/drawing/2014/main" id="{08D02BE5-847C-40C1-ACC4-52D94866A42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98" name="グループ化 197">
                    <a:extLst>
                      <a:ext uri="{FF2B5EF4-FFF2-40B4-BE49-F238E27FC236}">
                        <a16:creationId xmlns:a16="http://schemas.microsoft.com/office/drawing/2014/main" id="{32CB96B4-71A2-96B5-44DC-F0F3EFD91C09}"/>
                      </a:ext>
                    </a:extLst>
                  </p:cNvPr>
                  <p:cNvGrpSpPr/>
                  <p:nvPr/>
                </p:nvGrpSpPr>
                <p:grpSpPr>
                  <a:xfrm rot="15812476" flipH="1">
                    <a:off x="2506959" y="1114056"/>
                    <a:ext cx="325946" cy="149599"/>
                    <a:chOff x="2338699" y="527862"/>
                    <a:chExt cx="325946" cy="149599"/>
                  </a:xfrm>
                </p:grpSpPr>
                <p:grpSp>
                  <p:nvGrpSpPr>
                    <p:cNvPr id="199" name="グループ化 198">
                      <a:extLst>
                        <a:ext uri="{FF2B5EF4-FFF2-40B4-BE49-F238E27FC236}">
                          <a16:creationId xmlns:a16="http://schemas.microsoft.com/office/drawing/2014/main" id="{FB93BFF2-66F0-1071-30C1-D92886F73C20}"/>
                        </a:ext>
                      </a:extLst>
                    </p:cNvPr>
                    <p:cNvGrpSpPr/>
                    <p:nvPr/>
                  </p:nvGrpSpPr>
                  <p:grpSpPr>
                    <a:xfrm rot="78353">
                      <a:off x="2338699" y="562853"/>
                      <a:ext cx="214216" cy="114608"/>
                      <a:chOff x="2907756" y="777212"/>
                      <a:chExt cx="199464" cy="107962"/>
                    </a:xfrm>
                  </p:grpSpPr>
                  <p:grpSp>
                    <p:nvGrpSpPr>
                      <p:cNvPr id="203" name="グループ化 202">
                        <a:extLst>
                          <a:ext uri="{FF2B5EF4-FFF2-40B4-BE49-F238E27FC236}">
                            <a16:creationId xmlns:a16="http://schemas.microsoft.com/office/drawing/2014/main" id="{9DE09869-549C-D2C6-C34A-4FEC88A7516B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493866">
                        <a:off x="2907756" y="825059"/>
                        <a:ext cx="115853" cy="601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207" name="曲線コネクタ 206">
                          <a:extLst>
                            <a:ext uri="{FF2B5EF4-FFF2-40B4-BE49-F238E27FC236}">
                              <a16:creationId xmlns:a16="http://schemas.microsoft.com/office/drawing/2014/main" id="{F1C65011-4DDD-F8D8-D702-2CF3DD74393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08" name="曲線コネクタ 207">
                          <a:extLst>
                            <a:ext uri="{FF2B5EF4-FFF2-40B4-BE49-F238E27FC236}">
                              <a16:creationId xmlns:a16="http://schemas.microsoft.com/office/drawing/2014/main" id="{6F04789C-B89B-A7B9-1842-7829D15CE52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04" name="グループ化 203">
                        <a:extLst>
                          <a:ext uri="{FF2B5EF4-FFF2-40B4-BE49-F238E27FC236}">
                            <a16:creationId xmlns:a16="http://schemas.microsoft.com/office/drawing/2014/main" id="{DF37CD27-69EA-76E4-874E-2B197D57075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992880" y="777212"/>
                        <a:ext cx="114340" cy="60179"/>
                        <a:chOff x="3017594" y="792040"/>
                        <a:chExt cx="114340" cy="60179"/>
                      </a:xfrm>
                    </p:grpSpPr>
                    <p:cxnSp>
                      <p:nvCxnSpPr>
                        <p:cNvPr id="205" name="曲線コネクタ 204">
                          <a:extLst>
                            <a:ext uri="{FF2B5EF4-FFF2-40B4-BE49-F238E27FC236}">
                              <a16:creationId xmlns:a16="http://schemas.microsoft.com/office/drawing/2014/main" id="{9256907B-36E8-2999-F1CC-3D1C015A41A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3017676" y="79204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06" name="曲線コネクタ 205">
                          <a:extLst>
                            <a:ext uri="{FF2B5EF4-FFF2-40B4-BE49-F238E27FC236}">
                              <a16:creationId xmlns:a16="http://schemas.microsoft.com/office/drawing/2014/main" id="{3797E09C-6FEC-D7E3-55C7-AA7B75595C9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3017594" y="792490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200" name="グループ化 199">
                      <a:extLst>
                        <a:ext uri="{FF2B5EF4-FFF2-40B4-BE49-F238E27FC236}">
                          <a16:creationId xmlns:a16="http://schemas.microsoft.com/office/drawing/2014/main" id="{D3B44443-C1DB-AD21-C9DF-A9602971FB76}"/>
                        </a:ext>
                      </a:extLst>
                    </p:cNvPr>
                    <p:cNvGrpSpPr/>
                    <p:nvPr/>
                  </p:nvGrpSpPr>
                  <p:grpSpPr>
                    <a:xfrm rot="472691">
                      <a:off x="2540223" y="527862"/>
                      <a:ext cx="124422" cy="63815"/>
                      <a:chOff x="2907756" y="825059"/>
                      <a:chExt cx="115853" cy="60115"/>
                    </a:xfrm>
                  </p:grpSpPr>
                  <p:cxnSp>
                    <p:nvCxnSpPr>
                      <p:cNvPr id="201" name="曲線コネクタ 200">
                        <a:extLst>
                          <a:ext uri="{FF2B5EF4-FFF2-40B4-BE49-F238E27FC236}">
                            <a16:creationId xmlns:a16="http://schemas.microsoft.com/office/drawing/2014/main" id="{9DD45A7A-34E3-CFDD-F247-8BEBF74E4FF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299487">
                        <a:off x="2907756" y="825059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60000"/>
                            <a:lumOff val="40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2" name="曲線コネクタ 201">
                        <a:extLst>
                          <a:ext uri="{FF2B5EF4-FFF2-40B4-BE49-F238E27FC236}">
                            <a16:creationId xmlns:a16="http://schemas.microsoft.com/office/drawing/2014/main" id="{800B9D0C-2CA6-46F7-B5BA-121BA8657DB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20313694" flipV="1">
                        <a:off x="2909351" y="825445"/>
                        <a:ext cx="114258" cy="59729"/>
                      </a:xfrm>
                      <a:prstGeom prst="curvedConnector3">
                        <a:avLst/>
                      </a:prstGeom>
                      <a:ln w="57150">
                        <a:solidFill>
                          <a:schemeClr val="accent5">
                            <a:lumMod val="7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  <p:sp>
            <p:nvSpPr>
              <p:cNvPr id="189" name="フリーフォーム 188">
                <a:extLst>
                  <a:ext uri="{FF2B5EF4-FFF2-40B4-BE49-F238E27FC236}">
                    <a16:creationId xmlns:a16="http://schemas.microsoft.com/office/drawing/2014/main" id="{32AE4078-B314-A6EE-8FBE-CCF71FB7D752}"/>
                  </a:ext>
                </a:extLst>
              </p:cNvPr>
              <p:cNvSpPr/>
              <p:nvPr/>
            </p:nvSpPr>
            <p:spPr>
              <a:xfrm rot="272787">
                <a:off x="4417393" y="1058935"/>
                <a:ext cx="188191" cy="258709"/>
              </a:xfrm>
              <a:custGeom>
                <a:avLst/>
                <a:gdLst>
                  <a:gd name="connsiteX0" fmla="*/ 573122 w 638175"/>
                  <a:gd name="connsiteY0" fmla="*/ 168542 h 891025"/>
                  <a:gd name="connsiteX1" fmla="*/ 486036 w 638175"/>
                  <a:gd name="connsiteY1" fmla="*/ 27028 h 891025"/>
                  <a:gd name="connsiteX2" fmla="*/ 333636 w 638175"/>
                  <a:gd name="connsiteY2" fmla="*/ 5256 h 891025"/>
                  <a:gd name="connsiteX3" fmla="*/ 170351 w 638175"/>
                  <a:gd name="connsiteY3" fmla="*/ 92342 h 891025"/>
                  <a:gd name="connsiteX4" fmla="*/ 7065 w 638175"/>
                  <a:gd name="connsiteY4" fmla="*/ 353599 h 891025"/>
                  <a:gd name="connsiteX5" fmla="*/ 61494 w 638175"/>
                  <a:gd name="connsiteY5" fmla="*/ 734599 h 891025"/>
                  <a:gd name="connsiteX6" fmla="*/ 344522 w 638175"/>
                  <a:gd name="connsiteY6" fmla="*/ 886999 h 891025"/>
                  <a:gd name="connsiteX7" fmla="*/ 616665 w 638175"/>
                  <a:gd name="connsiteY7" fmla="*/ 821685 h 891025"/>
                  <a:gd name="connsiteX8" fmla="*/ 594894 w 638175"/>
                  <a:gd name="connsiteY8" fmla="*/ 560428 h 891025"/>
                  <a:gd name="connsiteX9" fmla="*/ 388065 w 638175"/>
                  <a:gd name="connsiteY9" fmla="*/ 560428 h 891025"/>
                  <a:gd name="connsiteX10" fmla="*/ 279208 w 638175"/>
                  <a:gd name="connsiteY10" fmla="*/ 375371 h 891025"/>
                  <a:gd name="connsiteX11" fmla="*/ 398951 w 638175"/>
                  <a:gd name="connsiteY11" fmla="*/ 266514 h 891025"/>
                  <a:gd name="connsiteX12" fmla="*/ 496922 w 638175"/>
                  <a:gd name="connsiteY12" fmla="*/ 288285 h 891025"/>
                  <a:gd name="connsiteX13" fmla="*/ 573122 w 638175"/>
                  <a:gd name="connsiteY13" fmla="*/ 168542 h 8910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38175" h="891025">
                    <a:moveTo>
                      <a:pt x="573122" y="168542"/>
                    </a:moveTo>
                    <a:cubicBezTo>
                      <a:pt x="571308" y="124999"/>
                      <a:pt x="525950" y="54242"/>
                      <a:pt x="486036" y="27028"/>
                    </a:cubicBezTo>
                    <a:cubicBezTo>
                      <a:pt x="446122" y="-186"/>
                      <a:pt x="386250" y="-5630"/>
                      <a:pt x="333636" y="5256"/>
                    </a:cubicBezTo>
                    <a:cubicBezTo>
                      <a:pt x="281022" y="16142"/>
                      <a:pt x="224779" y="34285"/>
                      <a:pt x="170351" y="92342"/>
                    </a:cubicBezTo>
                    <a:cubicBezTo>
                      <a:pt x="115923" y="150399"/>
                      <a:pt x="25208" y="246556"/>
                      <a:pt x="7065" y="353599"/>
                    </a:cubicBezTo>
                    <a:cubicBezTo>
                      <a:pt x="-11078" y="460642"/>
                      <a:pt x="5251" y="645699"/>
                      <a:pt x="61494" y="734599"/>
                    </a:cubicBezTo>
                    <a:cubicBezTo>
                      <a:pt x="117737" y="823499"/>
                      <a:pt x="251994" y="872485"/>
                      <a:pt x="344522" y="886999"/>
                    </a:cubicBezTo>
                    <a:cubicBezTo>
                      <a:pt x="437050" y="901513"/>
                      <a:pt x="574936" y="876113"/>
                      <a:pt x="616665" y="821685"/>
                    </a:cubicBezTo>
                    <a:cubicBezTo>
                      <a:pt x="658394" y="767257"/>
                      <a:pt x="632994" y="603971"/>
                      <a:pt x="594894" y="560428"/>
                    </a:cubicBezTo>
                    <a:cubicBezTo>
                      <a:pt x="556794" y="516885"/>
                      <a:pt x="440679" y="591271"/>
                      <a:pt x="388065" y="560428"/>
                    </a:cubicBezTo>
                    <a:cubicBezTo>
                      <a:pt x="335451" y="529585"/>
                      <a:pt x="277394" y="424357"/>
                      <a:pt x="279208" y="375371"/>
                    </a:cubicBezTo>
                    <a:cubicBezTo>
                      <a:pt x="281022" y="326385"/>
                      <a:pt x="362665" y="281028"/>
                      <a:pt x="398951" y="266514"/>
                    </a:cubicBezTo>
                    <a:cubicBezTo>
                      <a:pt x="435237" y="252000"/>
                      <a:pt x="471522" y="299171"/>
                      <a:pt x="496922" y="288285"/>
                    </a:cubicBezTo>
                    <a:cubicBezTo>
                      <a:pt x="522322" y="277399"/>
                      <a:pt x="574936" y="212085"/>
                      <a:pt x="573122" y="168542"/>
                    </a:cubicBezTo>
                    <a:close/>
                  </a:path>
                </a:pathLst>
              </a:cu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 dirty="0">
                  <a:latin typeface="Helvetica" pitchFamily="2" charset="0"/>
                </a:endParaRPr>
              </a:p>
            </p:txBody>
          </p:sp>
          <p:sp>
            <p:nvSpPr>
              <p:cNvPr id="190" name="フリーフォーム 189">
                <a:extLst>
                  <a:ext uri="{FF2B5EF4-FFF2-40B4-BE49-F238E27FC236}">
                    <a16:creationId xmlns:a16="http://schemas.microsoft.com/office/drawing/2014/main" id="{20F83C39-5C85-621E-FE6D-DE63F51D20DB}"/>
                  </a:ext>
                </a:extLst>
              </p:cNvPr>
              <p:cNvSpPr/>
              <p:nvPr/>
            </p:nvSpPr>
            <p:spPr>
              <a:xfrm rot="21327213" flipH="1">
                <a:off x="4569793" y="1058934"/>
                <a:ext cx="188191" cy="258709"/>
              </a:xfrm>
              <a:custGeom>
                <a:avLst/>
                <a:gdLst>
                  <a:gd name="connsiteX0" fmla="*/ 573122 w 638175"/>
                  <a:gd name="connsiteY0" fmla="*/ 168542 h 891025"/>
                  <a:gd name="connsiteX1" fmla="*/ 486036 w 638175"/>
                  <a:gd name="connsiteY1" fmla="*/ 27028 h 891025"/>
                  <a:gd name="connsiteX2" fmla="*/ 333636 w 638175"/>
                  <a:gd name="connsiteY2" fmla="*/ 5256 h 891025"/>
                  <a:gd name="connsiteX3" fmla="*/ 170351 w 638175"/>
                  <a:gd name="connsiteY3" fmla="*/ 92342 h 891025"/>
                  <a:gd name="connsiteX4" fmla="*/ 7065 w 638175"/>
                  <a:gd name="connsiteY4" fmla="*/ 353599 h 891025"/>
                  <a:gd name="connsiteX5" fmla="*/ 61494 w 638175"/>
                  <a:gd name="connsiteY5" fmla="*/ 734599 h 891025"/>
                  <a:gd name="connsiteX6" fmla="*/ 344522 w 638175"/>
                  <a:gd name="connsiteY6" fmla="*/ 886999 h 891025"/>
                  <a:gd name="connsiteX7" fmla="*/ 616665 w 638175"/>
                  <a:gd name="connsiteY7" fmla="*/ 821685 h 891025"/>
                  <a:gd name="connsiteX8" fmla="*/ 594894 w 638175"/>
                  <a:gd name="connsiteY8" fmla="*/ 560428 h 891025"/>
                  <a:gd name="connsiteX9" fmla="*/ 388065 w 638175"/>
                  <a:gd name="connsiteY9" fmla="*/ 560428 h 891025"/>
                  <a:gd name="connsiteX10" fmla="*/ 279208 w 638175"/>
                  <a:gd name="connsiteY10" fmla="*/ 375371 h 891025"/>
                  <a:gd name="connsiteX11" fmla="*/ 398951 w 638175"/>
                  <a:gd name="connsiteY11" fmla="*/ 266514 h 891025"/>
                  <a:gd name="connsiteX12" fmla="*/ 496922 w 638175"/>
                  <a:gd name="connsiteY12" fmla="*/ 288285 h 891025"/>
                  <a:gd name="connsiteX13" fmla="*/ 573122 w 638175"/>
                  <a:gd name="connsiteY13" fmla="*/ 168542 h 8910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</a:cxnLst>
                <a:rect l="l" t="t" r="r" b="b"/>
                <a:pathLst>
                  <a:path w="638175" h="891025">
                    <a:moveTo>
                      <a:pt x="573122" y="168542"/>
                    </a:moveTo>
                    <a:cubicBezTo>
                      <a:pt x="571308" y="124999"/>
                      <a:pt x="525950" y="54242"/>
                      <a:pt x="486036" y="27028"/>
                    </a:cubicBezTo>
                    <a:cubicBezTo>
                      <a:pt x="446122" y="-186"/>
                      <a:pt x="386250" y="-5630"/>
                      <a:pt x="333636" y="5256"/>
                    </a:cubicBezTo>
                    <a:cubicBezTo>
                      <a:pt x="281022" y="16142"/>
                      <a:pt x="224779" y="34285"/>
                      <a:pt x="170351" y="92342"/>
                    </a:cubicBezTo>
                    <a:cubicBezTo>
                      <a:pt x="115923" y="150399"/>
                      <a:pt x="25208" y="246556"/>
                      <a:pt x="7065" y="353599"/>
                    </a:cubicBezTo>
                    <a:cubicBezTo>
                      <a:pt x="-11078" y="460642"/>
                      <a:pt x="5251" y="645699"/>
                      <a:pt x="61494" y="734599"/>
                    </a:cubicBezTo>
                    <a:cubicBezTo>
                      <a:pt x="117737" y="823499"/>
                      <a:pt x="251994" y="872485"/>
                      <a:pt x="344522" y="886999"/>
                    </a:cubicBezTo>
                    <a:cubicBezTo>
                      <a:pt x="437050" y="901513"/>
                      <a:pt x="574936" y="876113"/>
                      <a:pt x="616665" y="821685"/>
                    </a:cubicBezTo>
                    <a:cubicBezTo>
                      <a:pt x="658394" y="767257"/>
                      <a:pt x="632994" y="603971"/>
                      <a:pt x="594894" y="560428"/>
                    </a:cubicBezTo>
                    <a:cubicBezTo>
                      <a:pt x="556794" y="516885"/>
                      <a:pt x="440679" y="591271"/>
                      <a:pt x="388065" y="560428"/>
                    </a:cubicBezTo>
                    <a:cubicBezTo>
                      <a:pt x="335451" y="529585"/>
                      <a:pt x="277394" y="424357"/>
                      <a:pt x="279208" y="375371"/>
                    </a:cubicBezTo>
                    <a:cubicBezTo>
                      <a:pt x="281022" y="326385"/>
                      <a:pt x="362665" y="281028"/>
                      <a:pt x="398951" y="266514"/>
                    </a:cubicBezTo>
                    <a:cubicBezTo>
                      <a:pt x="435237" y="252000"/>
                      <a:pt x="471522" y="299171"/>
                      <a:pt x="496922" y="288285"/>
                    </a:cubicBezTo>
                    <a:cubicBezTo>
                      <a:pt x="522322" y="277399"/>
                      <a:pt x="574936" y="212085"/>
                      <a:pt x="573122" y="168542"/>
                    </a:cubicBezTo>
                    <a:close/>
                  </a:path>
                </a:pathLst>
              </a:custGeom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 dirty="0">
                  <a:latin typeface="Helvetica" pitchFamily="2" charset="0"/>
                </a:endParaRPr>
              </a:p>
            </p:txBody>
          </p:sp>
          <p:sp>
            <p:nvSpPr>
              <p:cNvPr id="191" name="フリーフォーム 190">
                <a:extLst>
                  <a:ext uri="{FF2B5EF4-FFF2-40B4-BE49-F238E27FC236}">
                    <a16:creationId xmlns:a16="http://schemas.microsoft.com/office/drawing/2014/main" id="{E2D237C0-4262-C240-044C-494127780986}"/>
                  </a:ext>
                </a:extLst>
              </p:cNvPr>
              <p:cNvSpPr/>
              <p:nvPr/>
            </p:nvSpPr>
            <p:spPr>
              <a:xfrm rot="21155521">
                <a:off x="4230657" y="2219687"/>
                <a:ext cx="287110" cy="341454"/>
              </a:xfrm>
              <a:custGeom>
                <a:avLst/>
                <a:gdLst>
                  <a:gd name="connsiteX0" fmla="*/ 33790 w 251639"/>
                  <a:gd name="connsiteY0" fmla="*/ 265254 h 340322"/>
                  <a:gd name="connsiteX1" fmla="*/ 1133 w 251639"/>
                  <a:gd name="connsiteY1" fmla="*/ 123740 h 340322"/>
                  <a:gd name="connsiteX2" fmla="*/ 55561 w 251639"/>
                  <a:gd name="connsiteY2" fmla="*/ 25769 h 340322"/>
                  <a:gd name="connsiteX3" fmla="*/ 186190 w 251639"/>
                  <a:gd name="connsiteY3" fmla="*/ 3997 h 340322"/>
                  <a:gd name="connsiteX4" fmla="*/ 251504 w 251639"/>
                  <a:gd name="connsiteY4" fmla="*/ 91083 h 340322"/>
                  <a:gd name="connsiteX5" fmla="*/ 197076 w 251639"/>
                  <a:gd name="connsiteY5" fmla="*/ 330569 h 340322"/>
                  <a:gd name="connsiteX6" fmla="*/ 33790 w 251639"/>
                  <a:gd name="connsiteY6" fmla="*/ 265254 h 3403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51639" h="340322">
                    <a:moveTo>
                      <a:pt x="33790" y="265254"/>
                    </a:moveTo>
                    <a:cubicBezTo>
                      <a:pt x="1133" y="230783"/>
                      <a:pt x="-2495" y="163654"/>
                      <a:pt x="1133" y="123740"/>
                    </a:cubicBezTo>
                    <a:cubicBezTo>
                      <a:pt x="4761" y="83826"/>
                      <a:pt x="24718" y="45726"/>
                      <a:pt x="55561" y="25769"/>
                    </a:cubicBezTo>
                    <a:cubicBezTo>
                      <a:pt x="86404" y="5812"/>
                      <a:pt x="153533" y="-6889"/>
                      <a:pt x="186190" y="3997"/>
                    </a:cubicBezTo>
                    <a:cubicBezTo>
                      <a:pt x="218847" y="14883"/>
                      <a:pt x="249690" y="36654"/>
                      <a:pt x="251504" y="91083"/>
                    </a:cubicBezTo>
                    <a:cubicBezTo>
                      <a:pt x="253318" y="145512"/>
                      <a:pt x="236990" y="296098"/>
                      <a:pt x="197076" y="330569"/>
                    </a:cubicBezTo>
                    <a:cubicBezTo>
                      <a:pt x="157162" y="365040"/>
                      <a:pt x="66447" y="299725"/>
                      <a:pt x="33790" y="265254"/>
                    </a:cubicBezTo>
                    <a:close/>
                  </a:path>
                </a:pathLst>
              </a:cu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>
                  <a:latin typeface="Helvetica" pitchFamily="2" charset="0"/>
                </a:endParaRPr>
              </a:p>
            </p:txBody>
          </p:sp>
          <p:sp>
            <p:nvSpPr>
              <p:cNvPr id="192" name="フリーフォーム 191">
                <a:extLst>
                  <a:ext uri="{FF2B5EF4-FFF2-40B4-BE49-F238E27FC236}">
                    <a16:creationId xmlns:a16="http://schemas.microsoft.com/office/drawing/2014/main" id="{4A2A4B4A-19A4-CE72-0077-2731B21518FF}"/>
                  </a:ext>
                </a:extLst>
              </p:cNvPr>
              <p:cNvSpPr/>
              <p:nvPr/>
            </p:nvSpPr>
            <p:spPr>
              <a:xfrm rot="703009" flipH="1">
                <a:off x="4496167" y="2221205"/>
                <a:ext cx="283313" cy="343511"/>
              </a:xfrm>
              <a:custGeom>
                <a:avLst/>
                <a:gdLst>
                  <a:gd name="connsiteX0" fmla="*/ 33790 w 251639"/>
                  <a:gd name="connsiteY0" fmla="*/ 265254 h 340322"/>
                  <a:gd name="connsiteX1" fmla="*/ 1133 w 251639"/>
                  <a:gd name="connsiteY1" fmla="*/ 123740 h 340322"/>
                  <a:gd name="connsiteX2" fmla="*/ 55561 w 251639"/>
                  <a:gd name="connsiteY2" fmla="*/ 25769 h 340322"/>
                  <a:gd name="connsiteX3" fmla="*/ 186190 w 251639"/>
                  <a:gd name="connsiteY3" fmla="*/ 3997 h 340322"/>
                  <a:gd name="connsiteX4" fmla="*/ 251504 w 251639"/>
                  <a:gd name="connsiteY4" fmla="*/ 91083 h 340322"/>
                  <a:gd name="connsiteX5" fmla="*/ 197076 w 251639"/>
                  <a:gd name="connsiteY5" fmla="*/ 330569 h 340322"/>
                  <a:gd name="connsiteX6" fmla="*/ 33790 w 251639"/>
                  <a:gd name="connsiteY6" fmla="*/ 265254 h 34032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51639" h="340322">
                    <a:moveTo>
                      <a:pt x="33790" y="265254"/>
                    </a:moveTo>
                    <a:cubicBezTo>
                      <a:pt x="1133" y="230783"/>
                      <a:pt x="-2495" y="163654"/>
                      <a:pt x="1133" y="123740"/>
                    </a:cubicBezTo>
                    <a:cubicBezTo>
                      <a:pt x="4761" y="83826"/>
                      <a:pt x="24718" y="45726"/>
                      <a:pt x="55561" y="25769"/>
                    </a:cubicBezTo>
                    <a:cubicBezTo>
                      <a:pt x="86404" y="5812"/>
                      <a:pt x="153533" y="-6889"/>
                      <a:pt x="186190" y="3997"/>
                    </a:cubicBezTo>
                    <a:cubicBezTo>
                      <a:pt x="218847" y="14883"/>
                      <a:pt x="249690" y="36654"/>
                      <a:pt x="251504" y="91083"/>
                    </a:cubicBezTo>
                    <a:cubicBezTo>
                      <a:pt x="253318" y="145512"/>
                      <a:pt x="236990" y="296098"/>
                      <a:pt x="197076" y="330569"/>
                    </a:cubicBezTo>
                    <a:cubicBezTo>
                      <a:pt x="157162" y="365040"/>
                      <a:pt x="66447" y="299725"/>
                      <a:pt x="33790" y="265254"/>
                    </a:cubicBezTo>
                    <a:close/>
                  </a:path>
                </a:pathLst>
              </a:custGeom>
              <a:solidFill>
                <a:schemeClr val="accent5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>
                  <a:latin typeface="Helvetica" pitchFamily="2" charset="0"/>
                </a:endParaRPr>
              </a:p>
            </p:txBody>
          </p:sp>
          <p:sp>
            <p:nvSpPr>
              <p:cNvPr id="193" name="角丸四角形 192">
                <a:extLst>
                  <a:ext uri="{FF2B5EF4-FFF2-40B4-BE49-F238E27FC236}">
                    <a16:creationId xmlns:a16="http://schemas.microsoft.com/office/drawing/2014/main" id="{640D8D5B-7AB6-5E94-F950-16F754B8BEBC}"/>
                  </a:ext>
                </a:extLst>
              </p:cNvPr>
              <p:cNvSpPr/>
              <p:nvPr/>
            </p:nvSpPr>
            <p:spPr>
              <a:xfrm rot="18891331">
                <a:off x="4082387" y="2022956"/>
                <a:ext cx="70017" cy="296757"/>
              </a:xfrm>
              <a:prstGeom prst="roundRect">
                <a:avLst>
                  <a:gd name="adj" fmla="val 50000"/>
                </a:avLst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>
                  <a:latin typeface="Helvetica" pitchFamily="2" charset="0"/>
                </a:endParaRPr>
              </a:p>
            </p:txBody>
          </p:sp>
          <p:sp>
            <p:nvSpPr>
              <p:cNvPr id="194" name="角丸四角形 193">
                <a:extLst>
                  <a:ext uri="{FF2B5EF4-FFF2-40B4-BE49-F238E27FC236}">
                    <a16:creationId xmlns:a16="http://schemas.microsoft.com/office/drawing/2014/main" id="{2C2A2330-B22D-3BA8-85A3-95CFDFA0D862}"/>
                  </a:ext>
                </a:extLst>
              </p:cNvPr>
              <p:cNvSpPr/>
              <p:nvPr/>
            </p:nvSpPr>
            <p:spPr>
              <a:xfrm rot="5556525" flipH="1">
                <a:off x="4744398" y="2382581"/>
                <a:ext cx="126099" cy="65300"/>
              </a:xfrm>
              <a:prstGeom prst="roundRect">
                <a:avLst>
                  <a:gd name="adj" fmla="val 50000"/>
                </a:avLst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>
                  <a:latin typeface="Helvetica" pitchFamily="2" charset="0"/>
                </a:endParaRPr>
              </a:p>
            </p:txBody>
          </p:sp>
        </p:grp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F1519EE1-7D07-4B2C-7400-D42DDEAE7462}"/>
                </a:ext>
              </a:extLst>
            </p:cNvPr>
            <p:cNvSpPr txBox="1"/>
            <p:nvPr/>
          </p:nvSpPr>
          <p:spPr>
            <a:xfrm>
              <a:off x="1032253" y="5896036"/>
              <a:ext cx="605808" cy="283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CN" sz="800" b="1" dirty="0">
                  <a:solidFill>
                    <a:schemeClr val="accent4"/>
                  </a:solidFill>
                  <a:latin typeface="Helvetica" pitchFamily="2" charset="0"/>
                </a:rPr>
                <a:t>Psm3</a:t>
              </a:r>
              <a:endParaRPr kumimoji="1" lang="ja-CN" altLang="en-US" sz="800" b="1" dirty="0">
                <a:solidFill>
                  <a:schemeClr val="accent4"/>
                </a:solidFill>
                <a:latin typeface="Helvetica" pitchFamily="2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4769F96D-FCB2-E8F1-8D65-20FE792BB808}"/>
                </a:ext>
              </a:extLst>
            </p:cNvPr>
            <p:cNvSpPr txBox="1"/>
            <p:nvPr/>
          </p:nvSpPr>
          <p:spPr>
            <a:xfrm>
              <a:off x="771839" y="7939639"/>
              <a:ext cx="580733" cy="283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CN" sz="800" b="1" dirty="0">
                  <a:solidFill>
                    <a:schemeClr val="accent6"/>
                  </a:solidFill>
                  <a:latin typeface="Helvetica" pitchFamily="2" charset="0"/>
                </a:rPr>
                <a:t>Mis4</a:t>
              </a:r>
              <a:endParaRPr kumimoji="1" lang="ja-CN" altLang="en-US" sz="800" b="1" dirty="0">
                <a:solidFill>
                  <a:schemeClr val="accent6"/>
                </a:solidFill>
                <a:latin typeface="Helvetica" pitchFamily="2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DB065174-85B9-F7F3-8AC0-6EC21E44F254}"/>
                </a:ext>
              </a:extLst>
            </p:cNvPr>
            <p:cNvSpPr txBox="1"/>
            <p:nvPr/>
          </p:nvSpPr>
          <p:spPr>
            <a:xfrm>
              <a:off x="833479" y="7554886"/>
              <a:ext cx="597333" cy="283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CN" sz="800" b="1" dirty="0">
                  <a:solidFill>
                    <a:srgbClr val="FF0000"/>
                  </a:solidFill>
                  <a:latin typeface="Helvetica" pitchFamily="2" charset="0"/>
                </a:rPr>
                <a:t>Rec8</a:t>
              </a:r>
              <a:endParaRPr kumimoji="1" lang="ja-CN" altLang="en-US" sz="800" b="1" dirty="0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72" name="テキスト ボックス 37">
              <a:extLst>
                <a:ext uri="{FF2B5EF4-FFF2-40B4-BE49-F238E27FC236}">
                  <a16:creationId xmlns:a16="http://schemas.microsoft.com/office/drawing/2014/main" id="{CD0FF5B2-3EFA-F778-B8E4-D8D5DBD7733A}"/>
                </a:ext>
              </a:extLst>
            </p:cNvPr>
            <p:cNvSpPr txBox="1"/>
            <p:nvPr/>
          </p:nvSpPr>
          <p:spPr>
            <a:xfrm>
              <a:off x="1383702" y="6866807"/>
              <a:ext cx="520681" cy="26324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en-US" sz="700" b="1" dirty="0">
                  <a:solidFill>
                    <a:schemeClr val="accent4"/>
                  </a:solidFill>
                  <a:latin typeface="Helvetica" pitchFamily="2" charset="0"/>
                </a:rPr>
                <a:t>T182</a:t>
              </a:r>
              <a:endParaRPr kumimoji="1" lang="x-none" altLang="en-US" sz="700" b="1" dirty="0">
                <a:solidFill>
                  <a:schemeClr val="accent4"/>
                </a:solidFill>
              </a:endParaRPr>
            </a:p>
          </p:txBody>
        </p:sp>
        <p:sp>
          <p:nvSpPr>
            <p:cNvPr id="173" name="テキスト ボックス 37">
              <a:extLst>
                <a:ext uri="{FF2B5EF4-FFF2-40B4-BE49-F238E27FC236}">
                  <a16:creationId xmlns:a16="http://schemas.microsoft.com/office/drawing/2014/main" id="{91F0FC5D-0514-75CA-C710-94555BD1C060}"/>
                </a:ext>
              </a:extLst>
            </p:cNvPr>
            <p:cNvSpPr txBox="1"/>
            <p:nvPr/>
          </p:nvSpPr>
          <p:spPr>
            <a:xfrm>
              <a:off x="1317289" y="6740464"/>
              <a:ext cx="683241" cy="26324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en-US" sz="700" b="1" dirty="0">
                  <a:solidFill>
                    <a:schemeClr val="accent4"/>
                  </a:solidFill>
                  <a:latin typeface="Helvetica" pitchFamily="2" charset="0"/>
                </a:rPr>
                <a:t>S1001</a:t>
              </a:r>
            </a:p>
          </p:txBody>
        </p:sp>
        <p:sp>
          <p:nvSpPr>
            <p:cNvPr id="174" name="円/楕円 173">
              <a:extLst>
                <a:ext uri="{FF2B5EF4-FFF2-40B4-BE49-F238E27FC236}">
                  <a16:creationId xmlns:a16="http://schemas.microsoft.com/office/drawing/2014/main" id="{FFF08D64-6759-0D89-B2E1-502F92637D6B}"/>
                </a:ext>
              </a:extLst>
            </p:cNvPr>
            <p:cNvSpPr/>
            <p:nvPr/>
          </p:nvSpPr>
          <p:spPr>
            <a:xfrm>
              <a:off x="1859458" y="8076176"/>
              <a:ext cx="83773" cy="83773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ECB1C067-F919-540C-A2F5-84224A6547D3}"/>
                </a:ext>
              </a:extLst>
            </p:cNvPr>
            <p:cNvSpPr txBox="1"/>
            <p:nvPr/>
          </p:nvSpPr>
          <p:spPr>
            <a:xfrm>
              <a:off x="1383115" y="6991331"/>
              <a:ext cx="624566" cy="263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700" b="1" dirty="0">
                  <a:solidFill>
                    <a:schemeClr val="accent4"/>
                  </a:solidFill>
                  <a:latin typeface="Helvetica" pitchFamily="2" charset="0"/>
                </a:rPr>
                <a:t>S110</a:t>
              </a:r>
            </a:p>
          </p:txBody>
        </p:sp>
        <p:sp>
          <p:nvSpPr>
            <p:cNvPr id="176" name="円/楕円 175">
              <a:extLst>
                <a:ext uri="{FF2B5EF4-FFF2-40B4-BE49-F238E27FC236}">
                  <a16:creationId xmlns:a16="http://schemas.microsoft.com/office/drawing/2014/main" id="{53C6320D-281F-9DDA-4E18-A563E8B7312B}"/>
                </a:ext>
              </a:extLst>
            </p:cNvPr>
            <p:cNvSpPr/>
            <p:nvPr/>
          </p:nvSpPr>
          <p:spPr>
            <a:xfrm>
              <a:off x="1409164" y="7366723"/>
              <a:ext cx="129425" cy="129427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77" name="円/楕円 176">
              <a:extLst>
                <a:ext uri="{FF2B5EF4-FFF2-40B4-BE49-F238E27FC236}">
                  <a16:creationId xmlns:a16="http://schemas.microsoft.com/office/drawing/2014/main" id="{419454E7-6A10-BB26-8AE6-FA00C26A94DD}"/>
                </a:ext>
              </a:extLst>
            </p:cNvPr>
            <p:cNvSpPr/>
            <p:nvPr/>
          </p:nvSpPr>
          <p:spPr>
            <a:xfrm>
              <a:off x="1547364" y="7365279"/>
              <a:ext cx="129425" cy="129427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78" name="テキスト ボックス 37">
              <a:extLst>
                <a:ext uri="{FF2B5EF4-FFF2-40B4-BE49-F238E27FC236}">
                  <a16:creationId xmlns:a16="http://schemas.microsoft.com/office/drawing/2014/main" id="{DF674BDE-6C5C-8233-0F52-92C856A19D74}"/>
                </a:ext>
              </a:extLst>
            </p:cNvPr>
            <p:cNvSpPr txBox="1"/>
            <p:nvPr/>
          </p:nvSpPr>
          <p:spPr>
            <a:xfrm>
              <a:off x="1315672" y="7313076"/>
              <a:ext cx="249608" cy="2429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en-US" sz="600" b="1" dirty="0">
                  <a:latin typeface="Helvetica" pitchFamily="2" charset="0"/>
                </a:rPr>
                <a:t>K</a:t>
              </a:r>
            </a:p>
          </p:txBody>
        </p:sp>
        <p:sp>
          <p:nvSpPr>
            <p:cNvPr id="179" name="テキスト ボックス 37">
              <a:extLst>
                <a:ext uri="{FF2B5EF4-FFF2-40B4-BE49-F238E27FC236}">
                  <a16:creationId xmlns:a16="http://schemas.microsoft.com/office/drawing/2014/main" id="{F658CD3C-4B22-D7B0-9598-4DBE81FEFF27}"/>
                </a:ext>
              </a:extLst>
            </p:cNvPr>
            <p:cNvSpPr txBox="1"/>
            <p:nvPr/>
          </p:nvSpPr>
          <p:spPr>
            <a:xfrm>
              <a:off x="1453884" y="7310968"/>
              <a:ext cx="249608" cy="2429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en-US" sz="600" b="1" dirty="0">
                  <a:latin typeface="Helvetica" pitchFamily="2" charset="0"/>
                </a:rPr>
                <a:t>K</a:t>
              </a:r>
            </a:p>
          </p:txBody>
        </p:sp>
        <p:sp>
          <p:nvSpPr>
            <p:cNvPr id="180" name="下矢印 179">
              <a:extLst>
                <a:ext uri="{FF2B5EF4-FFF2-40B4-BE49-F238E27FC236}">
                  <a16:creationId xmlns:a16="http://schemas.microsoft.com/office/drawing/2014/main" id="{7CD56766-A8F6-1547-6F16-A9F0A4A5A6BA}"/>
                </a:ext>
              </a:extLst>
            </p:cNvPr>
            <p:cNvSpPr/>
            <p:nvPr/>
          </p:nvSpPr>
          <p:spPr>
            <a:xfrm rot="2738431">
              <a:off x="1284075" y="6873277"/>
              <a:ext cx="98511" cy="237048"/>
            </a:xfrm>
            <a:prstGeom prst="downArrow">
              <a:avLst>
                <a:gd name="adj1" fmla="val 18750"/>
                <a:gd name="adj2" fmla="val 5000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81" name="下矢印 180">
              <a:extLst>
                <a:ext uri="{FF2B5EF4-FFF2-40B4-BE49-F238E27FC236}">
                  <a16:creationId xmlns:a16="http://schemas.microsoft.com/office/drawing/2014/main" id="{D97A3BE5-5512-DE31-ACAE-F3A1D2CE8A02}"/>
                </a:ext>
              </a:extLst>
            </p:cNvPr>
            <p:cNvSpPr/>
            <p:nvPr/>
          </p:nvSpPr>
          <p:spPr>
            <a:xfrm rot="2738431">
              <a:off x="1368622" y="6984222"/>
              <a:ext cx="90699" cy="192327"/>
            </a:xfrm>
            <a:prstGeom prst="downArrow">
              <a:avLst>
                <a:gd name="adj1" fmla="val 18750"/>
                <a:gd name="adj2" fmla="val 5000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82" name="下矢印 181">
              <a:extLst>
                <a:ext uri="{FF2B5EF4-FFF2-40B4-BE49-F238E27FC236}">
                  <a16:creationId xmlns:a16="http://schemas.microsoft.com/office/drawing/2014/main" id="{887A46C6-0F93-55E2-9402-2E47B866F9A2}"/>
                </a:ext>
              </a:extLst>
            </p:cNvPr>
            <p:cNvSpPr/>
            <p:nvPr/>
          </p:nvSpPr>
          <p:spPr>
            <a:xfrm rot="1370995">
              <a:off x="1536520" y="7170315"/>
              <a:ext cx="89564" cy="155492"/>
            </a:xfrm>
            <a:prstGeom prst="downArrow">
              <a:avLst>
                <a:gd name="adj1" fmla="val 18750"/>
                <a:gd name="adj2" fmla="val 50000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83" name="フリーフォーム 182">
              <a:extLst>
                <a:ext uri="{FF2B5EF4-FFF2-40B4-BE49-F238E27FC236}">
                  <a16:creationId xmlns:a16="http://schemas.microsoft.com/office/drawing/2014/main" id="{5309BABE-67E9-6B89-6A0F-23018313A9E9}"/>
                </a:ext>
              </a:extLst>
            </p:cNvPr>
            <p:cNvSpPr/>
            <p:nvPr/>
          </p:nvSpPr>
          <p:spPr>
            <a:xfrm>
              <a:off x="939478" y="7007723"/>
              <a:ext cx="1177886" cy="1792929"/>
            </a:xfrm>
            <a:custGeom>
              <a:avLst/>
              <a:gdLst>
                <a:gd name="connsiteX0" fmla="*/ 406921 w 1223540"/>
                <a:gd name="connsiteY0" fmla="*/ 209508 h 1792929"/>
                <a:gd name="connsiteX1" fmla="*/ 254521 w 1223540"/>
                <a:gd name="connsiteY1" fmla="*/ 57108 h 1792929"/>
                <a:gd name="connsiteX2" fmla="*/ 173839 w 1223540"/>
                <a:gd name="connsiteY2" fmla="*/ 3319 h 1792929"/>
                <a:gd name="connsiteX3" fmla="*/ 39368 w 1223540"/>
                <a:gd name="connsiteY3" fmla="*/ 21249 h 1792929"/>
                <a:gd name="connsiteX4" fmla="*/ 30403 w 1223540"/>
                <a:gd name="connsiteY4" fmla="*/ 146755 h 1792929"/>
                <a:gd name="connsiteX5" fmla="*/ 406921 w 1223540"/>
                <a:gd name="connsiteY5" fmla="*/ 424661 h 1792929"/>
                <a:gd name="connsiteX6" fmla="*/ 532427 w 1223540"/>
                <a:gd name="connsiteY6" fmla="*/ 962543 h 1792929"/>
                <a:gd name="connsiteX7" fmla="*/ 613109 w 1223540"/>
                <a:gd name="connsiteY7" fmla="*/ 1258378 h 1792929"/>
                <a:gd name="connsiteX8" fmla="*/ 738615 w 1223540"/>
                <a:gd name="connsiteY8" fmla="*/ 1482496 h 1792929"/>
                <a:gd name="connsiteX9" fmla="*/ 523462 w 1223540"/>
                <a:gd name="connsiteY9" fmla="*/ 1518355 h 1792929"/>
                <a:gd name="connsiteX10" fmla="*/ 371062 w 1223540"/>
                <a:gd name="connsiteY10" fmla="*/ 1392849 h 1792929"/>
                <a:gd name="connsiteX11" fmla="*/ 200733 w 1223540"/>
                <a:gd name="connsiteY11" fmla="*/ 1428708 h 1792929"/>
                <a:gd name="connsiteX12" fmla="*/ 200733 w 1223540"/>
                <a:gd name="connsiteY12" fmla="*/ 1590072 h 1792929"/>
                <a:gd name="connsiteX13" fmla="*/ 478639 w 1223540"/>
                <a:gd name="connsiteY13" fmla="*/ 1787296 h 1792929"/>
                <a:gd name="connsiteX14" fmla="*/ 1016521 w 1223540"/>
                <a:gd name="connsiteY14" fmla="*/ 1724543 h 1792929"/>
                <a:gd name="connsiteX15" fmla="*/ 1186851 w 1223540"/>
                <a:gd name="connsiteY15" fmla="*/ 1572143 h 1792929"/>
                <a:gd name="connsiteX16" fmla="*/ 1043415 w 1223540"/>
                <a:gd name="connsiteY16" fmla="*/ 1195625 h 1792929"/>
                <a:gd name="connsiteX17" fmla="*/ 962733 w 1223540"/>
                <a:gd name="connsiteY17" fmla="*/ 1016331 h 1792929"/>
                <a:gd name="connsiteX18" fmla="*/ 1007556 w 1223540"/>
                <a:gd name="connsiteY18" fmla="*/ 890825 h 1792929"/>
                <a:gd name="connsiteX19" fmla="*/ 1177886 w 1223540"/>
                <a:gd name="connsiteY19" fmla="*/ 783249 h 1792929"/>
                <a:gd name="connsiteX20" fmla="*/ 1222709 w 1223540"/>
                <a:gd name="connsiteY20" fmla="*/ 612919 h 1792929"/>
                <a:gd name="connsiteX21" fmla="*/ 1150992 w 1223540"/>
                <a:gd name="connsiteY21" fmla="*/ 415696 h 1792929"/>
                <a:gd name="connsiteX22" fmla="*/ 1159956 w 1223540"/>
                <a:gd name="connsiteY22" fmla="*/ 433625 h 179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</a:cxnLst>
              <a:rect l="l" t="t" r="r" b="b"/>
              <a:pathLst>
                <a:path w="1223540" h="1792929">
                  <a:moveTo>
                    <a:pt x="406921" y="209508"/>
                  </a:moveTo>
                  <a:cubicBezTo>
                    <a:pt x="350144" y="150490"/>
                    <a:pt x="293368" y="91473"/>
                    <a:pt x="254521" y="57108"/>
                  </a:cubicBezTo>
                  <a:cubicBezTo>
                    <a:pt x="215674" y="22743"/>
                    <a:pt x="209698" y="9295"/>
                    <a:pt x="173839" y="3319"/>
                  </a:cubicBezTo>
                  <a:cubicBezTo>
                    <a:pt x="137980" y="-2657"/>
                    <a:pt x="63274" y="-2657"/>
                    <a:pt x="39368" y="21249"/>
                  </a:cubicBezTo>
                  <a:cubicBezTo>
                    <a:pt x="15462" y="45155"/>
                    <a:pt x="-30856" y="79520"/>
                    <a:pt x="30403" y="146755"/>
                  </a:cubicBezTo>
                  <a:cubicBezTo>
                    <a:pt x="91662" y="213990"/>
                    <a:pt x="323250" y="288696"/>
                    <a:pt x="406921" y="424661"/>
                  </a:cubicBezTo>
                  <a:cubicBezTo>
                    <a:pt x="490592" y="560626"/>
                    <a:pt x="498062" y="823590"/>
                    <a:pt x="532427" y="962543"/>
                  </a:cubicBezTo>
                  <a:cubicBezTo>
                    <a:pt x="566792" y="1101496"/>
                    <a:pt x="578744" y="1171719"/>
                    <a:pt x="613109" y="1258378"/>
                  </a:cubicBezTo>
                  <a:cubicBezTo>
                    <a:pt x="647474" y="1345037"/>
                    <a:pt x="753556" y="1439167"/>
                    <a:pt x="738615" y="1482496"/>
                  </a:cubicBezTo>
                  <a:cubicBezTo>
                    <a:pt x="723674" y="1525825"/>
                    <a:pt x="584721" y="1533296"/>
                    <a:pt x="523462" y="1518355"/>
                  </a:cubicBezTo>
                  <a:cubicBezTo>
                    <a:pt x="462203" y="1503414"/>
                    <a:pt x="424850" y="1407790"/>
                    <a:pt x="371062" y="1392849"/>
                  </a:cubicBezTo>
                  <a:cubicBezTo>
                    <a:pt x="317274" y="1377908"/>
                    <a:pt x="229121" y="1395838"/>
                    <a:pt x="200733" y="1428708"/>
                  </a:cubicBezTo>
                  <a:cubicBezTo>
                    <a:pt x="172345" y="1461578"/>
                    <a:pt x="154415" y="1530307"/>
                    <a:pt x="200733" y="1590072"/>
                  </a:cubicBezTo>
                  <a:cubicBezTo>
                    <a:pt x="247051" y="1649837"/>
                    <a:pt x="342674" y="1764884"/>
                    <a:pt x="478639" y="1787296"/>
                  </a:cubicBezTo>
                  <a:cubicBezTo>
                    <a:pt x="614604" y="1809708"/>
                    <a:pt x="898486" y="1760402"/>
                    <a:pt x="1016521" y="1724543"/>
                  </a:cubicBezTo>
                  <a:cubicBezTo>
                    <a:pt x="1134556" y="1688684"/>
                    <a:pt x="1182369" y="1660296"/>
                    <a:pt x="1186851" y="1572143"/>
                  </a:cubicBezTo>
                  <a:cubicBezTo>
                    <a:pt x="1191333" y="1483990"/>
                    <a:pt x="1080768" y="1288260"/>
                    <a:pt x="1043415" y="1195625"/>
                  </a:cubicBezTo>
                  <a:cubicBezTo>
                    <a:pt x="1006062" y="1102990"/>
                    <a:pt x="968709" y="1067131"/>
                    <a:pt x="962733" y="1016331"/>
                  </a:cubicBezTo>
                  <a:cubicBezTo>
                    <a:pt x="956757" y="965531"/>
                    <a:pt x="971697" y="929672"/>
                    <a:pt x="1007556" y="890825"/>
                  </a:cubicBezTo>
                  <a:cubicBezTo>
                    <a:pt x="1043415" y="851978"/>
                    <a:pt x="1142027" y="829567"/>
                    <a:pt x="1177886" y="783249"/>
                  </a:cubicBezTo>
                  <a:cubicBezTo>
                    <a:pt x="1213745" y="736931"/>
                    <a:pt x="1227191" y="674178"/>
                    <a:pt x="1222709" y="612919"/>
                  </a:cubicBezTo>
                  <a:cubicBezTo>
                    <a:pt x="1218227" y="551660"/>
                    <a:pt x="1150992" y="415696"/>
                    <a:pt x="1150992" y="415696"/>
                  </a:cubicBezTo>
                  <a:cubicBezTo>
                    <a:pt x="1140533" y="385814"/>
                    <a:pt x="1150244" y="409719"/>
                    <a:pt x="1159956" y="433625"/>
                  </a:cubicBezTo>
                </a:path>
              </a:pathLst>
            </a:cu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CN" altLang="en-US"/>
            </a:p>
          </p:txBody>
        </p:sp>
        <p:sp>
          <p:nvSpPr>
            <p:cNvPr id="184" name="正方形/長方形 183">
              <a:extLst>
                <a:ext uri="{FF2B5EF4-FFF2-40B4-BE49-F238E27FC236}">
                  <a16:creationId xmlns:a16="http://schemas.microsoft.com/office/drawing/2014/main" id="{77476CCE-5F03-3D64-7AA0-561879ED3DFF}"/>
                </a:ext>
              </a:extLst>
            </p:cNvPr>
            <p:cNvSpPr/>
            <p:nvPr/>
          </p:nvSpPr>
          <p:spPr>
            <a:xfrm rot="4560115">
              <a:off x="1163440" y="7614680"/>
              <a:ext cx="437021" cy="9494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185" name="正方形/長方形 184">
              <a:extLst>
                <a:ext uri="{FF2B5EF4-FFF2-40B4-BE49-F238E27FC236}">
                  <a16:creationId xmlns:a16="http://schemas.microsoft.com/office/drawing/2014/main" id="{7FA2D86A-128D-6363-BF56-B8B31DC6899C}"/>
                </a:ext>
              </a:extLst>
            </p:cNvPr>
            <p:cNvSpPr/>
            <p:nvPr/>
          </p:nvSpPr>
          <p:spPr>
            <a:xfrm>
              <a:off x="817481" y="6770755"/>
              <a:ext cx="1080045" cy="1136756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CN" altLang="en-US"/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id="{8A39B7B3-E4B0-B7EA-C57A-F3388858DA78}"/>
                </a:ext>
              </a:extLst>
            </p:cNvPr>
            <p:cNvSpPr txBox="1"/>
            <p:nvPr/>
          </p:nvSpPr>
          <p:spPr>
            <a:xfrm>
              <a:off x="1904948" y="7934280"/>
              <a:ext cx="561513" cy="283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CN" sz="800" b="1" dirty="0">
                  <a:solidFill>
                    <a:schemeClr val="accent3">
                      <a:lumMod val="75000"/>
                    </a:schemeClr>
                  </a:solidFill>
                  <a:latin typeface="Helvetica" pitchFamily="2" charset="0"/>
                </a:rPr>
                <a:t>Psc3</a:t>
              </a:r>
              <a:endParaRPr kumimoji="1" lang="ja-CN" altLang="en-US" sz="800" b="1" dirty="0">
                <a:solidFill>
                  <a:schemeClr val="accent3">
                    <a:lumMod val="75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599F318C-7164-AE78-9556-A75F71B11D92}"/>
                </a:ext>
              </a:extLst>
            </p:cNvPr>
            <p:cNvSpPr txBox="1"/>
            <p:nvPr/>
          </p:nvSpPr>
          <p:spPr>
            <a:xfrm>
              <a:off x="2314291" y="7321945"/>
              <a:ext cx="590010" cy="283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CN" sz="800" b="1" dirty="0">
                  <a:latin typeface="Helvetica" pitchFamily="2" charset="0"/>
                </a:rPr>
                <a:t>Eso1</a:t>
              </a:r>
              <a:endParaRPr kumimoji="1" lang="ja-CN" altLang="en-US" sz="800" b="1" dirty="0">
                <a:latin typeface="Helvetica" pitchFamily="2" charset="0"/>
              </a:endParaRPr>
            </a:p>
          </p:txBody>
        </p:sp>
      </p:grpSp>
      <p:grpSp>
        <p:nvGrpSpPr>
          <p:cNvPr id="307" name="グループ化 306">
            <a:extLst>
              <a:ext uri="{FF2B5EF4-FFF2-40B4-BE49-F238E27FC236}">
                <a16:creationId xmlns:a16="http://schemas.microsoft.com/office/drawing/2014/main" id="{A22B66EF-1F00-257D-05A7-7D0471F04DB9}"/>
              </a:ext>
            </a:extLst>
          </p:cNvPr>
          <p:cNvGrpSpPr/>
          <p:nvPr/>
        </p:nvGrpSpPr>
        <p:grpSpPr>
          <a:xfrm>
            <a:off x="3037419" y="1475646"/>
            <a:ext cx="2284594" cy="2501543"/>
            <a:chOff x="3154469" y="5925059"/>
            <a:chExt cx="3006255" cy="3291731"/>
          </a:xfrm>
        </p:grpSpPr>
        <p:sp>
          <p:nvSpPr>
            <p:cNvPr id="37" name="フリーフォーム 36">
              <a:extLst>
                <a:ext uri="{FF2B5EF4-FFF2-40B4-BE49-F238E27FC236}">
                  <a16:creationId xmlns:a16="http://schemas.microsoft.com/office/drawing/2014/main" id="{478181C6-BF3F-E90A-F3A1-A9E70FE2E7A9}"/>
                </a:ext>
              </a:extLst>
            </p:cNvPr>
            <p:cNvSpPr/>
            <p:nvPr/>
          </p:nvSpPr>
          <p:spPr>
            <a:xfrm>
              <a:off x="3452328" y="8168401"/>
              <a:ext cx="1099646" cy="737059"/>
            </a:xfrm>
            <a:custGeom>
              <a:avLst/>
              <a:gdLst>
                <a:gd name="connsiteX0" fmla="*/ 526489 w 1224327"/>
                <a:gd name="connsiteY0" fmla="*/ 312990 h 830650"/>
                <a:gd name="connsiteX1" fmla="*/ 278011 w 1224327"/>
                <a:gd name="connsiteY1" fmla="*/ 183781 h 830650"/>
                <a:gd name="connsiteX2" fmla="*/ 69289 w 1224327"/>
                <a:gd name="connsiteY2" fmla="*/ 213598 h 830650"/>
                <a:gd name="connsiteX3" fmla="*/ 9654 w 1224327"/>
                <a:gd name="connsiteY3" fmla="*/ 462077 h 830650"/>
                <a:gd name="connsiteX4" fmla="*/ 248193 w 1224327"/>
                <a:gd name="connsiteY4" fmla="*/ 760251 h 830650"/>
                <a:gd name="connsiteX5" fmla="*/ 953872 w 1224327"/>
                <a:gd name="connsiteY5" fmla="*/ 809946 h 830650"/>
                <a:gd name="connsiteX6" fmla="*/ 1222228 w 1224327"/>
                <a:gd name="connsiteY6" fmla="*/ 481955 h 830650"/>
                <a:gd name="connsiteX7" fmla="*/ 1063202 w 1224327"/>
                <a:gd name="connsiteY7" fmla="*/ 14816 h 830650"/>
                <a:gd name="connsiteX8" fmla="*/ 784906 w 1224327"/>
                <a:gd name="connsiteY8" fmla="*/ 144025 h 830650"/>
                <a:gd name="connsiteX9" fmla="*/ 844541 w 1224327"/>
                <a:gd name="connsiteY9" fmla="*/ 422320 h 830650"/>
                <a:gd name="connsiteX10" fmla="*/ 576185 w 1224327"/>
                <a:gd name="connsiteY10" fmla="*/ 531651 h 830650"/>
                <a:gd name="connsiteX11" fmla="*/ 556306 w 1224327"/>
                <a:gd name="connsiteY11" fmla="*/ 362685 h 830650"/>
                <a:gd name="connsiteX12" fmla="*/ 526489 w 1224327"/>
                <a:gd name="connsiteY12" fmla="*/ 312990 h 8306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224327" h="830650">
                  <a:moveTo>
                    <a:pt x="526489" y="312990"/>
                  </a:moveTo>
                  <a:cubicBezTo>
                    <a:pt x="480107" y="283173"/>
                    <a:pt x="354211" y="200346"/>
                    <a:pt x="278011" y="183781"/>
                  </a:cubicBezTo>
                  <a:cubicBezTo>
                    <a:pt x="201811" y="167216"/>
                    <a:pt x="114015" y="167215"/>
                    <a:pt x="69289" y="213598"/>
                  </a:cubicBezTo>
                  <a:cubicBezTo>
                    <a:pt x="24563" y="259981"/>
                    <a:pt x="-20163" y="370968"/>
                    <a:pt x="9654" y="462077"/>
                  </a:cubicBezTo>
                  <a:cubicBezTo>
                    <a:pt x="39471" y="553186"/>
                    <a:pt x="90823" y="702273"/>
                    <a:pt x="248193" y="760251"/>
                  </a:cubicBezTo>
                  <a:cubicBezTo>
                    <a:pt x="405563" y="818229"/>
                    <a:pt x="791533" y="856329"/>
                    <a:pt x="953872" y="809946"/>
                  </a:cubicBezTo>
                  <a:cubicBezTo>
                    <a:pt x="1116211" y="763563"/>
                    <a:pt x="1204006" y="614477"/>
                    <a:pt x="1222228" y="481955"/>
                  </a:cubicBezTo>
                  <a:cubicBezTo>
                    <a:pt x="1240450" y="349433"/>
                    <a:pt x="1136089" y="71138"/>
                    <a:pt x="1063202" y="14816"/>
                  </a:cubicBezTo>
                  <a:cubicBezTo>
                    <a:pt x="990315" y="-41506"/>
                    <a:pt x="821349" y="76108"/>
                    <a:pt x="784906" y="144025"/>
                  </a:cubicBezTo>
                  <a:cubicBezTo>
                    <a:pt x="748463" y="211942"/>
                    <a:pt x="879328" y="357716"/>
                    <a:pt x="844541" y="422320"/>
                  </a:cubicBezTo>
                  <a:cubicBezTo>
                    <a:pt x="809754" y="486924"/>
                    <a:pt x="624224" y="541590"/>
                    <a:pt x="576185" y="531651"/>
                  </a:cubicBezTo>
                  <a:cubicBezTo>
                    <a:pt x="528146" y="521712"/>
                    <a:pt x="556306" y="362685"/>
                    <a:pt x="556306" y="362685"/>
                  </a:cubicBezTo>
                  <a:cubicBezTo>
                    <a:pt x="549680" y="327898"/>
                    <a:pt x="572871" y="342807"/>
                    <a:pt x="526489" y="312990"/>
                  </a:cubicBezTo>
                  <a:close/>
                </a:path>
              </a:pathLst>
            </a:cu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CN" altLang="en-US" dirty="0"/>
            </a:p>
          </p:txBody>
        </p:sp>
        <p:grpSp>
          <p:nvGrpSpPr>
            <p:cNvPr id="301" name="グループ化 300">
              <a:extLst>
                <a:ext uri="{FF2B5EF4-FFF2-40B4-BE49-F238E27FC236}">
                  <a16:creationId xmlns:a16="http://schemas.microsoft.com/office/drawing/2014/main" id="{99F43553-BFC2-1140-69C8-01A16E1B4AEE}"/>
                </a:ext>
              </a:extLst>
            </p:cNvPr>
            <p:cNvGrpSpPr/>
            <p:nvPr/>
          </p:nvGrpSpPr>
          <p:grpSpPr>
            <a:xfrm>
              <a:off x="3154469" y="5925059"/>
              <a:ext cx="1638622" cy="2876983"/>
              <a:chOff x="3290947" y="5925059"/>
              <a:chExt cx="1638622" cy="2876983"/>
            </a:xfrm>
          </p:grpSpPr>
          <p:grpSp>
            <p:nvGrpSpPr>
              <p:cNvPr id="55" name="グループ化 54">
                <a:extLst>
                  <a:ext uri="{FF2B5EF4-FFF2-40B4-BE49-F238E27FC236}">
                    <a16:creationId xmlns:a16="http://schemas.microsoft.com/office/drawing/2014/main" id="{9A0D6EF1-F001-88C3-E054-60DD850D388C}"/>
                  </a:ext>
                </a:extLst>
              </p:cNvPr>
              <p:cNvGrpSpPr/>
              <p:nvPr/>
            </p:nvGrpSpPr>
            <p:grpSpPr>
              <a:xfrm>
                <a:off x="3447140" y="5925059"/>
                <a:ext cx="1482429" cy="2426828"/>
                <a:chOff x="3807215" y="1058934"/>
                <a:chExt cx="1348422" cy="2207450"/>
              </a:xfrm>
            </p:grpSpPr>
            <p:sp>
              <p:nvSpPr>
                <p:cNvPr id="67" name="フリーフォーム 66">
                  <a:extLst>
                    <a:ext uri="{FF2B5EF4-FFF2-40B4-BE49-F238E27FC236}">
                      <a16:creationId xmlns:a16="http://schemas.microsoft.com/office/drawing/2014/main" id="{67688D73-5623-2A1F-5813-D53E164DD031}"/>
                    </a:ext>
                  </a:extLst>
                </p:cNvPr>
                <p:cNvSpPr/>
                <p:nvPr/>
              </p:nvSpPr>
              <p:spPr>
                <a:xfrm rot="21263862">
                  <a:off x="3807215" y="2090726"/>
                  <a:ext cx="1036959" cy="1175658"/>
                </a:xfrm>
                <a:custGeom>
                  <a:avLst/>
                  <a:gdLst>
                    <a:gd name="connsiteX0" fmla="*/ 548384 w 1083438"/>
                    <a:gd name="connsiteY0" fmla="*/ 1052454 h 1352588"/>
                    <a:gd name="connsiteX1" fmla="*/ 646355 w 1083438"/>
                    <a:gd name="connsiteY1" fmla="*/ 1030683 h 1352588"/>
                    <a:gd name="connsiteX2" fmla="*/ 689898 w 1083438"/>
                    <a:gd name="connsiteY2" fmla="*/ 910940 h 1352588"/>
                    <a:gd name="connsiteX3" fmla="*/ 689898 w 1083438"/>
                    <a:gd name="connsiteY3" fmla="*/ 769426 h 1352588"/>
                    <a:gd name="connsiteX4" fmla="*/ 722555 w 1083438"/>
                    <a:gd name="connsiteY4" fmla="*/ 617026 h 1352588"/>
                    <a:gd name="connsiteX5" fmla="*/ 755213 w 1083438"/>
                    <a:gd name="connsiteY5" fmla="*/ 551711 h 1352588"/>
                    <a:gd name="connsiteX6" fmla="*/ 874955 w 1083438"/>
                    <a:gd name="connsiteY6" fmla="*/ 529940 h 1352588"/>
                    <a:gd name="connsiteX7" fmla="*/ 1016470 w 1083438"/>
                    <a:gd name="connsiteY7" fmla="*/ 562597 h 1352588"/>
                    <a:gd name="connsiteX8" fmla="*/ 1081784 w 1083438"/>
                    <a:gd name="connsiteY8" fmla="*/ 682340 h 1352588"/>
                    <a:gd name="connsiteX9" fmla="*/ 1049127 w 1083438"/>
                    <a:gd name="connsiteY9" fmla="*/ 802083 h 1352588"/>
                    <a:gd name="connsiteX10" fmla="*/ 896727 w 1083438"/>
                    <a:gd name="connsiteY10" fmla="*/ 878283 h 1352588"/>
                    <a:gd name="connsiteX11" fmla="*/ 842298 w 1083438"/>
                    <a:gd name="connsiteY11" fmla="*/ 921826 h 1352588"/>
                    <a:gd name="connsiteX12" fmla="*/ 820527 w 1083438"/>
                    <a:gd name="connsiteY12" fmla="*/ 1074226 h 1352588"/>
                    <a:gd name="connsiteX13" fmla="*/ 787870 w 1083438"/>
                    <a:gd name="connsiteY13" fmla="*/ 1226626 h 1352588"/>
                    <a:gd name="connsiteX14" fmla="*/ 613698 w 1083438"/>
                    <a:gd name="connsiteY14" fmla="*/ 1346368 h 1352588"/>
                    <a:gd name="connsiteX15" fmla="*/ 395984 w 1083438"/>
                    <a:gd name="connsiteY15" fmla="*/ 1313711 h 1352588"/>
                    <a:gd name="connsiteX16" fmla="*/ 276241 w 1083438"/>
                    <a:gd name="connsiteY16" fmla="*/ 1128654 h 1352588"/>
                    <a:gd name="connsiteX17" fmla="*/ 308898 w 1083438"/>
                    <a:gd name="connsiteY17" fmla="*/ 910940 h 1352588"/>
                    <a:gd name="connsiteX18" fmla="*/ 406870 w 1083438"/>
                    <a:gd name="connsiteY18" fmla="*/ 704111 h 1352588"/>
                    <a:gd name="connsiteX19" fmla="*/ 287127 w 1083438"/>
                    <a:gd name="connsiteY19" fmla="*/ 486397 h 1352588"/>
                    <a:gd name="connsiteX20" fmla="*/ 80298 w 1083438"/>
                    <a:gd name="connsiteY20" fmla="*/ 301340 h 1352588"/>
                    <a:gd name="connsiteX21" fmla="*/ 4098 w 1083438"/>
                    <a:gd name="connsiteY21" fmla="*/ 138054 h 1352588"/>
                    <a:gd name="connsiteX22" fmla="*/ 25870 w 1083438"/>
                    <a:gd name="connsiteY22" fmla="*/ 29197 h 1352588"/>
                    <a:gd name="connsiteX23" fmla="*/ 156498 w 1083438"/>
                    <a:gd name="connsiteY23" fmla="*/ 7426 h 1352588"/>
                    <a:gd name="connsiteX24" fmla="*/ 352441 w 1083438"/>
                    <a:gd name="connsiteY24" fmla="*/ 138054 h 1352588"/>
                    <a:gd name="connsiteX25" fmla="*/ 537498 w 1083438"/>
                    <a:gd name="connsiteY25" fmla="*/ 410197 h 1352588"/>
                    <a:gd name="connsiteX26" fmla="*/ 570155 w 1083438"/>
                    <a:gd name="connsiteY26" fmla="*/ 562597 h 1352588"/>
                    <a:gd name="connsiteX27" fmla="*/ 570155 w 1083438"/>
                    <a:gd name="connsiteY27" fmla="*/ 758540 h 1352588"/>
                    <a:gd name="connsiteX28" fmla="*/ 504841 w 1083438"/>
                    <a:gd name="connsiteY28" fmla="*/ 965368 h 1352588"/>
                    <a:gd name="connsiteX29" fmla="*/ 548384 w 1083438"/>
                    <a:gd name="connsiteY29" fmla="*/ 1052454 h 13525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</a:cxnLst>
                  <a:rect l="l" t="t" r="r" b="b"/>
                  <a:pathLst>
                    <a:path w="1083438" h="1352588">
                      <a:moveTo>
                        <a:pt x="548384" y="1052454"/>
                      </a:moveTo>
                      <a:cubicBezTo>
                        <a:pt x="571970" y="1063340"/>
                        <a:pt x="622769" y="1054269"/>
                        <a:pt x="646355" y="1030683"/>
                      </a:cubicBezTo>
                      <a:cubicBezTo>
                        <a:pt x="669941" y="1007097"/>
                        <a:pt x="682641" y="954483"/>
                        <a:pt x="689898" y="910940"/>
                      </a:cubicBezTo>
                      <a:cubicBezTo>
                        <a:pt x="697155" y="867397"/>
                        <a:pt x="684455" y="818412"/>
                        <a:pt x="689898" y="769426"/>
                      </a:cubicBezTo>
                      <a:cubicBezTo>
                        <a:pt x="695341" y="720440"/>
                        <a:pt x="722555" y="617026"/>
                        <a:pt x="722555" y="617026"/>
                      </a:cubicBezTo>
                      <a:cubicBezTo>
                        <a:pt x="733441" y="580740"/>
                        <a:pt x="729813" y="566225"/>
                        <a:pt x="755213" y="551711"/>
                      </a:cubicBezTo>
                      <a:cubicBezTo>
                        <a:pt x="780613" y="537197"/>
                        <a:pt x="831412" y="528126"/>
                        <a:pt x="874955" y="529940"/>
                      </a:cubicBezTo>
                      <a:cubicBezTo>
                        <a:pt x="918498" y="531754"/>
                        <a:pt x="981999" y="537197"/>
                        <a:pt x="1016470" y="562597"/>
                      </a:cubicBezTo>
                      <a:cubicBezTo>
                        <a:pt x="1050941" y="587997"/>
                        <a:pt x="1076341" y="642426"/>
                        <a:pt x="1081784" y="682340"/>
                      </a:cubicBezTo>
                      <a:cubicBezTo>
                        <a:pt x="1087227" y="722254"/>
                        <a:pt x="1079970" y="769426"/>
                        <a:pt x="1049127" y="802083"/>
                      </a:cubicBezTo>
                      <a:cubicBezTo>
                        <a:pt x="1018284" y="834740"/>
                        <a:pt x="896727" y="878283"/>
                        <a:pt x="896727" y="878283"/>
                      </a:cubicBezTo>
                      <a:cubicBezTo>
                        <a:pt x="862256" y="898240"/>
                        <a:pt x="854998" y="889169"/>
                        <a:pt x="842298" y="921826"/>
                      </a:cubicBezTo>
                      <a:cubicBezTo>
                        <a:pt x="829598" y="954483"/>
                        <a:pt x="829598" y="1023426"/>
                        <a:pt x="820527" y="1074226"/>
                      </a:cubicBezTo>
                      <a:cubicBezTo>
                        <a:pt x="811456" y="1125026"/>
                        <a:pt x="822341" y="1181269"/>
                        <a:pt x="787870" y="1226626"/>
                      </a:cubicBezTo>
                      <a:cubicBezTo>
                        <a:pt x="753399" y="1271983"/>
                        <a:pt x="679012" y="1331854"/>
                        <a:pt x="613698" y="1346368"/>
                      </a:cubicBezTo>
                      <a:cubicBezTo>
                        <a:pt x="548384" y="1360882"/>
                        <a:pt x="452227" y="1349997"/>
                        <a:pt x="395984" y="1313711"/>
                      </a:cubicBezTo>
                      <a:cubicBezTo>
                        <a:pt x="339741" y="1277425"/>
                        <a:pt x="290755" y="1195782"/>
                        <a:pt x="276241" y="1128654"/>
                      </a:cubicBezTo>
                      <a:cubicBezTo>
                        <a:pt x="261727" y="1061526"/>
                        <a:pt x="287127" y="981697"/>
                        <a:pt x="308898" y="910940"/>
                      </a:cubicBezTo>
                      <a:cubicBezTo>
                        <a:pt x="330669" y="840183"/>
                        <a:pt x="410498" y="774868"/>
                        <a:pt x="406870" y="704111"/>
                      </a:cubicBezTo>
                      <a:cubicBezTo>
                        <a:pt x="403242" y="633354"/>
                        <a:pt x="341556" y="553525"/>
                        <a:pt x="287127" y="486397"/>
                      </a:cubicBezTo>
                      <a:cubicBezTo>
                        <a:pt x="232698" y="419269"/>
                        <a:pt x="127469" y="359397"/>
                        <a:pt x="80298" y="301340"/>
                      </a:cubicBezTo>
                      <a:cubicBezTo>
                        <a:pt x="33126" y="243283"/>
                        <a:pt x="13169" y="183411"/>
                        <a:pt x="4098" y="138054"/>
                      </a:cubicBezTo>
                      <a:cubicBezTo>
                        <a:pt x="-4973" y="92697"/>
                        <a:pt x="470" y="50968"/>
                        <a:pt x="25870" y="29197"/>
                      </a:cubicBezTo>
                      <a:cubicBezTo>
                        <a:pt x="51270" y="7426"/>
                        <a:pt x="102069" y="-10717"/>
                        <a:pt x="156498" y="7426"/>
                      </a:cubicBezTo>
                      <a:cubicBezTo>
                        <a:pt x="210926" y="25569"/>
                        <a:pt x="288941" y="70926"/>
                        <a:pt x="352441" y="138054"/>
                      </a:cubicBezTo>
                      <a:cubicBezTo>
                        <a:pt x="415941" y="205182"/>
                        <a:pt x="501212" y="339440"/>
                        <a:pt x="537498" y="410197"/>
                      </a:cubicBezTo>
                      <a:cubicBezTo>
                        <a:pt x="573784" y="480954"/>
                        <a:pt x="564712" y="504540"/>
                        <a:pt x="570155" y="562597"/>
                      </a:cubicBezTo>
                      <a:cubicBezTo>
                        <a:pt x="575598" y="620654"/>
                        <a:pt x="581041" y="691411"/>
                        <a:pt x="570155" y="758540"/>
                      </a:cubicBezTo>
                      <a:cubicBezTo>
                        <a:pt x="559269" y="825668"/>
                        <a:pt x="512098" y="918197"/>
                        <a:pt x="504841" y="965368"/>
                      </a:cubicBezTo>
                      <a:cubicBezTo>
                        <a:pt x="497584" y="1012539"/>
                        <a:pt x="524798" y="1041568"/>
                        <a:pt x="548384" y="1052454"/>
                      </a:cubicBez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 dirty="0">
                    <a:latin typeface="Helvetica" pitchFamily="2" charset="0"/>
                  </a:endParaRPr>
                </a:p>
              </p:txBody>
            </p:sp>
            <p:grpSp>
              <p:nvGrpSpPr>
                <p:cNvPr id="68" name="グループ化 67">
                  <a:extLst>
                    <a:ext uri="{FF2B5EF4-FFF2-40B4-BE49-F238E27FC236}">
                      <a16:creationId xmlns:a16="http://schemas.microsoft.com/office/drawing/2014/main" id="{B23D2D3F-10FB-E331-132F-0B638AFA0D5D}"/>
                    </a:ext>
                  </a:extLst>
                </p:cNvPr>
                <p:cNvGrpSpPr/>
                <p:nvPr/>
              </p:nvGrpSpPr>
              <p:grpSpPr>
                <a:xfrm rot="221016">
                  <a:off x="4017723" y="1245123"/>
                  <a:ext cx="499429" cy="992071"/>
                  <a:chOff x="2548152" y="853236"/>
                  <a:chExt cx="499429" cy="992071"/>
                </a:xfrm>
              </p:grpSpPr>
              <p:grpSp>
                <p:nvGrpSpPr>
                  <p:cNvPr id="122" name="グループ化 121">
                    <a:extLst>
                      <a:ext uri="{FF2B5EF4-FFF2-40B4-BE49-F238E27FC236}">
                        <a16:creationId xmlns:a16="http://schemas.microsoft.com/office/drawing/2014/main" id="{DF280949-9EB3-7F33-30B8-415A80E12437}"/>
                      </a:ext>
                    </a:extLst>
                  </p:cNvPr>
                  <p:cNvGrpSpPr/>
                  <p:nvPr/>
                </p:nvGrpSpPr>
                <p:grpSpPr>
                  <a:xfrm>
                    <a:off x="2595132" y="853236"/>
                    <a:ext cx="425746" cy="498593"/>
                    <a:chOff x="2595132" y="853236"/>
                    <a:chExt cx="425746" cy="498593"/>
                  </a:xfrm>
                </p:grpSpPr>
                <p:grpSp>
                  <p:nvGrpSpPr>
                    <p:cNvPr id="146" name="グループ化 145">
                      <a:extLst>
                        <a:ext uri="{FF2B5EF4-FFF2-40B4-BE49-F238E27FC236}">
                          <a16:creationId xmlns:a16="http://schemas.microsoft.com/office/drawing/2014/main" id="{C70FB682-C0BB-6183-8C69-25455B85AD3D}"/>
                        </a:ext>
                      </a:extLst>
                    </p:cNvPr>
                    <p:cNvGrpSpPr/>
                    <p:nvPr/>
                  </p:nvGrpSpPr>
                  <p:grpSpPr>
                    <a:xfrm rot="20918512">
                      <a:off x="2694936" y="853236"/>
                      <a:ext cx="325942" cy="149594"/>
                      <a:chOff x="2338703" y="527862"/>
                      <a:chExt cx="325942" cy="149594"/>
                    </a:xfrm>
                  </p:grpSpPr>
                  <p:grpSp>
                    <p:nvGrpSpPr>
                      <p:cNvPr id="158" name="グループ化 157">
                        <a:extLst>
                          <a:ext uri="{FF2B5EF4-FFF2-40B4-BE49-F238E27FC236}">
                            <a16:creationId xmlns:a16="http://schemas.microsoft.com/office/drawing/2014/main" id="{DF17E1DF-2883-3985-CD84-59CC2FD12F2A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703" y="562564"/>
                        <a:ext cx="214128" cy="114892"/>
                        <a:chOff x="2907756" y="776944"/>
                        <a:chExt cx="199382" cy="108230"/>
                      </a:xfrm>
                    </p:grpSpPr>
                    <p:grpSp>
                      <p:nvGrpSpPr>
                        <p:cNvPr id="162" name="グループ化 161">
                          <a:extLst>
                            <a:ext uri="{FF2B5EF4-FFF2-40B4-BE49-F238E27FC236}">
                              <a16:creationId xmlns:a16="http://schemas.microsoft.com/office/drawing/2014/main" id="{B1D993A0-710E-C193-CB41-D1B86518BF0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166" name="曲線コネクタ 165">
                            <a:extLst>
                              <a:ext uri="{FF2B5EF4-FFF2-40B4-BE49-F238E27FC236}">
                                <a16:creationId xmlns:a16="http://schemas.microsoft.com/office/drawing/2014/main" id="{1D66E4FD-CAFA-A72E-9B03-8DDDB8A161F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7" name="曲線コネクタ 166">
                            <a:extLst>
                              <a:ext uri="{FF2B5EF4-FFF2-40B4-BE49-F238E27FC236}">
                                <a16:creationId xmlns:a16="http://schemas.microsoft.com/office/drawing/2014/main" id="{DD42B49E-77FB-33C0-450A-FF53B9D7130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63" name="グループ化 162">
                          <a:extLst>
                            <a:ext uri="{FF2B5EF4-FFF2-40B4-BE49-F238E27FC236}">
                              <a16:creationId xmlns:a16="http://schemas.microsoft.com/office/drawing/2014/main" id="{FBC06052-9B85-EFF7-51CD-5DF053DFE23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0023" y="776944"/>
                          <a:ext cx="117115" cy="60447"/>
                          <a:chOff x="3014737" y="791772"/>
                          <a:chExt cx="117115" cy="60447"/>
                        </a:xfrm>
                      </p:grpSpPr>
                      <p:cxnSp>
                        <p:nvCxnSpPr>
                          <p:cNvPr id="164" name="曲線コネクタ 163">
                            <a:extLst>
                              <a:ext uri="{FF2B5EF4-FFF2-40B4-BE49-F238E27FC236}">
                                <a16:creationId xmlns:a16="http://schemas.microsoft.com/office/drawing/2014/main" id="{81D40918-A738-BCED-AA63-149CCF5147D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5" name="曲線コネクタ 164">
                            <a:extLst>
                              <a:ext uri="{FF2B5EF4-FFF2-40B4-BE49-F238E27FC236}">
                                <a16:creationId xmlns:a16="http://schemas.microsoft.com/office/drawing/2014/main" id="{62E6999B-EDEB-83A0-7F91-C3A2AC3F12D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4737" y="791772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59" name="グループ化 158">
                        <a:extLst>
                          <a:ext uri="{FF2B5EF4-FFF2-40B4-BE49-F238E27FC236}">
                            <a16:creationId xmlns:a16="http://schemas.microsoft.com/office/drawing/2014/main" id="{2690D919-0B15-B7AF-F501-441AF3B1A894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160" name="曲線コネクタ 159">
                          <a:extLst>
                            <a:ext uri="{FF2B5EF4-FFF2-40B4-BE49-F238E27FC236}">
                              <a16:creationId xmlns:a16="http://schemas.microsoft.com/office/drawing/2014/main" id="{EADCC4E4-4501-61AC-E072-31174BC46F9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61" name="曲線コネクタ 160">
                          <a:extLst>
                            <a:ext uri="{FF2B5EF4-FFF2-40B4-BE49-F238E27FC236}">
                              <a16:creationId xmlns:a16="http://schemas.microsoft.com/office/drawing/2014/main" id="{E6529B25-8DAC-F7A5-9E87-F2B014DEB32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47" name="グループ化 146">
                      <a:extLst>
                        <a:ext uri="{FF2B5EF4-FFF2-40B4-BE49-F238E27FC236}">
                          <a16:creationId xmlns:a16="http://schemas.microsoft.com/office/drawing/2014/main" id="{2C517D02-6D3D-73CE-884E-23B96F33E9AC}"/>
                        </a:ext>
                      </a:extLst>
                    </p:cNvPr>
                    <p:cNvGrpSpPr/>
                    <p:nvPr/>
                  </p:nvGrpSpPr>
                  <p:grpSpPr>
                    <a:xfrm rot="15812476" flipH="1">
                      <a:off x="2506959" y="1114056"/>
                      <a:ext cx="325946" cy="149599"/>
                      <a:chOff x="2338699" y="527862"/>
                      <a:chExt cx="325946" cy="149599"/>
                    </a:xfrm>
                  </p:grpSpPr>
                  <p:grpSp>
                    <p:nvGrpSpPr>
                      <p:cNvPr id="148" name="グループ化 147">
                        <a:extLst>
                          <a:ext uri="{FF2B5EF4-FFF2-40B4-BE49-F238E27FC236}">
                            <a16:creationId xmlns:a16="http://schemas.microsoft.com/office/drawing/2014/main" id="{7FF7A9C9-EA3B-4290-FA74-836FB818197A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699" y="562852"/>
                        <a:ext cx="214216" cy="114609"/>
                        <a:chOff x="2907756" y="777212"/>
                        <a:chExt cx="199464" cy="107963"/>
                      </a:xfrm>
                    </p:grpSpPr>
                    <p:grpSp>
                      <p:nvGrpSpPr>
                        <p:cNvPr id="152" name="グループ化 151">
                          <a:extLst>
                            <a:ext uri="{FF2B5EF4-FFF2-40B4-BE49-F238E27FC236}">
                              <a16:creationId xmlns:a16="http://schemas.microsoft.com/office/drawing/2014/main" id="{D1B92AEE-64F9-7939-1C8C-BC6CBBF16BA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2" cy="60116"/>
                          <a:chOff x="2907756" y="825059"/>
                          <a:chExt cx="115852" cy="60116"/>
                        </a:xfrm>
                      </p:grpSpPr>
                      <p:cxnSp>
                        <p:nvCxnSpPr>
                          <p:cNvPr id="156" name="曲線コネクタ 155">
                            <a:extLst>
                              <a:ext uri="{FF2B5EF4-FFF2-40B4-BE49-F238E27FC236}">
                                <a16:creationId xmlns:a16="http://schemas.microsoft.com/office/drawing/2014/main" id="{7B6862A5-2C17-51CB-3127-1B3ADCA99AA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7" name="曲線コネクタ 156">
                            <a:extLst>
                              <a:ext uri="{FF2B5EF4-FFF2-40B4-BE49-F238E27FC236}">
                                <a16:creationId xmlns:a16="http://schemas.microsoft.com/office/drawing/2014/main" id="{7BED3C8D-949E-83B2-E96F-AE3B35F8B5D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0" y="825446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53" name="グループ化 152">
                          <a:extLst>
                            <a:ext uri="{FF2B5EF4-FFF2-40B4-BE49-F238E27FC236}">
                              <a16:creationId xmlns:a16="http://schemas.microsoft.com/office/drawing/2014/main" id="{9AC3F6D2-8A37-AFFA-A69D-AA210CA1303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7212"/>
                          <a:ext cx="114340" cy="60179"/>
                          <a:chOff x="3017594" y="792040"/>
                          <a:chExt cx="114340" cy="60179"/>
                        </a:xfrm>
                      </p:grpSpPr>
                      <p:cxnSp>
                        <p:nvCxnSpPr>
                          <p:cNvPr id="154" name="曲線コネクタ 153">
                            <a:extLst>
                              <a:ext uri="{FF2B5EF4-FFF2-40B4-BE49-F238E27FC236}">
                                <a16:creationId xmlns:a16="http://schemas.microsoft.com/office/drawing/2014/main" id="{26AC7F71-A930-4B24-1FA8-94703E093F6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7676" y="79204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5" name="曲線コネクタ 154">
                            <a:extLst>
                              <a:ext uri="{FF2B5EF4-FFF2-40B4-BE49-F238E27FC236}">
                                <a16:creationId xmlns:a16="http://schemas.microsoft.com/office/drawing/2014/main" id="{3411641C-FEB1-9FEE-0611-6D65446EBD5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49" name="グループ化 148">
                        <a:extLst>
                          <a:ext uri="{FF2B5EF4-FFF2-40B4-BE49-F238E27FC236}">
                            <a16:creationId xmlns:a16="http://schemas.microsoft.com/office/drawing/2014/main" id="{FABB00C8-AE79-258E-12A7-766EA60D16D3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150" name="曲線コネクタ 149">
                          <a:extLst>
                            <a:ext uri="{FF2B5EF4-FFF2-40B4-BE49-F238E27FC236}">
                              <a16:creationId xmlns:a16="http://schemas.microsoft.com/office/drawing/2014/main" id="{E6622191-59AE-F78B-9287-ECFFC457F51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51" name="曲線コネクタ 150">
                          <a:extLst>
                            <a:ext uri="{FF2B5EF4-FFF2-40B4-BE49-F238E27FC236}">
                              <a16:creationId xmlns:a16="http://schemas.microsoft.com/office/drawing/2014/main" id="{8DB28B50-3DF9-3EF0-A5AD-6A1DFF77641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  <p:grpSp>
                <p:nvGrpSpPr>
                  <p:cNvPr id="123" name="グループ化 122">
                    <a:extLst>
                      <a:ext uri="{FF2B5EF4-FFF2-40B4-BE49-F238E27FC236}">
                        <a16:creationId xmlns:a16="http://schemas.microsoft.com/office/drawing/2014/main" id="{377B0446-5070-A2CF-CA5C-B15193457A0A}"/>
                      </a:ext>
                    </a:extLst>
                  </p:cNvPr>
                  <p:cNvGrpSpPr/>
                  <p:nvPr/>
                </p:nvGrpSpPr>
                <p:grpSpPr>
                  <a:xfrm rot="17579374">
                    <a:off x="2583369" y="1381095"/>
                    <a:ext cx="428995" cy="499429"/>
                    <a:chOff x="2595132" y="852400"/>
                    <a:chExt cx="428995" cy="499429"/>
                  </a:xfrm>
                </p:grpSpPr>
                <p:grpSp>
                  <p:nvGrpSpPr>
                    <p:cNvPr id="124" name="グループ化 123">
                      <a:extLst>
                        <a:ext uri="{FF2B5EF4-FFF2-40B4-BE49-F238E27FC236}">
                          <a16:creationId xmlns:a16="http://schemas.microsoft.com/office/drawing/2014/main" id="{F7670AC5-9CEE-9139-6D72-17FB15896699}"/>
                        </a:ext>
                      </a:extLst>
                    </p:cNvPr>
                    <p:cNvGrpSpPr/>
                    <p:nvPr/>
                  </p:nvGrpSpPr>
                  <p:grpSpPr>
                    <a:xfrm rot="20918512">
                      <a:off x="2694883" y="852400"/>
                      <a:ext cx="329244" cy="150117"/>
                      <a:chOff x="2338732" y="527352"/>
                      <a:chExt cx="329244" cy="150117"/>
                    </a:xfrm>
                  </p:grpSpPr>
                  <p:grpSp>
                    <p:nvGrpSpPr>
                      <p:cNvPr id="136" name="グループ化 135">
                        <a:extLst>
                          <a:ext uri="{FF2B5EF4-FFF2-40B4-BE49-F238E27FC236}">
                            <a16:creationId xmlns:a16="http://schemas.microsoft.com/office/drawing/2014/main" id="{EE80BB6E-6E87-F428-27D6-8897AF7BDF00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732" y="559770"/>
                        <a:ext cx="215075" cy="117699"/>
                        <a:chOff x="2907756" y="774300"/>
                        <a:chExt cx="200264" cy="110874"/>
                      </a:xfrm>
                    </p:grpSpPr>
                    <p:grpSp>
                      <p:nvGrpSpPr>
                        <p:cNvPr id="140" name="グループ化 139">
                          <a:extLst>
                            <a:ext uri="{FF2B5EF4-FFF2-40B4-BE49-F238E27FC236}">
                              <a16:creationId xmlns:a16="http://schemas.microsoft.com/office/drawing/2014/main" id="{1C3337CB-0E03-B9F4-ED73-88C77740E2B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144" name="曲線コネクタ 143">
                            <a:extLst>
                              <a:ext uri="{FF2B5EF4-FFF2-40B4-BE49-F238E27FC236}">
                                <a16:creationId xmlns:a16="http://schemas.microsoft.com/office/drawing/2014/main" id="{F4FC8A87-577D-97C8-1E84-E6F7A50A21A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45" name="曲線コネクタ 144">
                            <a:extLst>
                              <a:ext uri="{FF2B5EF4-FFF2-40B4-BE49-F238E27FC236}">
                                <a16:creationId xmlns:a16="http://schemas.microsoft.com/office/drawing/2014/main" id="{9CEAE171-FF4E-9C34-991F-D0F7E54AA29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41" name="グループ化 140">
                          <a:extLst>
                            <a:ext uri="{FF2B5EF4-FFF2-40B4-BE49-F238E27FC236}">
                              <a16:creationId xmlns:a16="http://schemas.microsoft.com/office/drawing/2014/main" id="{7DEA6D73-F483-BAEE-84AF-E9F741CD22E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4300"/>
                          <a:ext cx="115140" cy="63091"/>
                          <a:chOff x="3017594" y="789128"/>
                          <a:chExt cx="115140" cy="63091"/>
                        </a:xfrm>
                      </p:grpSpPr>
                      <p:cxnSp>
                        <p:nvCxnSpPr>
                          <p:cNvPr id="142" name="曲線コネクタ 141">
                            <a:extLst>
                              <a:ext uri="{FF2B5EF4-FFF2-40B4-BE49-F238E27FC236}">
                                <a16:creationId xmlns:a16="http://schemas.microsoft.com/office/drawing/2014/main" id="{C2207C30-E9CF-A3DA-3144-BC4708B371F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43" name="曲線コネクタ 142">
                            <a:extLst>
                              <a:ext uri="{FF2B5EF4-FFF2-40B4-BE49-F238E27FC236}">
                                <a16:creationId xmlns:a16="http://schemas.microsoft.com/office/drawing/2014/main" id="{22BD3C15-4791-089B-E9D2-522D15A7E54F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8476" y="789128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37" name="グループ化 136">
                        <a:extLst>
                          <a:ext uri="{FF2B5EF4-FFF2-40B4-BE49-F238E27FC236}">
                            <a16:creationId xmlns:a16="http://schemas.microsoft.com/office/drawing/2014/main" id="{AE1D5CF0-84A8-C75E-83F4-4421C1344978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89" y="527352"/>
                        <a:ext cx="127687" cy="64152"/>
                        <a:chOff x="2907756" y="824356"/>
                        <a:chExt cx="118893" cy="60432"/>
                      </a:xfrm>
                    </p:grpSpPr>
                    <p:cxnSp>
                      <p:nvCxnSpPr>
                        <p:cNvPr id="138" name="曲線コネクタ 137">
                          <a:extLst>
                            <a:ext uri="{FF2B5EF4-FFF2-40B4-BE49-F238E27FC236}">
                              <a16:creationId xmlns:a16="http://schemas.microsoft.com/office/drawing/2014/main" id="{5920DB55-A53A-41DA-C343-2862EB35E08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12391" y="824356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39" name="曲線コネクタ 138">
                          <a:extLst>
                            <a:ext uri="{FF2B5EF4-FFF2-40B4-BE49-F238E27FC236}">
                              <a16:creationId xmlns:a16="http://schemas.microsoft.com/office/drawing/2014/main" id="{6E042980-898E-3D59-0F71-AB82C1FC90F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25" name="グループ化 124">
                      <a:extLst>
                        <a:ext uri="{FF2B5EF4-FFF2-40B4-BE49-F238E27FC236}">
                          <a16:creationId xmlns:a16="http://schemas.microsoft.com/office/drawing/2014/main" id="{F4C07E45-33D4-414F-5F4E-99914B3B4FC9}"/>
                        </a:ext>
                      </a:extLst>
                    </p:cNvPr>
                    <p:cNvGrpSpPr/>
                    <p:nvPr/>
                  </p:nvGrpSpPr>
                  <p:grpSpPr>
                    <a:xfrm rot="15812476" flipH="1">
                      <a:off x="2506959" y="1114056"/>
                      <a:ext cx="325946" cy="149599"/>
                      <a:chOff x="2338699" y="527862"/>
                      <a:chExt cx="325946" cy="149599"/>
                    </a:xfrm>
                  </p:grpSpPr>
                  <p:grpSp>
                    <p:nvGrpSpPr>
                      <p:cNvPr id="126" name="グループ化 125">
                        <a:extLst>
                          <a:ext uri="{FF2B5EF4-FFF2-40B4-BE49-F238E27FC236}">
                            <a16:creationId xmlns:a16="http://schemas.microsoft.com/office/drawing/2014/main" id="{A55D8E2D-35B6-3FBF-6409-212CCBD4281F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699" y="562853"/>
                        <a:ext cx="214216" cy="114608"/>
                        <a:chOff x="2907756" y="777212"/>
                        <a:chExt cx="199464" cy="107962"/>
                      </a:xfrm>
                    </p:grpSpPr>
                    <p:grpSp>
                      <p:nvGrpSpPr>
                        <p:cNvPr id="130" name="グループ化 129">
                          <a:extLst>
                            <a:ext uri="{FF2B5EF4-FFF2-40B4-BE49-F238E27FC236}">
                              <a16:creationId xmlns:a16="http://schemas.microsoft.com/office/drawing/2014/main" id="{3F2F5198-CFAA-3E3F-256B-3310B0D2387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134" name="曲線コネクタ 133">
                            <a:extLst>
                              <a:ext uri="{FF2B5EF4-FFF2-40B4-BE49-F238E27FC236}">
                                <a16:creationId xmlns:a16="http://schemas.microsoft.com/office/drawing/2014/main" id="{E94BC17C-9134-E7A4-9748-28B9B84502D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5" name="曲線コネクタ 134">
                            <a:extLst>
                              <a:ext uri="{FF2B5EF4-FFF2-40B4-BE49-F238E27FC236}">
                                <a16:creationId xmlns:a16="http://schemas.microsoft.com/office/drawing/2014/main" id="{8BF80A92-2006-4F68-221E-439964233E3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31" name="グループ化 130">
                          <a:extLst>
                            <a:ext uri="{FF2B5EF4-FFF2-40B4-BE49-F238E27FC236}">
                              <a16:creationId xmlns:a16="http://schemas.microsoft.com/office/drawing/2014/main" id="{813B5184-473D-E0E3-BC15-EABEB20C2B3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7212"/>
                          <a:ext cx="114340" cy="60179"/>
                          <a:chOff x="3017594" y="792040"/>
                          <a:chExt cx="114340" cy="60179"/>
                        </a:xfrm>
                      </p:grpSpPr>
                      <p:cxnSp>
                        <p:nvCxnSpPr>
                          <p:cNvPr id="132" name="曲線コネクタ 131">
                            <a:extLst>
                              <a:ext uri="{FF2B5EF4-FFF2-40B4-BE49-F238E27FC236}">
                                <a16:creationId xmlns:a16="http://schemas.microsoft.com/office/drawing/2014/main" id="{6012C7D4-B2F6-55ED-DECB-065A9021C80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7676" y="79204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3" name="曲線コネクタ 132">
                            <a:extLst>
                              <a:ext uri="{FF2B5EF4-FFF2-40B4-BE49-F238E27FC236}">
                                <a16:creationId xmlns:a16="http://schemas.microsoft.com/office/drawing/2014/main" id="{F2A62E2B-161A-E0DC-2287-F69035E4C2B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4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27" name="グループ化 126">
                        <a:extLst>
                          <a:ext uri="{FF2B5EF4-FFF2-40B4-BE49-F238E27FC236}">
                            <a16:creationId xmlns:a16="http://schemas.microsoft.com/office/drawing/2014/main" id="{DAE38A76-1BE8-C663-5234-47317E6887FB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128" name="曲線コネクタ 127">
                          <a:extLst>
                            <a:ext uri="{FF2B5EF4-FFF2-40B4-BE49-F238E27FC236}">
                              <a16:creationId xmlns:a16="http://schemas.microsoft.com/office/drawing/2014/main" id="{849A5E6B-00BF-4332-D2CA-4E036978F81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>
                              <a:lumMod val="40000"/>
                              <a:lumOff val="6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9" name="曲線コネクタ 128">
                          <a:extLst>
                            <a:ext uri="{FF2B5EF4-FFF2-40B4-BE49-F238E27FC236}">
                              <a16:creationId xmlns:a16="http://schemas.microsoft.com/office/drawing/2014/main" id="{59AB72EA-A2CB-3D9E-0B4B-A734B5FD3FD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4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</p:grpSp>
            <p:grpSp>
              <p:nvGrpSpPr>
                <p:cNvPr id="69" name="グループ化 68">
                  <a:extLst>
                    <a:ext uri="{FF2B5EF4-FFF2-40B4-BE49-F238E27FC236}">
                      <a16:creationId xmlns:a16="http://schemas.microsoft.com/office/drawing/2014/main" id="{DDB5D290-3A7F-152B-05A0-503DE664FE39}"/>
                    </a:ext>
                  </a:extLst>
                </p:cNvPr>
                <p:cNvGrpSpPr/>
                <p:nvPr/>
              </p:nvGrpSpPr>
              <p:grpSpPr>
                <a:xfrm flipH="1">
                  <a:off x="4656208" y="1281244"/>
                  <a:ext cx="499429" cy="992071"/>
                  <a:chOff x="2548152" y="853236"/>
                  <a:chExt cx="499429" cy="992071"/>
                </a:xfrm>
              </p:grpSpPr>
              <p:grpSp>
                <p:nvGrpSpPr>
                  <p:cNvPr id="76" name="グループ化 75">
                    <a:extLst>
                      <a:ext uri="{FF2B5EF4-FFF2-40B4-BE49-F238E27FC236}">
                        <a16:creationId xmlns:a16="http://schemas.microsoft.com/office/drawing/2014/main" id="{05B6DB96-BA18-6C83-E175-3DA8B54AEC8E}"/>
                      </a:ext>
                    </a:extLst>
                  </p:cNvPr>
                  <p:cNvGrpSpPr/>
                  <p:nvPr/>
                </p:nvGrpSpPr>
                <p:grpSpPr>
                  <a:xfrm>
                    <a:off x="2595132" y="853236"/>
                    <a:ext cx="425746" cy="498593"/>
                    <a:chOff x="2595132" y="853236"/>
                    <a:chExt cx="425746" cy="498593"/>
                  </a:xfrm>
                </p:grpSpPr>
                <p:grpSp>
                  <p:nvGrpSpPr>
                    <p:cNvPr id="100" name="グループ化 99">
                      <a:extLst>
                        <a:ext uri="{FF2B5EF4-FFF2-40B4-BE49-F238E27FC236}">
                          <a16:creationId xmlns:a16="http://schemas.microsoft.com/office/drawing/2014/main" id="{83669E07-14EC-4369-0F84-BB5D44BC0083}"/>
                        </a:ext>
                      </a:extLst>
                    </p:cNvPr>
                    <p:cNvGrpSpPr/>
                    <p:nvPr/>
                  </p:nvGrpSpPr>
                  <p:grpSpPr>
                    <a:xfrm rot="20918512">
                      <a:off x="2694936" y="853236"/>
                      <a:ext cx="325942" cy="149594"/>
                      <a:chOff x="2338703" y="527862"/>
                      <a:chExt cx="325942" cy="149594"/>
                    </a:xfrm>
                  </p:grpSpPr>
                  <p:grpSp>
                    <p:nvGrpSpPr>
                      <p:cNvPr id="112" name="グループ化 111">
                        <a:extLst>
                          <a:ext uri="{FF2B5EF4-FFF2-40B4-BE49-F238E27FC236}">
                            <a16:creationId xmlns:a16="http://schemas.microsoft.com/office/drawing/2014/main" id="{B6B78492-EB4B-5A8D-46E6-0A175AD9A665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703" y="562564"/>
                        <a:ext cx="214128" cy="114892"/>
                        <a:chOff x="2907756" y="776944"/>
                        <a:chExt cx="199382" cy="108230"/>
                      </a:xfrm>
                    </p:grpSpPr>
                    <p:grpSp>
                      <p:nvGrpSpPr>
                        <p:cNvPr id="116" name="グループ化 115">
                          <a:extLst>
                            <a:ext uri="{FF2B5EF4-FFF2-40B4-BE49-F238E27FC236}">
                              <a16:creationId xmlns:a16="http://schemas.microsoft.com/office/drawing/2014/main" id="{4B3CEE94-29A4-6682-6861-5A2711E07D2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120" name="曲線コネクタ 119">
                            <a:extLst>
                              <a:ext uri="{FF2B5EF4-FFF2-40B4-BE49-F238E27FC236}">
                                <a16:creationId xmlns:a16="http://schemas.microsoft.com/office/drawing/2014/main" id="{494BD0F0-7B41-A92E-8A43-102E8761A95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21" name="曲線コネクタ 120">
                            <a:extLst>
                              <a:ext uri="{FF2B5EF4-FFF2-40B4-BE49-F238E27FC236}">
                                <a16:creationId xmlns:a16="http://schemas.microsoft.com/office/drawing/2014/main" id="{F5207582-C7E4-BBAD-1644-116F80CA5922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17" name="グループ化 116">
                          <a:extLst>
                            <a:ext uri="{FF2B5EF4-FFF2-40B4-BE49-F238E27FC236}">
                              <a16:creationId xmlns:a16="http://schemas.microsoft.com/office/drawing/2014/main" id="{91DD2573-E64C-4E7F-E953-8DC27B30D0E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0023" y="776944"/>
                          <a:ext cx="117115" cy="60447"/>
                          <a:chOff x="3014737" y="791772"/>
                          <a:chExt cx="117115" cy="60447"/>
                        </a:xfrm>
                      </p:grpSpPr>
                      <p:cxnSp>
                        <p:nvCxnSpPr>
                          <p:cNvPr id="118" name="曲線コネクタ 117">
                            <a:extLst>
                              <a:ext uri="{FF2B5EF4-FFF2-40B4-BE49-F238E27FC236}">
                                <a16:creationId xmlns:a16="http://schemas.microsoft.com/office/drawing/2014/main" id="{C6F3AEBC-9EA3-ECD7-CB3E-366DC3FC2D2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19" name="曲線コネクタ 118">
                            <a:extLst>
                              <a:ext uri="{FF2B5EF4-FFF2-40B4-BE49-F238E27FC236}">
                                <a16:creationId xmlns:a16="http://schemas.microsoft.com/office/drawing/2014/main" id="{4BA18617-BA9D-41F6-803F-FA018AAF030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4737" y="791772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13" name="グループ化 112">
                        <a:extLst>
                          <a:ext uri="{FF2B5EF4-FFF2-40B4-BE49-F238E27FC236}">
                            <a16:creationId xmlns:a16="http://schemas.microsoft.com/office/drawing/2014/main" id="{3DC43B48-E654-203B-E6FB-48F2E1A59A3A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114" name="曲線コネクタ 113">
                          <a:extLst>
                            <a:ext uri="{FF2B5EF4-FFF2-40B4-BE49-F238E27FC236}">
                              <a16:creationId xmlns:a16="http://schemas.microsoft.com/office/drawing/2014/main" id="{98D297B0-E1A9-3B48-9B1D-D1DB597E7C5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15" name="曲線コネクタ 114">
                          <a:extLst>
                            <a:ext uri="{FF2B5EF4-FFF2-40B4-BE49-F238E27FC236}">
                              <a16:creationId xmlns:a16="http://schemas.microsoft.com/office/drawing/2014/main" id="{4CC7F44B-6D66-339D-2079-711253E5ED0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01" name="グループ化 100">
                      <a:extLst>
                        <a:ext uri="{FF2B5EF4-FFF2-40B4-BE49-F238E27FC236}">
                          <a16:creationId xmlns:a16="http://schemas.microsoft.com/office/drawing/2014/main" id="{C4625739-CD1F-2A2C-8EE8-1A7C8B4FB38F}"/>
                        </a:ext>
                      </a:extLst>
                    </p:cNvPr>
                    <p:cNvGrpSpPr/>
                    <p:nvPr/>
                  </p:nvGrpSpPr>
                  <p:grpSpPr>
                    <a:xfrm rot="15812476" flipH="1">
                      <a:off x="2506959" y="1114056"/>
                      <a:ext cx="325946" cy="149599"/>
                      <a:chOff x="2338699" y="527862"/>
                      <a:chExt cx="325946" cy="149599"/>
                    </a:xfrm>
                  </p:grpSpPr>
                  <p:grpSp>
                    <p:nvGrpSpPr>
                      <p:cNvPr id="102" name="グループ化 101">
                        <a:extLst>
                          <a:ext uri="{FF2B5EF4-FFF2-40B4-BE49-F238E27FC236}">
                            <a16:creationId xmlns:a16="http://schemas.microsoft.com/office/drawing/2014/main" id="{A8153F40-A0FB-64EB-90F5-502DC480338A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699" y="562852"/>
                        <a:ext cx="214216" cy="114609"/>
                        <a:chOff x="2907756" y="777212"/>
                        <a:chExt cx="199464" cy="107963"/>
                      </a:xfrm>
                    </p:grpSpPr>
                    <p:grpSp>
                      <p:nvGrpSpPr>
                        <p:cNvPr id="106" name="グループ化 105">
                          <a:extLst>
                            <a:ext uri="{FF2B5EF4-FFF2-40B4-BE49-F238E27FC236}">
                              <a16:creationId xmlns:a16="http://schemas.microsoft.com/office/drawing/2014/main" id="{C130D697-C357-94A8-E8C2-F9AE5CA5E14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2" cy="60116"/>
                          <a:chOff x="2907756" y="825059"/>
                          <a:chExt cx="115852" cy="60116"/>
                        </a:xfrm>
                      </p:grpSpPr>
                      <p:cxnSp>
                        <p:nvCxnSpPr>
                          <p:cNvPr id="110" name="曲線コネクタ 109">
                            <a:extLst>
                              <a:ext uri="{FF2B5EF4-FFF2-40B4-BE49-F238E27FC236}">
                                <a16:creationId xmlns:a16="http://schemas.microsoft.com/office/drawing/2014/main" id="{741E7DB4-03FD-25FE-5253-1CD0EE13EFA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11" name="曲線コネクタ 110">
                            <a:extLst>
                              <a:ext uri="{FF2B5EF4-FFF2-40B4-BE49-F238E27FC236}">
                                <a16:creationId xmlns:a16="http://schemas.microsoft.com/office/drawing/2014/main" id="{C4545985-650C-0AAE-7A3C-02F6F316403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0" y="825446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107" name="グループ化 106">
                          <a:extLst>
                            <a:ext uri="{FF2B5EF4-FFF2-40B4-BE49-F238E27FC236}">
                              <a16:creationId xmlns:a16="http://schemas.microsoft.com/office/drawing/2014/main" id="{690764A6-5EA5-4A94-0188-2BE4DE8D7FF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7212"/>
                          <a:ext cx="114340" cy="60179"/>
                          <a:chOff x="3017594" y="792040"/>
                          <a:chExt cx="114340" cy="60179"/>
                        </a:xfrm>
                      </p:grpSpPr>
                      <p:cxnSp>
                        <p:nvCxnSpPr>
                          <p:cNvPr id="108" name="曲線コネクタ 107">
                            <a:extLst>
                              <a:ext uri="{FF2B5EF4-FFF2-40B4-BE49-F238E27FC236}">
                                <a16:creationId xmlns:a16="http://schemas.microsoft.com/office/drawing/2014/main" id="{EF6E93FB-BAFB-5E27-52F9-45F326D43EF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7676" y="79204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09" name="曲線コネクタ 108">
                            <a:extLst>
                              <a:ext uri="{FF2B5EF4-FFF2-40B4-BE49-F238E27FC236}">
                                <a16:creationId xmlns:a16="http://schemas.microsoft.com/office/drawing/2014/main" id="{13769302-C791-C4B3-8B53-D8AC2B4DCC3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03" name="グループ化 102">
                        <a:extLst>
                          <a:ext uri="{FF2B5EF4-FFF2-40B4-BE49-F238E27FC236}">
                            <a16:creationId xmlns:a16="http://schemas.microsoft.com/office/drawing/2014/main" id="{D7744020-5546-612B-8C7D-2942F3E50417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104" name="曲線コネクタ 103">
                          <a:extLst>
                            <a:ext uri="{FF2B5EF4-FFF2-40B4-BE49-F238E27FC236}">
                              <a16:creationId xmlns:a16="http://schemas.microsoft.com/office/drawing/2014/main" id="{6D4774A5-DD9B-552E-D53A-3F4BBB45BEE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05" name="曲線コネクタ 104">
                          <a:extLst>
                            <a:ext uri="{FF2B5EF4-FFF2-40B4-BE49-F238E27FC236}">
                              <a16:creationId xmlns:a16="http://schemas.microsoft.com/office/drawing/2014/main" id="{154411D0-FCC1-3C1C-C7B4-5C527BEBFF1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  <p:grpSp>
                <p:nvGrpSpPr>
                  <p:cNvPr id="77" name="グループ化 76">
                    <a:extLst>
                      <a:ext uri="{FF2B5EF4-FFF2-40B4-BE49-F238E27FC236}">
                        <a16:creationId xmlns:a16="http://schemas.microsoft.com/office/drawing/2014/main" id="{C7DC9D87-8152-0D45-5360-631A56A6ADC7}"/>
                      </a:ext>
                    </a:extLst>
                  </p:cNvPr>
                  <p:cNvGrpSpPr/>
                  <p:nvPr/>
                </p:nvGrpSpPr>
                <p:grpSpPr>
                  <a:xfrm rot="17579374">
                    <a:off x="2583369" y="1381095"/>
                    <a:ext cx="428995" cy="499429"/>
                    <a:chOff x="2595132" y="852400"/>
                    <a:chExt cx="428995" cy="499429"/>
                  </a:xfrm>
                </p:grpSpPr>
                <p:grpSp>
                  <p:nvGrpSpPr>
                    <p:cNvPr id="78" name="グループ化 77">
                      <a:extLst>
                        <a:ext uri="{FF2B5EF4-FFF2-40B4-BE49-F238E27FC236}">
                          <a16:creationId xmlns:a16="http://schemas.microsoft.com/office/drawing/2014/main" id="{146F7EB2-10B8-2F14-5B6C-CA08489C7862}"/>
                        </a:ext>
                      </a:extLst>
                    </p:cNvPr>
                    <p:cNvGrpSpPr/>
                    <p:nvPr/>
                  </p:nvGrpSpPr>
                  <p:grpSpPr>
                    <a:xfrm rot="20918512">
                      <a:off x="2694883" y="852400"/>
                      <a:ext cx="329244" cy="150117"/>
                      <a:chOff x="2338732" y="527352"/>
                      <a:chExt cx="329244" cy="150117"/>
                    </a:xfrm>
                  </p:grpSpPr>
                  <p:grpSp>
                    <p:nvGrpSpPr>
                      <p:cNvPr id="90" name="グループ化 89">
                        <a:extLst>
                          <a:ext uri="{FF2B5EF4-FFF2-40B4-BE49-F238E27FC236}">
                            <a16:creationId xmlns:a16="http://schemas.microsoft.com/office/drawing/2014/main" id="{E903B597-0265-E719-1976-A1EDCBFCD9D9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732" y="559770"/>
                        <a:ext cx="215075" cy="117699"/>
                        <a:chOff x="2907756" y="774300"/>
                        <a:chExt cx="200264" cy="110874"/>
                      </a:xfrm>
                    </p:grpSpPr>
                    <p:grpSp>
                      <p:nvGrpSpPr>
                        <p:cNvPr id="94" name="グループ化 93">
                          <a:extLst>
                            <a:ext uri="{FF2B5EF4-FFF2-40B4-BE49-F238E27FC236}">
                              <a16:creationId xmlns:a16="http://schemas.microsoft.com/office/drawing/2014/main" id="{B8A6C0D2-705F-1A68-1C84-297CD422743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98" name="曲線コネクタ 97">
                            <a:extLst>
                              <a:ext uri="{FF2B5EF4-FFF2-40B4-BE49-F238E27FC236}">
                                <a16:creationId xmlns:a16="http://schemas.microsoft.com/office/drawing/2014/main" id="{BFF9B5F9-4A4B-21FE-2770-B29D1ED0084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9" name="曲線コネクタ 98">
                            <a:extLst>
                              <a:ext uri="{FF2B5EF4-FFF2-40B4-BE49-F238E27FC236}">
                                <a16:creationId xmlns:a16="http://schemas.microsoft.com/office/drawing/2014/main" id="{7B1E26BE-6014-A25F-54AE-F7356B7AE87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95" name="グループ化 94">
                          <a:extLst>
                            <a:ext uri="{FF2B5EF4-FFF2-40B4-BE49-F238E27FC236}">
                              <a16:creationId xmlns:a16="http://schemas.microsoft.com/office/drawing/2014/main" id="{EBA059B3-33E9-A4CD-9BC8-3DBEE18F737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4300"/>
                          <a:ext cx="115140" cy="63091"/>
                          <a:chOff x="3017594" y="789128"/>
                          <a:chExt cx="115140" cy="63091"/>
                        </a:xfrm>
                      </p:grpSpPr>
                      <p:cxnSp>
                        <p:nvCxnSpPr>
                          <p:cNvPr id="96" name="曲線コネクタ 95">
                            <a:extLst>
                              <a:ext uri="{FF2B5EF4-FFF2-40B4-BE49-F238E27FC236}">
                                <a16:creationId xmlns:a16="http://schemas.microsoft.com/office/drawing/2014/main" id="{FC472186-45D7-EA58-0C8B-E69079839FE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7" name="曲線コネクタ 96">
                            <a:extLst>
                              <a:ext uri="{FF2B5EF4-FFF2-40B4-BE49-F238E27FC236}">
                                <a16:creationId xmlns:a16="http://schemas.microsoft.com/office/drawing/2014/main" id="{3B7937F7-5AA7-5EF7-3624-B52DE05031A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8476" y="789128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91" name="グループ化 90">
                        <a:extLst>
                          <a:ext uri="{FF2B5EF4-FFF2-40B4-BE49-F238E27FC236}">
                            <a16:creationId xmlns:a16="http://schemas.microsoft.com/office/drawing/2014/main" id="{C5B197B2-D1EA-2FA0-C040-5FE0C5D26E19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89" y="527352"/>
                        <a:ext cx="127687" cy="64152"/>
                        <a:chOff x="2907756" y="824356"/>
                        <a:chExt cx="118893" cy="60432"/>
                      </a:xfrm>
                    </p:grpSpPr>
                    <p:cxnSp>
                      <p:nvCxnSpPr>
                        <p:cNvPr id="92" name="曲線コネクタ 91">
                          <a:extLst>
                            <a:ext uri="{FF2B5EF4-FFF2-40B4-BE49-F238E27FC236}">
                              <a16:creationId xmlns:a16="http://schemas.microsoft.com/office/drawing/2014/main" id="{02EFEA1B-4834-59EA-A322-4DE14635FDF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12391" y="824356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3" name="曲線コネクタ 92">
                          <a:extLst>
                            <a:ext uri="{FF2B5EF4-FFF2-40B4-BE49-F238E27FC236}">
                              <a16:creationId xmlns:a16="http://schemas.microsoft.com/office/drawing/2014/main" id="{C6B729ED-D320-6EB7-0D05-DBCE922B8AE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79" name="グループ化 78">
                      <a:extLst>
                        <a:ext uri="{FF2B5EF4-FFF2-40B4-BE49-F238E27FC236}">
                          <a16:creationId xmlns:a16="http://schemas.microsoft.com/office/drawing/2014/main" id="{F8793C21-7DCF-EE40-FFD2-1BFC30BDA6C5}"/>
                        </a:ext>
                      </a:extLst>
                    </p:cNvPr>
                    <p:cNvGrpSpPr/>
                    <p:nvPr/>
                  </p:nvGrpSpPr>
                  <p:grpSpPr>
                    <a:xfrm rot="15812476" flipH="1">
                      <a:off x="2506959" y="1114056"/>
                      <a:ext cx="325946" cy="149599"/>
                      <a:chOff x="2338699" y="527862"/>
                      <a:chExt cx="325946" cy="149599"/>
                    </a:xfrm>
                  </p:grpSpPr>
                  <p:grpSp>
                    <p:nvGrpSpPr>
                      <p:cNvPr id="80" name="グループ化 79">
                        <a:extLst>
                          <a:ext uri="{FF2B5EF4-FFF2-40B4-BE49-F238E27FC236}">
                            <a16:creationId xmlns:a16="http://schemas.microsoft.com/office/drawing/2014/main" id="{0B2B205C-594A-9F50-8523-E28CE7360522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78353">
                        <a:off x="2338699" y="562853"/>
                        <a:ext cx="214216" cy="114608"/>
                        <a:chOff x="2907756" y="777212"/>
                        <a:chExt cx="199464" cy="107962"/>
                      </a:xfrm>
                    </p:grpSpPr>
                    <p:grpSp>
                      <p:nvGrpSpPr>
                        <p:cNvPr id="84" name="グループ化 83">
                          <a:extLst>
                            <a:ext uri="{FF2B5EF4-FFF2-40B4-BE49-F238E27FC236}">
                              <a16:creationId xmlns:a16="http://schemas.microsoft.com/office/drawing/2014/main" id="{AAD059DD-3291-D161-1AAF-80D22A9F6B4D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rot="20493866">
                          <a:off x="2907756" y="825059"/>
                          <a:ext cx="115853" cy="60115"/>
                          <a:chOff x="2907756" y="825059"/>
                          <a:chExt cx="115853" cy="60115"/>
                        </a:xfrm>
                      </p:grpSpPr>
                      <p:cxnSp>
                        <p:nvCxnSpPr>
                          <p:cNvPr id="88" name="曲線コネクタ 87">
                            <a:extLst>
                              <a:ext uri="{FF2B5EF4-FFF2-40B4-BE49-F238E27FC236}">
                                <a16:creationId xmlns:a16="http://schemas.microsoft.com/office/drawing/2014/main" id="{3CEE47A8-8CCD-2B8B-20FE-9C88C6B6E6C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2907756" y="825059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89" name="曲線コネクタ 88">
                            <a:extLst>
                              <a:ext uri="{FF2B5EF4-FFF2-40B4-BE49-F238E27FC236}">
                                <a16:creationId xmlns:a16="http://schemas.microsoft.com/office/drawing/2014/main" id="{13F0892F-2E5B-5A65-AFE3-8894A2C35A5B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2909351" y="825445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85" name="グループ化 84">
                          <a:extLst>
                            <a:ext uri="{FF2B5EF4-FFF2-40B4-BE49-F238E27FC236}">
                              <a16:creationId xmlns:a16="http://schemas.microsoft.com/office/drawing/2014/main" id="{9F471BA2-A13F-D81C-5C2A-97B730F17DA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2880" y="777212"/>
                          <a:ext cx="114340" cy="60179"/>
                          <a:chOff x="3017594" y="792040"/>
                          <a:chExt cx="114340" cy="60179"/>
                        </a:xfrm>
                      </p:grpSpPr>
                      <p:cxnSp>
                        <p:nvCxnSpPr>
                          <p:cNvPr id="86" name="曲線コネクタ 85">
                            <a:extLst>
                              <a:ext uri="{FF2B5EF4-FFF2-40B4-BE49-F238E27FC236}">
                                <a16:creationId xmlns:a16="http://schemas.microsoft.com/office/drawing/2014/main" id="{0505485A-A895-F96F-ADDD-5BBAB6B4631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299487">
                            <a:off x="3017676" y="79204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7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87" name="曲線コネクタ 86">
                            <a:extLst>
                              <a:ext uri="{FF2B5EF4-FFF2-40B4-BE49-F238E27FC236}">
                                <a16:creationId xmlns:a16="http://schemas.microsoft.com/office/drawing/2014/main" id="{C90FBFE5-444F-F80E-6476-D767A5E9C7C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rot="20313694" flipV="1">
                            <a:off x="3017594" y="792490"/>
                            <a:ext cx="114258" cy="59729"/>
                          </a:xfrm>
                          <a:prstGeom prst="curvedConnector3">
                            <a:avLst/>
                          </a:prstGeom>
                          <a:ln w="57150">
                            <a:solidFill>
                              <a:schemeClr val="accent5">
                                <a:lumMod val="60000"/>
                                <a:lumOff val="40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81" name="グループ化 80">
                        <a:extLst>
                          <a:ext uri="{FF2B5EF4-FFF2-40B4-BE49-F238E27FC236}">
                            <a16:creationId xmlns:a16="http://schemas.microsoft.com/office/drawing/2014/main" id="{44BC5B11-E507-9BFB-82AC-4250BE127ECA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472691">
                        <a:off x="2540223" y="527862"/>
                        <a:ext cx="124422" cy="63815"/>
                        <a:chOff x="2907756" y="825059"/>
                        <a:chExt cx="115853" cy="60115"/>
                      </a:xfrm>
                    </p:grpSpPr>
                    <p:cxnSp>
                      <p:nvCxnSpPr>
                        <p:cNvPr id="82" name="曲線コネクタ 81">
                          <a:extLst>
                            <a:ext uri="{FF2B5EF4-FFF2-40B4-BE49-F238E27FC236}">
                              <a16:creationId xmlns:a16="http://schemas.microsoft.com/office/drawing/2014/main" id="{72488BD0-39CE-4542-61E0-5549F97E15B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299487">
                          <a:off x="2907756" y="825059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60000"/>
                              <a:lumOff val="40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83" name="曲線コネクタ 82">
                          <a:extLst>
                            <a:ext uri="{FF2B5EF4-FFF2-40B4-BE49-F238E27FC236}">
                              <a16:creationId xmlns:a16="http://schemas.microsoft.com/office/drawing/2014/main" id="{285E0CC0-3239-6061-A0C1-E15CE369126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rot="20313694" flipV="1">
                          <a:off x="2909351" y="825445"/>
                          <a:ext cx="114258" cy="59729"/>
                        </a:xfrm>
                        <a:prstGeom prst="curvedConnector3">
                          <a:avLst/>
                        </a:prstGeom>
                        <a:ln w="57150">
                          <a:solidFill>
                            <a:schemeClr val="accent5">
                              <a:lumMod val="7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</p:grpSp>
            <p:sp>
              <p:nvSpPr>
                <p:cNvPr id="70" name="フリーフォーム 69">
                  <a:extLst>
                    <a:ext uri="{FF2B5EF4-FFF2-40B4-BE49-F238E27FC236}">
                      <a16:creationId xmlns:a16="http://schemas.microsoft.com/office/drawing/2014/main" id="{7CEA1ED2-66F4-060C-D803-E007A0F8ED23}"/>
                    </a:ext>
                  </a:extLst>
                </p:cNvPr>
                <p:cNvSpPr/>
                <p:nvPr/>
              </p:nvSpPr>
              <p:spPr>
                <a:xfrm rot="272787">
                  <a:off x="4417393" y="1058935"/>
                  <a:ext cx="188191" cy="258709"/>
                </a:xfrm>
                <a:custGeom>
                  <a:avLst/>
                  <a:gdLst>
                    <a:gd name="connsiteX0" fmla="*/ 573122 w 638175"/>
                    <a:gd name="connsiteY0" fmla="*/ 168542 h 891025"/>
                    <a:gd name="connsiteX1" fmla="*/ 486036 w 638175"/>
                    <a:gd name="connsiteY1" fmla="*/ 27028 h 891025"/>
                    <a:gd name="connsiteX2" fmla="*/ 333636 w 638175"/>
                    <a:gd name="connsiteY2" fmla="*/ 5256 h 891025"/>
                    <a:gd name="connsiteX3" fmla="*/ 170351 w 638175"/>
                    <a:gd name="connsiteY3" fmla="*/ 92342 h 891025"/>
                    <a:gd name="connsiteX4" fmla="*/ 7065 w 638175"/>
                    <a:gd name="connsiteY4" fmla="*/ 353599 h 891025"/>
                    <a:gd name="connsiteX5" fmla="*/ 61494 w 638175"/>
                    <a:gd name="connsiteY5" fmla="*/ 734599 h 891025"/>
                    <a:gd name="connsiteX6" fmla="*/ 344522 w 638175"/>
                    <a:gd name="connsiteY6" fmla="*/ 886999 h 891025"/>
                    <a:gd name="connsiteX7" fmla="*/ 616665 w 638175"/>
                    <a:gd name="connsiteY7" fmla="*/ 821685 h 891025"/>
                    <a:gd name="connsiteX8" fmla="*/ 594894 w 638175"/>
                    <a:gd name="connsiteY8" fmla="*/ 560428 h 891025"/>
                    <a:gd name="connsiteX9" fmla="*/ 388065 w 638175"/>
                    <a:gd name="connsiteY9" fmla="*/ 560428 h 891025"/>
                    <a:gd name="connsiteX10" fmla="*/ 279208 w 638175"/>
                    <a:gd name="connsiteY10" fmla="*/ 375371 h 891025"/>
                    <a:gd name="connsiteX11" fmla="*/ 398951 w 638175"/>
                    <a:gd name="connsiteY11" fmla="*/ 266514 h 891025"/>
                    <a:gd name="connsiteX12" fmla="*/ 496922 w 638175"/>
                    <a:gd name="connsiteY12" fmla="*/ 288285 h 891025"/>
                    <a:gd name="connsiteX13" fmla="*/ 573122 w 638175"/>
                    <a:gd name="connsiteY13" fmla="*/ 168542 h 8910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638175" h="891025">
                      <a:moveTo>
                        <a:pt x="573122" y="168542"/>
                      </a:moveTo>
                      <a:cubicBezTo>
                        <a:pt x="571308" y="124999"/>
                        <a:pt x="525950" y="54242"/>
                        <a:pt x="486036" y="27028"/>
                      </a:cubicBezTo>
                      <a:cubicBezTo>
                        <a:pt x="446122" y="-186"/>
                        <a:pt x="386250" y="-5630"/>
                        <a:pt x="333636" y="5256"/>
                      </a:cubicBezTo>
                      <a:cubicBezTo>
                        <a:pt x="281022" y="16142"/>
                        <a:pt x="224779" y="34285"/>
                        <a:pt x="170351" y="92342"/>
                      </a:cubicBezTo>
                      <a:cubicBezTo>
                        <a:pt x="115923" y="150399"/>
                        <a:pt x="25208" y="246556"/>
                        <a:pt x="7065" y="353599"/>
                      </a:cubicBezTo>
                      <a:cubicBezTo>
                        <a:pt x="-11078" y="460642"/>
                        <a:pt x="5251" y="645699"/>
                        <a:pt x="61494" y="734599"/>
                      </a:cubicBezTo>
                      <a:cubicBezTo>
                        <a:pt x="117737" y="823499"/>
                        <a:pt x="251994" y="872485"/>
                        <a:pt x="344522" y="886999"/>
                      </a:cubicBezTo>
                      <a:cubicBezTo>
                        <a:pt x="437050" y="901513"/>
                        <a:pt x="574936" y="876113"/>
                        <a:pt x="616665" y="821685"/>
                      </a:cubicBezTo>
                      <a:cubicBezTo>
                        <a:pt x="658394" y="767257"/>
                        <a:pt x="632994" y="603971"/>
                        <a:pt x="594894" y="560428"/>
                      </a:cubicBezTo>
                      <a:cubicBezTo>
                        <a:pt x="556794" y="516885"/>
                        <a:pt x="440679" y="591271"/>
                        <a:pt x="388065" y="560428"/>
                      </a:cubicBezTo>
                      <a:cubicBezTo>
                        <a:pt x="335451" y="529585"/>
                        <a:pt x="277394" y="424357"/>
                        <a:pt x="279208" y="375371"/>
                      </a:cubicBezTo>
                      <a:cubicBezTo>
                        <a:pt x="281022" y="326385"/>
                        <a:pt x="362665" y="281028"/>
                        <a:pt x="398951" y="266514"/>
                      </a:cubicBezTo>
                      <a:cubicBezTo>
                        <a:pt x="435237" y="252000"/>
                        <a:pt x="471522" y="299171"/>
                        <a:pt x="496922" y="288285"/>
                      </a:cubicBezTo>
                      <a:cubicBezTo>
                        <a:pt x="522322" y="277399"/>
                        <a:pt x="574936" y="212085"/>
                        <a:pt x="573122" y="168542"/>
                      </a:cubicBezTo>
                      <a:close/>
                    </a:path>
                  </a:pathLst>
                </a:cu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 dirty="0">
                    <a:latin typeface="Helvetica" pitchFamily="2" charset="0"/>
                  </a:endParaRPr>
                </a:p>
              </p:txBody>
            </p:sp>
            <p:sp>
              <p:nvSpPr>
                <p:cNvPr id="71" name="フリーフォーム 70">
                  <a:extLst>
                    <a:ext uri="{FF2B5EF4-FFF2-40B4-BE49-F238E27FC236}">
                      <a16:creationId xmlns:a16="http://schemas.microsoft.com/office/drawing/2014/main" id="{3C8F1DE1-526A-507F-90EA-89EECDE496E0}"/>
                    </a:ext>
                  </a:extLst>
                </p:cNvPr>
                <p:cNvSpPr/>
                <p:nvPr/>
              </p:nvSpPr>
              <p:spPr>
                <a:xfrm rot="21327213" flipH="1">
                  <a:off x="4569793" y="1058934"/>
                  <a:ext cx="188191" cy="258709"/>
                </a:xfrm>
                <a:custGeom>
                  <a:avLst/>
                  <a:gdLst>
                    <a:gd name="connsiteX0" fmla="*/ 573122 w 638175"/>
                    <a:gd name="connsiteY0" fmla="*/ 168542 h 891025"/>
                    <a:gd name="connsiteX1" fmla="*/ 486036 w 638175"/>
                    <a:gd name="connsiteY1" fmla="*/ 27028 h 891025"/>
                    <a:gd name="connsiteX2" fmla="*/ 333636 w 638175"/>
                    <a:gd name="connsiteY2" fmla="*/ 5256 h 891025"/>
                    <a:gd name="connsiteX3" fmla="*/ 170351 w 638175"/>
                    <a:gd name="connsiteY3" fmla="*/ 92342 h 891025"/>
                    <a:gd name="connsiteX4" fmla="*/ 7065 w 638175"/>
                    <a:gd name="connsiteY4" fmla="*/ 353599 h 891025"/>
                    <a:gd name="connsiteX5" fmla="*/ 61494 w 638175"/>
                    <a:gd name="connsiteY5" fmla="*/ 734599 h 891025"/>
                    <a:gd name="connsiteX6" fmla="*/ 344522 w 638175"/>
                    <a:gd name="connsiteY6" fmla="*/ 886999 h 891025"/>
                    <a:gd name="connsiteX7" fmla="*/ 616665 w 638175"/>
                    <a:gd name="connsiteY7" fmla="*/ 821685 h 891025"/>
                    <a:gd name="connsiteX8" fmla="*/ 594894 w 638175"/>
                    <a:gd name="connsiteY8" fmla="*/ 560428 h 891025"/>
                    <a:gd name="connsiteX9" fmla="*/ 388065 w 638175"/>
                    <a:gd name="connsiteY9" fmla="*/ 560428 h 891025"/>
                    <a:gd name="connsiteX10" fmla="*/ 279208 w 638175"/>
                    <a:gd name="connsiteY10" fmla="*/ 375371 h 891025"/>
                    <a:gd name="connsiteX11" fmla="*/ 398951 w 638175"/>
                    <a:gd name="connsiteY11" fmla="*/ 266514 h 891025"/>
                    <a:gd name="connsiteX12" fmla="*/ 496922 w 638175"/>
                    <a:gd name="connsiteY12" fmla="*/ 288285 h 891025"/>
                    <a:gd name="connsiteX13" fmla="*/ 573122 w 638175"/>
                    <a:gd name="connsiteY13" fmla="*/ 168542 h 8910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638175" h="891025">
                      <a:moveTo>
                        <a:pt x="573122" y="168542"/>
                      </a:moveTo>
                      <a:cubicBezTo>
                        <a:pt x="571308" y="124999"/>
                        <a:pt x="525950" y="54242"/>
                        <a:pt x="486036" y="27028"/>
                      </a:cubicBezTo>
                      <a:cubicBezTo>
                        <a:pt x="446122" y="-186"/>
                        <a:pt x="386250" y="-5630"/>
                        <a:pt x="333636" y="5256"/>
                      </a:cubicBezTo>
                      <a:cubicBezTo>
                        <a:pt x="281022" y="16142"/>
                        <a:pt x="224779" y="34285"/>
                        <a:pt x="170351" y="92342"/>
                      </a:cubicBezTo>
                      <a:cubicBezTo>
                        <a:pt x="115923" y="150399"/>
                        <a:pt x="25208" y="246556"/>
                        <a:pt x="7065" y="353599"/>
                      </a:cubicBezTo>
                      <a:cubicBezTo>
                        <a:pt x="-11078" y="460642"/>
                        <a:pt x="5251" y="645699"/>
                        <a:pt x="61494" y="734599"/>
                      </a:cubicBezTo>
                      <a:cubicBezTo>
                        <a:pt x="117737" y="823499"/>
                        <a:pt x="251994" y="872485"/>
                        <a:pt x="344522" y="886999"/>
                      </a:cubicBezTo>
                      <a:cubicBezTo>
                        <a:pt x="437050" y="901513"/>
                        <a:pt x="574936" y="876113"/>
                        <a:pt x="616665" y="821685"/>
                      </a:cubicBezTo>
                      <a:cubicBezTo>
                        <a:pt x="658394" y="767257"/>
                        <a:pt x="632994" y="603971"/>
                        <a:pt x="594894" y="560428"/>
                      </a:cubicBezTo>
                      <a:cubicBezTo>
                        <a:pt x="556794" y="516885"/>
                        <a:pt x="440679" y="591271"/>
                        <a:pt x="388065" y="560428"/>
                      </a:cubicBezTo>
                      <a:cubicBezTo>
                        <a:pt x="335451" y="529585"/>
                        <a:pt x="277394" y="424357"/>
                        <a:pt x="279208" y="375371"/>
                      </a:cubicBezTo>
                      <a:cubicBezTo>
                        <a:pt x="281022" y="326385"/>
                        <a:pt x="362665" y="281028"/>
                        <a:pt x="398951" y="266514"/>
                      </a:cubicBezTo>
                      <a:cubicBezTo>
                        <a:pt x="435237" y="252000"/>
                        <a:pt x="471522" y="299171"/>
                        <a:pt x="496922" y="288285"/>
                      </a:cubicBezTo>
                      <a:cubicBezTo>
                        <a:pt x="522322" y="277399"/>
                        <a:pt x="574936" y="212085"/>
                        <a:pt x="573122" y="168542"/>
                      </a:cubicBezTo>
                      <a:close/>
                    </a:path>
                  </a:pathLst>
                </a:cu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 dirty="0">
                    <a:latin typeface="Helvetica" pitchFamily="2" charset="0"/>
                  </a:endParaRPr>
                </a:p>
              </p:txBody>
            </p:sp>
            <p:sp>
              <p:nvSpPr>
                <p:cNvPr id="72" name="フリーフォーム 71">
                  <a:extLst>
                    <a:ext uri="{FF2B5EF4-FFF2-40B4-BE49-F238E27FC236}">
                      <a16:creationId xmlns:a16="http://schemas.microsoft.com/office/drawing/2014/main" id="{3AFEA95A-6DB2-D0F3-F8E8-E2BAA49C6A38}"/>
                    </a:ext>
                  </a:extLst>
                </p:cNvPr>
                <p:cNvSpPr/>
                <p:nvPr/>
              </p:nvSpPr>
              <p:spPr>
                <a:xfrm rot="21155521">
                  <a:off x="4230657" y="2219687"/>
                  <a:ext cx="287110" cy="341454"/>
                </a:xfrm>
                <a:custGeom>
                  <a:avLst/>
                  <a:gdLst>
                    <a:gd name="connsiteX0" fmla="*/ 33790 w 251639"/>
                    <a:gd name="connsiteY0" fmla="*/ 265254 h 340322"/>
                    <a:gd name="connsiteX1" fmla="*/ 1133 w 251639"/>
                    <a:gd name="connsiteY1" fmla="*/ 123740 h 340322"/>
                    <a:gd name="connsiteX2" fmla="*/ 55561 w 251639"/>
                    <a:gd name="connsiteY2" fmla="*/ 25769 h 340322"/>
                    <a:gd name="connsiteX3" fmla="*/ 186190 w 251639"/>
                    <a:gd name="connsiteY3" fmla="*/ 3997 h 340322"/>
                    <a:gd name="connsiteX4" fmla="*/ 251504 w 251639"/>
                    <a:gd name="connsiteY4" fmla="*/ 91083 h 340322"/>
                    <a:gd name="connsiteX5" fmla="*/ 197076 w 251639"/>
                    <a:gd name="connsiteY5" fmla="*/ 330569 h 340322"/>
                    <a:gd name="connsiteX6" fmla="*/ 33790 w 251639"/>
                    <a:gd name="connsiteY6" fmla="*/ 265254 h 3403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51639" h="340322">
                      <a:moveTo>
                        <a:pt x="33790" y="265254"/>
                      </a:moveTo>
                      <a:cubicBezTo>
                        <a:pt x="1133" y="230783"/>
                        <a:pt x="-2495" y="163654"/>
                        <a:pt x="1133" y="123740"/>
                      </a:cubicBezTo>
                      <a:cubicBezTo>
                        <a:pt x="4761" y="83826"/>
                        <a:pt x="24718" y="45726"/>
                        <a:pt x="55561" y="25769"/>
                      </a:cubicBezTo>
                      <a:cubicBezTo>
                        <a:pt x="86404" y="5812"/>
                        <a:pt x="153533" y="-6889"/>
                        <a:pt x="186190" y="3997"/>
                      </a:cubicBezTo>
                      <a:cubicBezTo>
                        <a:pt x="218847" y="14883"/>
                        <a:pt x="249690" y="36654"/>
                        <a:pt x="251504" y="91083"/>
                      </a:cubicBezTo>
                      <a:cubicBezTo>
                        <a:pt x="253318" y="145512"/>
                        <a:pt x="236990" y="296098"/>
                        <a:pt x="197076" y="330569"/>
                      </a:cubicBezTo>
                      <a:cubicBezTo>
                        <a:pt x="157162" y="365040"/>
                        <a:pt x="66447" y="299725"/>
                        <a:pt x="33790" y="265254"/>
                      </a:cubicBezTo>
                      <a:close/>
                    </a:path>
                  </a:pathLst>
                </a:cu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>
                    <a:latin typeface="Helvetica" pitchFamily="2" charset="0"/>
                  </a:endParaRPr>
                </a:p>
              </p:txBody>
            </p:sp>
            <p:sp>
              <p:nvSpPr>
                <p:cNvPr id="73" name="フリーフォーム 72">
                  <a:extLst>
                    <a:ext uri="{FF2B5EF4-FFF2-40B4-BE49-F238E27FC236}">
                      <a16:creationId xmlns:a16="http://schemas.microsoft.com/office/drawing/2014/main" id="{0451ABF1-AB1E-44DF-57AE-DBB5208A9DC3}"/>
                    </a:ext>
                  </a:extLst>
                </p:cNvPr>
                <p:cNvSpPr/>
                <p:nvPr/>
              </p:nvSpPr>
              <p:spPr>
                <a:xfrm rot="703009" flipH="1">
                  <a:off x="4496167" y="2221205"/>
                  <a:ext cx="283313" cy="343511"/>
                </a:xfrm>
                <a:custGeom>
                  <a:avLst/>
                  <a:gdLst>
                    <a:gd name="connsiteX0" fmla="*/ 33790 w 251639"/>
                    <a:gd name="connsiteY0" fmla="*/ 265254 h 340322"/>
                    <a:gd name="connsiteX1" fmla="*/ 1133 w 251639"/>
                    <a:gd name="connsiteY1" fmla="*/ 123740 h 340322"/>
                    <a:gd name="connsiteX2" fmla="*/ 55561 w 251639"/>
                    <a:gd name="connsiteY2" fmla="*/ 25769 h 340322"/>
                    <a:gd name="connsiteX3" fmla="*/ 186190 w 251639"/>
                    <a:gd name="connsiteY3" fmla="*/ 3997 h 340322"/>
                    <a:gd name="connsiteX4" fmla="*/ 251504 w 251639"/>
                    <a:gd name="connsiteY4" fmla="*/ 91083 h 340322"/>
                    <a:gd name="connsiteX5" fmla="*/ 197076 w 251639"/>
                    <a:gd name="connsiteY5" fmla="*/ 330569 h 340322"/>
                    <a:gd name="connsiteX6" fmla="*/ 33790 w 251639"/>
                    <a:gd name="connsiteY6" fmla="*/ 265254 h 34032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51639" h="340322">
                      <a:moveTo>
                        <a:pt x="33790" y="265254"/>
                      </a:moveTo>
                      <a:cubicBezTo>
                        <a:pt x="1133" y="230783"/>
                        <a:pt x="-2495" y="163654"/>
                        <a:pt x="1133" y="123740"/>
                      </a:cubicBezTo>
                      <a:cubicBezTo>
                        <a:pt x="4761" y="83826"/>
                        <a:pt x="24718" y="45726"/>
                        <a:pt x="55561" y="25769"/>
                      </a:cubicBezTo>
                      <a:cubicBezTo>
                        <a:pt x="86404" y="5812"/>
                        <a:pt x="153533" y="-6889"/>
                        <a:pt x="186190" y="3997"/>
                      </a:cubicBezTo>
                      <a:cubicBezTo>
                        <a:pt x="218847" y="14883"/>
                        <a:pt x="249690" y="36654"/>
                        <a:pt x="251504" y="91083"/>
                      </a:cubicBezTo>
                      <a:cubicBezTo>
                        <a:pt x="253318" y="145512"/>
                        <a:pt x="236990" y="296098"/>
                        <a:pt x="197076" y="330569"/>
                      </a:cubicBezTo>
                      <a:cubicBezTo>
                        <a:pt x="157162" y="365040"/>
                        <a:pt x="66447" y="299725"/>
                        <a:pt x="33790" y="265254"/>
                      </a:cubicBezTo>
                      <a:close/>
                    </a:path>
                  </a:pathLst>
                </a:cu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>
                    <a:latin typeface="Helvetica" pitchFamily="2" charset="0"/>
                  </a:endParaRPr>
                </a:p>
              </p:txBody>
            </p:sp>
            <p:sp>
              <p:nvSpPr>
                <p:cNvPr id="74" name="角丸四角形 73">
                  <a:extLst>
                    <a:ext uri="{FF2B5EF4-FFF2-40B4-BE49-F238E27FC236}">
                      <a16:creationId xmlns:a16="http://schemas.microsoft.com/office/drawing/2014/main" id="{9FC4538D-BD92-48E5-AAFE-17F3094EBAC1}"/>
                    </a:ext>
                  </a:extLst>
                </p:cNvPr>
                <p:cNvSpPr/>
                <p:nvPr/>
              </p:nvSpPr>
              <p:spPr>
                <a:xfrm rot="18891331">
                  <a:off x="4082387" y="2022956"/>
                  <a:ext cx="70017" cy="296757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>
                    <a:latin typeface="Helvetica" pitchFamily="2" charset="0"/>
                  </a:endParaRPr>
                </a:p>
              </p:txBody>
            </p:sp>
            <p:sp>
              <p:nvSpPr>
                <p:cNvPr id="75" name="角丸四角形 74">
                  <a:extLst>
                    <a:ext uri="{FF2B5EF4-FFF2-40B4-BE49-F238E27FC236}">
                      <a16:creationId xmlns:a16="http://schemas.microsoft.com/office/drawing/2014/main" id="{EEEE4D6E-562F-6959-8535-7F8596502001}"/>
                    </a:ext>
                  </a:extLst>
                </p:cNvPr>
                <p:cNvSpPr/>
                <p:nvPr/>
              </p:nvSpPr>
              <p:spPr>
                <a:xfrm rot="5556525" flipH="1">
                  <a:off x="4744398" y="2382581"/>
                  <a:ext cx="126099" cy="65300"/>
                </a:xfrm>
                <a:prstGeom prst="roundRect">
                  <a:avLst>
                    <a:gd name="adj" fmla="val 50000"/>
                  </a:avLst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CN" altLang="en-US">
                    <a:latin typeface="Helvetica" pitchFamily="2" charset="0"/>
                  </a:endParaRPr>
                </a:p>
              </p:txBody>
            </p:sp>
          </p:grp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00BBC7C0-9880-50B5-35AF-1AEA74C72B98}"/>
                  </a:ext>
                </a:extLst>
              </p:cNvPr>
              <p:cNvSpPr txBox="1"/>
              <p:nvPr/>
            </p:nvSpPr>
            <p:spPr>
              <a:xfrm>
                <a:off x="3290947" y="7946463"/>
                <a:ext cx="592735" cy="283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CN" sz="800" b="1" dirty="0">
                    <a:solidFill>
                      <a:schemeClr val="bg1">
                        <a:lumMod val="65000"/>
                      </a:schemeClr>
                    </a:solidFill>
                    <a:latin typeface="Helvetica" pitchFamily="2" charset="0"/>
                  </a:rPr>
                  <a:t>Pds5</a:t>
                </a:r>
                <a:endParaRPr kumimoji="1" lang="ja-CN" altLang="en-US" sz="800" b="1" dirty="0">
                  <a:solidFill>
                    <a:schemeClr val="bg1">
                      <a:lumMod val="65000"/>
                    </a:schemeClr>
                  </a:solidFill>
                  <a:latin typeface="Helvetica" pitchFamily="2" charset="0"/>
                </a:endParaRPr>
              </a:p>
            </p:txBody>
          </p:sp>
          <p:sp>
            <p:nvSpPr>
              <p:cNvPr id="59" name="円/楕円 58">
                <a:extLst>
                  <a:ext uri="{FF2B5EF4-FFF2-40B4-BE49-F238E27FC236}">
                    <a16:creationId xmlns:a16="http://schemas.microsoft.com/office/drawing/2014/main" id="{D5612D19-9F29-53C7-DBC2-C865285BB091}"/>
                  </a:ext>
                </a:extLst>
              </p:cNvPr>
              <p:cNvSpPr/>
              <p:nvPr/>
            </p:nvSpPr>
            <p:spPr>
              <a:xfrm>
                <a:off x="4387166" y="8087505"/>
                <a:ext cx="83773" cy="83773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elvetica" pitchFamily="2" charset="0"/>
                </a:endParaRPr>
              </a:p>
            </p:txBody>
          </p:sp>
          <p:sp>
            <p:nvSpPr>
              <p:cNvPr id="60" name="円/楕円 59">
                <a:extLst>
                  <a:ext uri="{FF2B5EF4-FFF2-40B4-BE49-F238E27FC236}">
                    <a16:creationId xmlns:a16="http://schemas.microsoft.com/office/drawing/2014/main" id="{62721401-82C9-1CD1-D2F3-3CE19244271E}"/>
                  </a:ext>
                </a:extLst>
              </p:cNvPr>
              <p:cNvSpPr/>
              <p:nvPr/>
            </p:nvSpPr>
            <p:spPr>
              <a:xfrm>
                <a:off x="3934619" y="7367557"/>
                <a:ext cx="129979" cy="129981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elvetica" pitchFamily="2" charset="0"/>
                </a:endParaRPr>
              </a:p>
            </p:txBody>
          </p:sp>
          <p:sp>
            <p:nvSpPr>
              <p:cNvPr id="61" name="円/楕円 60">
                <a:extLst>
                  <a:ext uri="{FF2B5EF4-FFF2-40B4-BE49-F238E27FC236}">
                    <a16:creationId xmlns:a16="http://schemas.microsoft.com/office/drawing/2014/main" id="{09925864-B43C-1209-6F58-C10308C9899D}"/>
                  </a:ext>
                </a:extLst>
              </p:cNvPr>
              <p:cNvSpPr/>
              <p:nvPr/>
            </p:nvSpPr>
            <p:spPr>
              <a:xfrm>
                <a:off x="4072820" y="7366114"/>
                <a:ext cx="129979" cy="129981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elvetica" pitchFamily="2" charset="0"/>
                </a:endParaRPr>
              </a:p>
            </p:txBody>
          </p:sp>
          <p:sp>
            <p:nvSpPr>
              <p:cNvPr id="62" name="テキスト ボックス 37">
                <a:extLst>
                  <a:ext uri="{FF2B5EF4-FFF2-40B4-BE49-F238E27FC236}">
                    <a16:creationId xmlns:a16="http://schemas.microsoft.com/office/drawing/2014/main" id="{300B1D8E-124D-9CF6-9942-143BF98E1973}"/>
                  </a:ext>
                </a:extLst>
              </p:cNvPr>
              <p:cNvSpPr txBox="1"/>
              <p:nvPr/>
            </p:nvSpPr>
            <p:spPr>
              <a:xfrm>
                <a:off x="3815389" y="7307327"/>
                <a:ext cx="374671" cy="2429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en-US" sz="600" b="1" dirty="0">
                    <a:latin typeface="Helvetica" pitchFamily="2" charset="0"/>
                  </a:rPr>
                  <a:t>Ac</a:t>
                </a:r>
                <a:endParaRPr kumimoji="1" lang="en-US" altLang="en-US" sz="600" b="1" dirty="0">
                  <a:latin typeface="Helvetica" pitchFamily="2" charset="0"/>
                </a:endParaRPr>
              </a:p>
            </p:txBody>
          </p:sp>
          <p:sp>
            <p:nvSpPr>
              <p:cNvPr id="63" name="テキスト ボックス 37">
                <a:extLst>
                  <a:ext uri="{FF2B5EF4-FFF2-40B4-BE49-F238E27FC236}">
                    <a16:creationId xmlns:a16="http://schemas.microsoft.com/office/drawing/2014/main" id="{CDBF5CA8-42EF-78E4-B747-3CA8563F1FE7}"/>
                  </a:ext>
                </a:extLst>
              </p:cNvPr>
              <p:cNvSpPr txBox="1"/>
              <p:nvPr/>
            </p:nvSpPr>
            <p:spPr>
              <a:xfrm>
                <a:off x="3952185" y="7308427"/>
                <a:ext cx="371061" cy="2429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en-US" sz="600" b="1" dirty="0">
                    <a:latin typeface="Helvetica" pitchFamily="2" charset="0"/>
                  </a:rPr>
                  <a:t>Ac</a:t>
                </a:r>
              </a:p>
            </p:txBody>
          </p:sp>
          <p:sp>
            <p:nvSpPr>
              <p:cNvPr id="64" name="フリーフォーム 63">
                <a:extLst>
                  <a:ext uri="{FF2B5EF4-FFF2-40B4-BE49-F238E27FC236}">
                    <a16:creationId xmlns:a16="http://schemas.microsoft.com/office/drawing/2014/main" id="{27A49F99-F0A0-0895-D0C9-59CE7C1757C3}"/>
                  </a:ext>
                </a:extLst>
              </p:cNvPr>
              <p:cNvSpPr/>
              <p:nvPr/>
            </p:nvSpPr>
            <p:spPr>
              <a:xfrm>
                <a:off x="3467186" y="7009113"/>
                <a:ext cx="1177886" cy="1792929"/>
              </a:xfrm>
              <a:custGeom>
                <a:avLst/>
                <a:gdLst>
                  <a:gd name="connsiteX0" fmla="*/ 406921 w 1223540"/>
                  <a:gd name="connsiteY0" fmla="*/ 209508 h 1792929"/>
                  <a:gd name="connsiteX1" fmla="*/ 254521 w 1223540"/>
                  <a:gd name="connsiteY1" fmla="*/ 57108 h 1792929"/>
                  <a:gd name="connsiteX2" fmla="*/ 173839 w 1223540"/>
                  <a:gd name="connsiteY2" fmla="*/ 3319 h 1792929"/>
                  <a:gd name="connsiteX3" fmla="*/ 39368 w 1223540"/>
                  <a:gd name="connsiteY3" fmla="*/ 21249 h 1792929"/>
                  <a:gd name="connsiteX4" fmla="*/ 30403 w 1223540"/>
                  <a:gd name="connsiteY4" fmla="*/ 146755 h 1792929"/>
                  <a:gd name="connsiteX5" fmla="*/ 406921 w 1223540"/>
                  <a:gd name="connsiteY5" fmla="*/ 424661 h 1792929"/>
                  <a:gd name="connsiteX6" fmla="*/ 532427 w 1223540"/>
                  <a:gd name="connsiteY6" fmla="*/ 962543 h 1792929"/>
                  <a:gd name="connsiteX7" fmla="*/ 613109 w 1223540"/>
                  <a:gd name="connsiteY7" fmla="*/ 1258378 h 1792929"/>
                  <a:gd name="connsiteX8" fmla="*/ 738615 w 1223540"/>
                  <a:gd name="connsiteY8" fmla="*/ 1482496 h 1792929"/>
                  <a:gd name="connsiteX9" fmla="*/ 523462 w 1223540"/>
                  <a:gd name="connsiteY9" fmla="*/ 1518355 h 1792929"/>
                  <a:gd name="connsiteX10" fmla="*/ 371062 w 1223540"/>
                  <a:gd name="connsiteY10" fmla="*/ 1392849 h 1792929"/>
                  <a:gd name="connsiteX11" fmla="*/ 200733 w 1223540"/>
                  <a:gd name="connsiteY11" fmla="*/ 1428708 h 1792929"/>
                  <a:gd name="connsiteX12" fmla="*/ 200733 w 1223540"/>
                  <a:gd name="connsiteY12" fmla="*/ 1590072 h 1792929"/>
                  <a:gd name="connsiteX13" fmla="*/ 478639 w 1223540"/>
                  <a:gd name="connsiteY13" fmla="*/ 1787296 h 1792929"/>
                  <a:gd name="connsiteX14" fmla="*/ 1016521 w 1223540"/>
                  <a:gd name="connsiteY14" fmla="*/ 1724543 h 1792929"/>
                  <a:gd name="connsiteX15" fmla="*/ 1186851 w 1223540"/>
                  <a:gd name="connsiteY15" fmla="*/ 1572143 h 1792929"/>
                  <a:gd name="connsiteX16" fmla="*/ 1043415 w 1223540"/>
                  <a:gd name="connsiteY16" fmla="*/ 1195625 h 1792929"/>
                  <a:gd name="connsiteX17" fmla="*/ 962733 w 1223540"/>
                  <a:gd name="connsiteY17" fmla="*/ 1016331 h 1792929"/>
                  <a:gd name="connsiteX18" fmla="*/ 1007556 w 1223540"/>
                  <a:gd name="connsiteY18" fmla="*/ 890825 h 1792929"/>
                  <a:gd name="connsiteX19" fmla="*/ 1177886 w 1223540"/>
                  <a:gd name="connsiteY19" fmla="*/ 783249 h 1792929"/>
                  <a:gd name="connsiteX20" fmla="*/ 1222709 w 1223540"/>
                  <a:gd name="connsiteY20" fmla="*/ 612919 h 1792929"/>
                  <a:gd name="connsiteX21" fmla="*/ 1150992 w 1223540"/>
                  <a:gd name="connsiteY21" fmla="*/ 415696 h 1792929"/>
                  <a:gd name="connsiteX22" fmla="*/ 1159956 w 1223540"/>
                  <a:gd name="connsiteY22" fmla="*/ 433625 h 17929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1223540" h="1792929">
                    <a:moveTo>
                      <a:pt x="406921" y="209508"/>
                    </a:moveTo>
                    <a:cubicBezTo>
                      <a:pt x="350144" y="150490"/>
                      <a:pt x="293368" y="91473"/>
                      <a:pt x="254521" y="57108"/>
                    </a:cubicBezTo>
                    <a:cubicBezTo>
                      <a:pt x="215674" y="22743"/>
                      <a:pt x="209698" y="9295"/>
                      <a:pt x="173839" y="3319"/>
                    </a:cubicBezTo>
                    <a:cubicBezTo>
                      <a:pt x="137980" y="-2657"/>
                      <a:pt x="63274" y="-2657"/>
                      <a:pt x="39368" y="21249"/>
                    </a:cubicBezTo>
                    <a:cubicBezTo>
                      <a:pt x="15462" y="45155"/>
                      <a:pt x="-30856" y="79520"/>
                      <a:pt x="30403" y="146755"/>
                    </a:cubicBezTo>
                    <a:cubicBezTo>
                      <a:pt x="91662" y="213990"/>
                      <a:pt x="323250" y="288696"/>
                      <a:pt x="406921" y="424661"/>
                    </a:cubicBezTo>
                    <a:cubicBezTo>
                      <a:pt x="490592" y="560626"/>
                      <a:pt x="498062" y="823590"/>
                      <a:pt x="532427" y="962543"/>
                    </a:cubicBezTo>
                    <a:cubicBezTo>
                      <a:pt x="566792" y="1101496"/>
                      <a:pt x="578744" y="1171719"/>
                      <a:pt x="613109" y="1258378"/>
                    </a:cubicBezTo>
                    <a:cubicBezTo>
                      <a:pt x="647474" y="1345037"/>
                      <a:pt x="753556" y="1439167"/>
                      <a:pt x="738615" y="1482496"/>
                    </a:cubicBezTo>
                    <a:cubicBezTo>
                      <a:pt x="723674" y="1525825"/>
                      <a:pt x="584721" y="1533296"/>
                      <a:pt x="523462" y="1518355"/>
                    </a:cubicBezTo>
                    <a:cubicBezTo>
                      <a:pt x="462203" y="1503414"/>
                      <a:pt x="424850" y="1407790"/>
                      <a:pt x="371062" y="1392849"/>
                    </a:cubicBezTo>
                    <a:cubicBezTo>
                      <a:pt x="317274" y="1377908"/>
                      <a:pt x="229121" y="1395838"/>
                      <a:pt x="200733" y="1428708"/>
                    </a:cubicBezTo>
                    <a:cubicBezTo>
                      <a:pt x="172345" y="1461578"/>
                      <a:pt x="154415" y="1530307"/>
                      <a:pt x="200733" y="1590072"/>
                    </a:cubicBezTo>
                    <a:cubicBezTo>
                      <a:pt x="247051" y="1649837"/>
                      <a:pt x="342674" y="1764884"/>
                      <a:pt x="478639" y="1787296"/>
                    </a:cubicBezTo>
                    <a:cubicBezTo>
                      <a:pt x="614604" y="1809708"/>
                      <a:pt x="898486" y="1760402"/>
                      <a:pt x="1016521" y="1724543"/>
                    </a:cubicBezTo>
                    <a:cubicBezTo>
                      <a:pt x="1134556" y="1688684"/>
                      <a:pt x="1182369" y="1660296"/>
                      <a:pt x="1186851" y="1572143"/>
                    </a:cubicBezTo>
                    <a:cubicBezTo>
                      <a:pt x="1191333" y="1483990"/>
                      <a:pt x="1080768" y="1288260"/>
                      <a:pt x="1043415" y="1195625"/>
                    </a:cubicBezTo>
                    <a:cubicBezTo>
                      <a:pt x="1006062" y="1102990"/>
                      <a:pt x="968709" y="1067131"/>
                      <a:pt x="962733" y="1016331"/>
                    </a:cubicBezTo>
                    <a:cubicBezTo>
                      <a:pt x="956757" y="965531"/>
                      <a:pt x="971697" y="929672"/>
                      <a:pt x="1007556" y="890825"/>
                    </a:cubicBezTo>
                    <a:cubicBezTo>
                      <a:pt x="1043415" y="851978"/>
                      <a:pt x="1142027" y="829567"/>
                      <a:pt x="1177886" y="783249"/>
                    </a:cubicBezTo>
                    <a:cubicBezTo>
                      <a:pt x="1213745" y="736931"/>
                      <a:pt x="1227191" y="674178"/>
                      <a:pt x="1222709" y="612919"/>
                    </a:cubicBezTo>
                    <a:cubicBezTo>
                      <a:pt x="1218227" y="551660"/>
                      <a:pt x="1150992" y="415696"/>
                      <a:pt x="1150992" y="415696"/>
                    </a:cubicBezTo>
                    <a:cubicBezTo>
                      <a:pt x="1140533" y="385814"/>
                      <a:pt x="1150244" y="409719"/>
                      <a:pt x="1159956" y="433625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CN" altLang="en-US" dirty="0"/>
              </a:p>
            </p:txBody>
          </p:sp>
          <p:sp>
            <p:nvSpPr>
              <p:cNvPr id="65" name="正方形/長方形 64">
                <a:extLst>
                  <a:ext uri="{FF2B5EF4-FFF2-40B4-BE49-F238E27FC236}">
                    <a16:creationId xmlns:a16="http://schemas.microsoft.com/office/drawing/2014/main" id="{BA6D639C-120B-526E-7EDF-5039B9616B1D}"/>
                  </a:ext>
                </a:extLst>
              </p:cNvPr>
              <p:cNvSpPr/>
              <p:nvPr/>
            </p:nvSpPr>
            <p:spPr>
              <a:xfrm rot="4560115">
                <a:off x="3691148" y="7616070"/>
                <a:ext cx="437021" cy="949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elvetica" pitchFamily="2" charset="0"/>
                </a:endParaRPr>
              </a:p>
            </p:txBody>
          </p:sp>
        </p:grp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id="{70440332-3E2E-C9C1-FE22-59C68DBFCCCA}"/>
                </a:ext>
              </a:extLst>
            </p:cNvPr>
            <p:cNvSpPr txBox="1"/>
            <p:nvPr/>
          </p:nvSpPr>
          <p:spPr>
            <a:xfrm>
              <a:off x="3486507" y="8933291"/>
              <a:ext cx="1095182" cy="283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Helvetica" pitchFamily="2" charset="0"/>
                </a:rPr>
                <a:t>Establishment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35" name="右矢印 34">
              <a:extLst>
                <a:ext uri="{FF2B5EF4-FFF2-40B4-BE49-F238E27FC236}">
                  <a16:creationId xmlns:a16="http://schemas.microsoft.com/office/drawing/2014/main" id="{E3B9B395-8DF9-FCBA-370A-E87A5894CDC0}"/>
                </a:ext>
              </a:extLst>
            </p:cNvPr>
            <p:cNvSpPr/>
            <p:nvPr/>
          </p:nvSpPr>
          <p:spPr>
            <a:xfrm>
              <a:off x="4750890" y="7441374"/>
              <a:ext cx="624071" cy="378900"/>
            </a:xfrm>
            <a:prstGeom prst="rightArrow">
              <a:avLst>
                <a:gd name="adj1" fmla="val 25000"/>
                <a:gd name="adj2" fmla="val 50000"/>
              </a:avLst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id="{7EAB1155-2333-6D12-8E16-DBE3CAC84CBA}"/>
                </a:ext>
              </a:extLst>
            </p:cNvPr>
            <p:cNvSpPr txBox="1"/>
            <p:nvPr/>
          </p:nvSpPr>
          <p:spPr>
            <a:xfrm>
              <a:off x="4687302" y="7679368"/>
              <a:ext cx="590010" cy="283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CN" sz="800" b="1" dirty="0">
                  <a:latin typeface="Helvetica" pitchFamily="2" charset="0"/>
                </a:rPr>
                <a:t>Wpl1</a:t>
              </a:r>
              <a:endParaRPr kumimoji="1" lang="ja-CN" altLang="en-US" sz="800" b="1" dirty="0">
                <a:latin typeface="Helvetica" pitchFamily="2" charset="0"/>
              </a:endParaRPr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C9CBB899-C260-26BA-C0C8-E81241F2C82E}"/>
                </a:ext>
              </a:extLst>
            </p:cNvPr>
            <p:cNvSpPr txBox="1"/>
            <p:nvPr/>
          </p:nvSpPr>
          <p:spPr>
            <a:xfrm>
              <a:off x="4703944" y="7320833"/>
              <a:ext cx="506670" cy="2834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CN" sz="800" b="1" dirty="0">
                  <a:latin typeface="Helvetica" pitchFamily="2" charset="0"/>
                </a:rPr>
                <a:t>Clr6</a:t>
              </a:r>
              <a:endParaRPr kumimoji="1" lang="ja-CN" altLang="en-US" sz="800" b="1" dirty="0">
                <a:latin typeface="Helvetica" pitchFamily="2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CFE3BF85-E1A3-4C8F-AA05-5291677832B5}"/>
                </a:ext>
              </a:extLst>
            </p:cNvPr>
            <p:cNvSpPr txBox="1"/>
            <p:nvPr/>
          </p:nvSpPr>
          <p:spPr>
            <a:xfrm>
              <a:off x="5392701" y="7388338"/>
              <a:ext cx="768023" cy="445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 err="1">
                  <a:latin typeface="Helvetica" pitchFamily="2" charset="0"/>
                </a:rPr>
                <a:t>Cohesin</a:t>
              </a:r>
              <a:r>
                <a:rPr kumimoji="1" lang="en-US" altLang="ja-JP" sz="800" dirty="0">
                  <a:latin typeface="Helvetica" pitchFamily="2" charset="0"/>
                </a:rPr>
                <a:t> release</a:t>
              </a:r>
              <a:endParaRPr kumimoji="1" lang="ja-JP" altLang="en-US" sz="800">
                <a:latin typeface="Helvetica" pitchFamily="2" charset="0"/>
              </a:endParaRPr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4A57CAD8-86CE-2796-6D0B-40A5AB4730F8}"/>
              </a:ext>
            </a:extLst>
          </p:cNvPr>
          <p:cNvGrpSpPr/>
          <p:nvPr/>
        </p:nvGrpSpPr>
        <p:grpSpPr>
          <a:xfrm>
            <a:off x="950476" y="4215581"/>
            <a:ext cx="4613899" cy="2186628"/>
            <a:chOff x="950476" y="4215581"/>
            <a:chExt cx="4613899" cy="2186628"/>
          </a:xfrm>
        </p:grpSpPr>
        <p:sp>
          <p:nvSpPr>
            <p:cNvPr id="3" name="テキスト ボックス 456">
              <a:extLst>
                <a:ext uri="{FF2B5EF4-FFF2-40B4-BE49-F238E27FC236}">
                  <a16:creationId xmlns:a16="http://schemas.microsoft.com/office/drawing/2014/main" id="{018778C7-6F33-3A77-CF76-C05B550790F8}"/>
                </a:ext>
              </a:extLst>
            </p:cNvPr>
            <p:cNvSpPr txBox="1"/>
            <p:nvPr/>
          </p:nvSpPr>
          <p:spPr>
            <a:xfrm>
              <a:off x="950476" y="4215581"/>
              <a:ext cx="220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200" b="1" dirty="0">
                  <a:latin typeface="Helvetica" pitchFamily="2" charset="0"/>
                </a:rPr>
                <a:t>B</a:t>
              </a:r>
              <a:endParaRPr kumimoji="1" lang="x-none" altLang="en-US" sz="1200" b="1" dirty="0">
                <a:latin typeface="Helvetica" pitchFamily="2" charset="0"/>
              </a:endParaRPr>
            </a:p>
          </p:txBody>
        </p:sp>
        <p:grpSp>
          <p:nvGrpSpPr>
            <p:cNvPr id="452" name="グループ化 451">
              <a:extLst>
                <a:ext uri="{FF2B5EF4-FFF2-40B4-BE49-F238E27FC236}">
                  <a16:creationId xmlns:a16="http://schemas.microsoft.com/office/drawing/2014/main" id="{B198E7DE-749F-6AB5-101F-7AB8DEB5FD03}"/>
                </a:ext>
              </a:extLst>
            </p:cNvPr>
            <p:cNvGrpSpPr/>
            <p:nvPr/>
          </p:nvGrpSpPr>
          <p:grpSpPr>
            <a:xfrm>
              <a:off x="989464" y="4355431"/>
              <a:ext cx="1574313" cy="2035573"/>
              <a:chOff x="989464" y="4355431"/>
              <a:chExt cx="1574313" cy="2035573"/>
            </a:xfrm>
          </p:grpSpPr>
          <p:sp>
            <p:nvSpPr>
              <p:cNvPr id="4" name="TextBox 67">
                <a:extLst>
                  <a:ext uri="{FF2B5EF4-FFF2-40B4-BE49-F238E27FC236}">
                    <a16:creationId xmlns:a16="http://schemas.microsoft.com/office/drawing/2014/main" id="{30CB99ED-E161-D383-8E04-80C5A2F1E068}"/>
                  </a:ext>
                </a:extLst>
              </p:cNvPr>
              <p:cNvSpPr txBox="1"/>
              <p:nvPr/>
            </p:nvSpPr>
            <p:spPr>
              <a:xfrm>
                <a:off x="1467813" y="4355431"/>
                <a:ext cx="8903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Helvetica" pitchFamily="2" charset="0"/>
                  </a:rPr>
                  <a:t>Mis4-PK  IP(%)</a:t>
                </a:r>
                <a:endParaRPr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" name="TextBox 68">
                <a:extLst>
                  <a:ext uri="{FF2B5EF4-FFF2-40B4-BE49-F238E27FC236}">
                    <a16:creationId xmlns:a16="http://schemas.microsoft.com/office/drawing/2014/main" id="{EA57A33A-D2EE-9BD7-77CC-33ECAFAE2361}"/>
                  </a:ext>
                </a:extLst>
              </p:cNvPr>
              <p:cNvSpPr txBox="1"/>
              <p:nvPr/>
            </p:nvSpPr>
            <p:spPr>
              <a:xfrm>
                <a:off x="1393536" y="4521022"/>
                <a:ext cx="3606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 err="1">
                    <a:latin typeface="Helvetica" pitchFamily="2" charset="0"/>
                  </a:rPr>
                  <a:t>wt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sp>
            <p:nvSpPr>
              <p:cNvPr id="7" name="TextBox 69">
                <a:extLst>
                  <a:ext uri="{FF2B5EF4-FFF2-40B4-BE49-F238E27FC236}">
                    <a16:creationId xmlns:a16="http://schemas.microsoft.com/office/drawing/2014/main" id="{DB266A52-6779-7FC8-6F40-C10BBD85BA38}"/>
                  </a:ext>
                </a:extLst>
              </p:cNvPr>
              <p:cNvSpPr txBox="1"/>
              <p:nvPr/>
            </p:nvSpPr>
            <p:spPr>
              <a:xfrm>
                <a:off x="1941449" y="4521024"/>
                <a:ext cx="6043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Helvetica" pitchFamily="2" charset="0"/>
                  </a:rPr>
                  <a:t>moa1Δ 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graphicFrame>
            <p:nvGraphicFramePr>
              <p:cNvPr id="38" name="图表 52">
                <a:extLst>
                  <a:ext uri="{FF2B5EF4-FFF2-40B4-BE49-F238E27FC236}">
                    <a16:creationId xmlns:a16="http://schemas.microsoft.com/office/drawing/2014/main" id="{FD42B292-91D5-6101-3121-DD4881C3112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41074202"/>
                  </p:ext>
                </p:extLst>
              </p:nvPr>
            </p:nvGraphicFramePr>
            <p:xfrm>
              <a:off x="989464" y="4595164"/>
              <a:ext cx="1574313" cy="166598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cxnSp>
            <p:nvCxnSpPr>
              <p:cNvPr id="314" name="直線コネクタ 458">
                <a:extLst>
                  <a:ext uri="{FF2B5EF4-FFF2-40B4-BE49-F238E27FC236}">
                    <a16:creationId xmlns:a16="http://schemas.microsoft.com/office/drawing/2014/main" id="{3BAF94FB-F35B-3397-C9A9-A521C7AA17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17647" y="4543316"/>
                <a:ext cx="109100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442D68DF-92F5-DD36-B19B-933D22F4C7C5}"/>
                  </a:ext>
                </a:extLst>
              </p:cNvPr>
              <p:cNvGrpSpPr/>
              <p:nvPr/>
            </p:nvGrpSpPr>
            <p:grpSpPr>
              <a:xfrm>
                <a:off x="1288767" y="6021692"/>
                <a:ext cx="1130451" cy="369312"/>
                <a:chOff x="1288767" y="6021692"/>
                <a:chExt cx="1130451" cy="369312"/>
              </a:xfrm>
            </p:grpSpPr>
            <p:grpSp>
              <p:nvGrpSpPr>
                <p:cNvPr id="5" name="グループ化 4">
                  <a:extLst>
                    <a:ext uri="{FF2B5EF4-FFF2-40B4-BE49-F238E27FC236}">
                      <a16:creationId xmlns:a16="http://schemas.microsoft.com/office/drawing/2014/main" id="{D205E802-2717-6DEA-F460-416417903263}"/>
                    </a:ext>
                  </a:extLst>
                </p:cNvPr>
                <p:cNvGrpSpPr/>
                <p:nvPr/>
              </p:nvGrpSpPr>
              <p:grpSpPr>
                <a:xfrm>
                  <a:off x="1862508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482" name="TextBox 31">
                    <a:extLst>
                      <a:ext uri="{FF2B5EF4-FFF2-40B4-BE49-F238E27FC236}">
                        <a16:creationId xmlns:a16="http://schemas.microsoft.com/office/drawing/2014/main" id="{70856B80-9DC3-1D9C-9CED-C425D8D8113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483" name="TextBox 33">
                    <a:extLst>
                      <a:ext uri="{FF2B5EF4-FFF2-40B4-BE49-F238E27FC236}">
                        <a16:creationId xmlns:a16="http://schemas.microsoft.com/office/drawing/2014/main" id="{2ECB745D-E909-19F1-A894-75307073E15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484" name="TextBox 34">
                    <a:extLst>
                      <a:ext uri="{FF2B5EF4-FFF2-40B4-BE49-F238E27FC236}">
                        <a16:creationId xmlns:a16="http://schemas.microsoft.com/office/drawing/2014/main" id="{FAEE3BCC-EEA8-090C-88BC-AB7D952FAFB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491" name="TextBox 30">
                    <a:extLst>
                      <a:ext uri="{FF2B5EF4-FFF2-40B4-BE49-F238E27FC236}">
                        <a16:creationId xmlns:a16="http://schemas.microsoft.com/office/drawing/2014/main" id="{87F10E78-2B9B-1F06-78F6-F50F0127C96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403C6809-0859-E64E-9D98-AF42E5717AC4}"/>
                    </a:ext>
                  </a:extLst>
                </p:cNvPr>
                <p:cNvGrpSpPr/>
                <p:nvPr/>
              </p:nvGrpSpPr>
              <p:grpSpPr>
                <a:xfrm>
                  <a:off x="1288767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9" name="TextBox 31">
                    <a:extLst>
                      <a:ext uri="{FF2B5EF4-FFF2-40B4-BE49-F238E27FC236}">
                        <a16:creationId xmlns:a16="http://schemas.microsoft.com/office/drawing/2014/main" id="{2D2D8C5F-2AD2-5DEB-1A07-69E3FC33EBF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0" name="TextBox 33">
                    <a:extLst>
                      <a:ext uri="{FF2B5EF4-FFF2-40B4-BE49-F238E27FC236}">
                        <a16:creationId xmlns:a16="http://schemas.microsoft.com/office/drawing/2014/main" id="{E5B846EF-AFFE-1FCF-A069-33DCEEB5585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1" name="TextBox 34">
                    <a:extLst>
                      <a:ext uri="{FF2B5EF4-FFF2-40B4-BE49-F238E27FC236}">
                        <a16:creationId xmlns:a16="http://schemas.microsoft.com/office/drawing/2014/main" id="{B1124377-E7C6-95FD-247C-0F7FB896AB6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2" name="TextBox 30">
                    <a:extLst>
                      <a:ext uri="{FF2B5EF4-FFF2-40B4-BE49-F238E27FC236}">
                        <a16:creationId xmlns:a16="http://schemas.microsoft.com/office/drawing/2014/main" id="{1B579716-BEDF-683E-D5D7-3B75C67B180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51" name="グループ化 450">
              <a:extLst>
                <a:ext uri="{FF2B5EF4-FFF2-40B4-BE49-F238E27FC236}">
                  <a16:creationId xmlns:a16="http://schemas.microsoft.com/office/drawing/2014/main" id="{6B4A2CA0-234A-F822-1A22-CFD68BCA5934}"/>
                </a:ext>
              </a:extLst>
            </p:cNvPr>
            <p:cNvGrpSpPr/>
            <p:nvPr/>
          </p:nvGrpSpPr>
          <p:grpSpPr>
            <a:xfrm>
              <a:off x="2522142" y="4361810"/>
              <a:ext cx="1582628" cy="2040399"/>
              <a:chOff x="2522142" y="4361810"/>
              <a:chExt cx="1582628" cy="2040399"/>
            </a:xfrm>
          </p:grpSpPr>
          <p:sp>
            <p:nvSpPr>
              <p:cNvPr id="30" name="TextBox 68">
                <a:extLst>
                  <a:ext uri="{FF2B5EF4-FFF2-40B4-BE49-F238E27FC236}">
                    <a16:creationId xmlns:a16="http://schemas.microsoft.com/office/drawing/2014/main" id="{B6D13816-8395-A211-FD4C-054848686EE8}"/>
                  </a:ext>
                </a:extLst>
              </p:cNvPr>
              <p:cNvSpPr txBox="1"/>
              <p:nvPr/>
            </p:nvSpPr>
            <p:spPr>
              <a:xfrm>
                <a:off x="2971727" y="4539446"/>
                <a:ext cx="3176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 err="1">
                    <a:latin typeface="Helvetica" pitchFamily="2" charset="0"/>
                  </a:rPr>
                  <a:t>wt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sp>
            <p:nvSpPr>
              <p:cNvPr id="31" name="TextBox 69">
                <a:extLst>
                  <a:ext uri="{FF2B5EF4-FFF2-40B4-BE49-F238E27FC236}">
                    <a16:creationId xmlns:a16="http://schemas.microsoft.com/office/drawing/2014/main" id="{87EF0DA4-213B-AEB1-2A93-8205699D2C8F}"/>
                  </a:ext>
                </a:extLst>
              </p:cNvPr>
              <p:cNvSpPr txBox="1"/>
              <p:nvPr/>
            </p:nvSpPr>
            <p:spPr>
              <a:xfrm>
                <a:off x="3461187" y="4535668"/>
                <a:ext cx="5323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Helvetica" pitchFamily="2" charset="0"/>
                  </a:rPr>
                  <a:t>moa1Δ 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graphicFrame>
            <p:nvGraphicFramePr>
              <p:cNvPr id="39" name="图表 55">
                <a:extLst>
                  <a:ext uri="{FF2B5EF4-FFF2-40B4-BE49-F238E27FC236}">
                    <a16:creationId xmlns:a16="http://schemas.microsoft.com/office/drawing/2014/main" id="{767BD2C3-6971-5DE0-7CBE-0D4A9B46F5B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74884962"/>
                  </p:ext>
                </p:extLst>
              </p:nvPr>
            </p:nvGraphicFramePr>
            <p:xfrm>
              <a:off x="2522142" y="4588074"/>
              <a:ext cx="1582628" cy="168413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cxnSp>
            <p:nvCxnSpPr>
              <p:cNvPr id="325" name="直線コネクタ 458">
                <a:extLst>
                  <a:ext uri="{FF2B5EF4-FFF2-40B4-BE49-F238E27FC236}">
                    <a16:creationId xmlns:a16="http://schemas.microsoft.com/office/drawing/2014/main" id="{A56FD445-C45A-79EF-6433-5FFE01E08C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5823" y="4557493"/>
                <a:ext cx="109100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0" name="TextBox 67">
                <a:extLst>
                  <a:ext uri="{FF2B5EF4-FFF2-40B4-BE49-F238E27FC236}">
                    <a16:creationId xmlns:a16="http://schemas.microsoft.com/office/drawing/2014/main" id="{572D084A-27BE-CCDD-3B39-90CFD1BE387C}"/>
                  </a:ext>
                </a:extLst>
              </p:cNvPr>
              <p:cNvSpPr txBox="1"/>
              <p:nvPr/>
            </p:nvSpPr>
            <p:spPr>
              <a:xfrm>
                <a:off x="2925359" y="4361810"/>
                <a:ext cx="97263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Helvetica" pitchFamily="2" charset="0"/>
                  </a:rPr>
                  <a:t>Rec8-GFP  IP(%)</a:t>
                </a:r>
                <a:endParaRPr lang="zh-CN" altLang="en-US" sz="800" dirty="0">
                  <a:latin typeface="Helvetica" pitchFamily="2" charset="0"/>
                </a:endParaRPr>
              </a:p>
            </p:txBody>
          </p:sp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8F1DEAE2-659E-CE84-9BBC-144EEB355BE7}"/>
                  </a:ext>
                </a:extLst>
              </p:cNvPr>
              <p:cNvGrpSpPr/>
              <p:nvPr/>
            </p:nvGrpSpPr>
            <p:grpSpPr>
              <a:xfrm>
                <a:off x="2832938" y="6032897"/>
                <a:ext cx="1130451" cy="369312"/>
                <a:chOff x="1288767" y="6021692"/>
                <a:chExt cx="1130451" cy="369312"/>
              </a:xfrm>
            </p:grpSpPr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2FC21E60-7946-2E3A-5696-F02D51DC4C5F}"/>
                    </a:ext>
                  </a:extLst>
                </p:cNvPr>
                <p:cNvGrpSpPr/>
                <p:nvPr/>
              </p:nvGrpSpPr>
              <p:grpSpPr>
                <a:xfrm>
                  <a:off x="1862508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21" name="TextBox 31">
                    <a:extLst>
                      <a:ext uri="{FF2B5EF4-FFF2-40B4-BE49-F238E27FC236}">
                        <a16:creationId xmlns:a16="http://schemas.microsoft.com/office/drawing/2014/main" id="{EB73724B-052E-1B48-822B-9E3EB4D622E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22" name="TextBox 33">
                    <a:extLst>
                      <a:ext uri="{FF2B5EF4-FFF2-40B4-BE49-F238E27FC236}">
                        <a16:creationId xmlns:a16="http://schemas.microsoft.com/office/drawing/2014/main" id="{678A1662-899D-F731-392C-F1E8360A962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23" name="TextBox 34">
                    <a:extLst>
                      <a:ext uri="{FF2B5EF4-FFF2-40B4-BE49-F238E27FC236}">
                        <a16:creationId xmlns:a16="http://schemas.microsoft.com/office/drawing/2014/main" id="{3A1F4426-4F0B-C3B1-AB5E-E4E1115E6BA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27" name="TextBox 30">
                    <a:extLst>
                      <a:ext uri="{FF2B5EF4-FFF2-40B4-BE49-F238E27FC236}">
                        <a16:creationId xmlns:a16="http://schemas.microsoft.com/office/drawing/2014/main" id="{7945DCD2-CDB2-C5C0-2D12-361BC2A05FE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  <p:grpSp>
              <p:nvGrpSpPr>
                <p:cNvPr id="16" name="グループ化 15">
                  <a:extLst>
                    <a:ext uri="{FF2B5EF4-FFF2-40B4-BE49-F238E27FC236}">
                      <a16:creationId xmlns:a16="http://schemas.microsoft.com/office/drawing/2014/main" id="{D995C6F0-1E47-E4E7-8C94-7F996676F4AF}"/>
                    </a:ext>
                  </a:extLst>
                </p:cNvPr>
                <p:cNvGrpSpPr/>
                <p:nvPr/>
              </p:nvGrpSpPr>
              <p:grpSpPr>
                <a:xfrm>
                  <a:off x="1288767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17" name="TextBox 31">
                    <a:extLst>
                      <a:ext uri="{FF2B5EF4-FFF2-40B4-BE49-F238E27FC236}">
                        <a16:creationId xmlns:a16="http://schemas.microsoft.com/office/drawing/2014/main" id="{288BA9F0-A949-F78C-5683-9760926664C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8" name="TextBox 33">
                    <a:extLst>
                      <a:ext uri="{FF2B5EF4-FFF2-40B4-BE49-F238E27FC236}">
                        <a16:creationId xmlns:a16="http://schemas.microsoft.com/office/drawing/2014/main" id="{D12170FA-2747-A0B5-103F-095484BAB49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19" name="TextBox 34">
                    <a:extLst>
                      <a:ext uri="{FF2B5EF4-FFF2-40B4-BE49-F238E27FC236}">
                        <a16:creationId xmlns:a16="http://schemas.microsoft.com/office/drawing/2014/main" id="{8C0E4591-462B-FB42-C0BE-9955A000E41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20" name="TextBox 30">
                    <a:extLst>
                      <a:ext uri="{FF2B5EF4-FFF2-40B4-BE49-F238E27FC236}">
                        <a16:creationId xmlns:a16="http://schemas.microsoft.com/office/drawing/2014/main" id="{7AB500D7-97D0-2F40-6394-859E3B09619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</p:grpSp>
        </p:grpSp>
        <p:grpSp>
          <p:nvGrpSpPr>
            <p:cNvPr id="450" name="グループ化 449">
              <a:extLst>
                <a:ext uri="{FF2B5EF4-FFF2-40B4-BE49-F238E27FC236}">
                  <a16:creationId xmlns:a16="http://schemas.microsoft.com/office/drawing/2014/main" id="{37C10912-6155-E04D-94D8-6116844CBF56}"/>
                </a:ext>
              </a:extLst>
            </p:cNvPr>
            <p:cNvGrpSpPr/>
            <p:nvPr/>
          </p:nvGrpSpPr>
          <p:grpSpPr>
            <a:xfrm>
              <a:off x="4133726" y="4361569"/>
              <a:ext cx="1430649" cy="2030556"/>
              <a:chOff x="4133726" y="4361569"/>
              <a:chExt cx="1430649" cy="2030556"/>
            </a:xfrm>
          </p:grpSpPr>
          <p:sp>
            <p:nvSpPr>
              <p:cNvPr id="24" name="TextBox 68">
                <a:extLst>
                  <a:ext uri="{FF2B5EF4-FFF2-40B4-BE49-F238E27FC236}">
                    <a16:creationId xmlns:a16="http://schemas.microsoft.com/office/drawing/2014/main" id="{F8096662-2F29-6398-021E-F0E9FF7A6D6A}"/>
                  </a:ext>
                </a:extLst>
              </p:cNvPr>
              <p:cNvSpPr txBox="1"/>
              <p:nvPr/>
            </p:nvSpPr>
            <p:spPr>
              <a:xfrm>
                <a:off x="4480100" y="4521023"/>
                <a:ext cx="3136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 err="1">
                    <a:latin typeface="Helvetica" pitchFamily="2" charset="0"/>
                  </a:rPr>
                  <a:t>wt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sp>
            <p:nvSpPr>
              <p:cNvPr id="25" name="TextBox 69">
                <a:extLst>
                  <a:ext uri="{FF2B5EF4-FFF2-40B4-BE49-F238E27FC236}">
                    <a16:creationId xmlns:a16="http://schemas.microsoft.com/office/drawing/2014/main" id="{CA064D95-04AA-D14D-1E59-3555E4D2E5DD}"/>
                  </a:ext>
                </a:extLst>
              </p:cNvPr>
              <p:cNvSpPr txBox="1"/>
              <p:nvPr/>
            </p:nvSpPr>
            <p:spPr>
              <a:xfrm>
                <a:off x="5012461" y="4524802"/>
                <a:ext cx="5257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i="1" dirty="0">
                    <a:latin typeface="Helvetica" pitchFamily="2" charset="0"/>
                  </a:rPr>
                  <a:t>moa1Δ </a:t>
                </a:r>
                <a:endParaRPr lang="zh-CN" altLang="en-US" sz="800" i="1" dirty="0">
                  <a:latin typeface="Helvetica" pitchFamily="2" charset="0"/>
                </a:endParaRPr>
              </a:p>
            </p:txBody>
          </p:sp>
          <p:cxnSp>
            <p:nvCxnSpPr>
              <p:cNvPr id="26" name="直線コネクタ 458">
                <a:extLst>
                  <a:ext uri="{FF2B5EF4-FFF2-40B4-BE49-F238E27FC236}">
                    <a16:creationId xmlns:a16="http://schemas.microsoft.com/office/drawing/2014/main" id="{BB3A90B0-F605-7A74-A912-4BE4F883AE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4636" y="4546860"/>
                <a:ext cx="109100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40" name="图表 56">
                <a:extLst>
                  <a:ext uri="{FF2B5EF4-FFF2-40B4-BE49-F238E27FC236}">
                    <a16:creationId xmlns:a16="http://schemas.microsoft.com/office/drawing/2014/main" id="{5653EFE8-FDD5-2A85-6603-0C770CC02BE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84760577"/>
                  </p:ext>
                </p:extLst>
              </p:nvPr>
            </p:nvGraphicFramePr>
            <p:xfrm>
              <a:off x="4133726" y="4575045"/>
              <a:ext cx="1430649" cy="16910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31" name="TextBox 67">
                <a:extLst>
                  <a:ext uri="{FF2B5EF4-FFF2-40B4-BE49-F238E27FC236}">
                    <a16:creationId xmlns:a16="http://schemas.microsoft.com/office/drawing/2014/main" id="{BC9CF774-B79E-7378-1EC1-4522895BECD6}"/>
                  </a:ext>
                </a:extLst>
              </p:cNvPr>
              <p:cNvSpPr txBox="1"/>
              <p:nvPr/>
            </p:nvSpPr>
            <p:spPr>
              <a:xfrm>
                <a:off x="4486550" y="4361569"/>
                <a:ext cx="9740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Helvetica" pitchFamily="2" charset="0"/>
                  </a:rPr>
                  <a:t>Pds5-GFP  IP(%)</a:t>
                </a:r>
                <a:endParaRPr lang="zh-CN" altLang="en-US" sz="800" dirty="0">
                  <a:latin typeface="Helvetica" pitchFamily="2" charset="0"/>
                </a:endParaRPr>
              </a:p>
            </p:txBody>
          </p:sp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75D82F66-1C76-329E-6301-8EB7E61453A6}"/>
                  </a:ext>
                </a:extLst>
              </p:cNvPr>
              <p:cNvGrpSpPr/>
              <p:nvPr/>
            </p:nvGrpSpPr>
            <p:grpSpPr>
              <a:xfrm>
                <a:off x="4382711" y="6022813"/>
                <a:ext cx="1130451" cy="369312"/>
                <a:chOff x="1288767" y="6021692"/>
                <a:chExt cx="1130451" cy="369312"/>
              </a:xfrm>
            </p:grpSpPr>
            <p:grpSp>
              <p:nvGrpSpPr>
                <p:cNvPr id="29" name="グループ化 28">
                  <a:extLst>
                    <a:ext uri="{FF2B5EF4-FFF2-40B4-BE49-F238E27FC236}">
                      <a16:creationId xmlns:a16="http://schemas.microsoft.com/office/drawing/2014/main" id="{24A4B319-0596-0F38-9144-E7FFD363F3E8}"/>
                    </a:ext>
                  </a:extLst>
                </p:cNvPr>
                <p:cNvGrpSpPr/>
                <p:nvPr/>
              </p:nvGrpSpPr>
              <p:grpSpPr>
                <a:xfrm>
                  <a:off x="1862508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56" name="TextBox 31">
                    <a:extLst>
                      <a:ext uri="{FF2B5EF4-FFF2-40B4-BE49-F238E27FC236}">
                        <a16:creationId xmlns:a16="http://schemas.microsoft.com/office/drawing/2014/main" id="{1685F59F-3B0E-33F7-7DFF-693C4002EED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58" name="TextBox 33">
                    <a:extLst>
                      <a:ext uri="{FF2B5EF4-FFF2-40B4-BE49-F238E27FC236}">
                        <a16:creationId xmlns:a16="http://schemas.microsoft.com/office/drawing/2014/main" id="{D4BA01F3-793D-9133-7876-85C1BF27D26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448" name="TextBox 34">
                    <a:extLst>
                      <a:ext uri="{FF2B5EF4-FFF2-40B4-BE49-F238E27FC236}">
                        <a16:creationId xmlns:a16="http://schemas.microsoft.com/office/drawing/2014/main" id="{F7C76F20-FFF1-E56F-D0DF-53A5FD43B22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449" name="TextBox 30">
                    <a:extLst>
                      <a:ext uri="{FF2B5EF4-FFF2-40B4-BE49-F238E27FC236}">
                        <a16:creationId xmlns:a16="http://schemas.microsoft.com/office/drawing/2014/main" id="{55F19421-2308-A6C3-A4A5-4CF97447A5E2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  <p:grpSp>
              <p:nvGrpSpPr>
                <p:cNvPr id="32" name="グループ化 31">
                  <a:extLst>
                    <a:ext uri="{FF2B5EF4-FFF2-40B4-BE49-F238E27FC236}">
                      <a16:creationId xmlns:a16="http://schemas.microsoft.com/office/drawing/2014/main" id="{AC0208DF-1AF8-2A03-9EA5-4D0716322AF0}"/>
                    </a:ext>
                  </a:extLst>
                </p:cNvPr>
                <p:cNvGrpSpPr/>
                <p:nvPr/>
              </p:nvGrpSpPr>
              <p:grpSpPr>
                <a:xfrm>
                  <a:off x="1288767" y="6021692"/>
                  <a:ext cx="556710" cy="369312"/>
                  <a:chOff x="1862508" y="6023933"/>
                  <a:chExt cx="556710" cy="369312"/>
                </a:xfrm>
              </p:grpSpPr>
              <p:sp>
                <p:nvSpPr>
                  <p:cNvPr id="33" name="TextBox 31">
                    <a:extLst>
                      <a:ext uri="{FF2B5EF4-FFF2-40B4-BE49-F238E27FC236}">
                        <a16:creationId xmlns:a16="http://schemas.microsoft.com/office/drawing/2014/main" id="{D6FA5656-A25C-FB75-08B0-A777CD8449C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893905" y="6101473"/>
                    <a:ext cx="36810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imr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3F0CF453-1033-2B2C-E691-11CA1868CEC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36503" y="6091204"/>
                    <a:ext cx="34998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h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36" name="TextBox 34">
                    <a:extLst>
                      <a:ext uri="{FF2B5EF4-FFF2-40B4-BE49-F238E27FC236}">
                        <a16:creationId xmlns:a16="http://schemas.microsoft.com/office/drawing/2014/main" id="{B2F1EAC6-A001-B576-578F-1169E05DAF5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22042" y="6096219"/>
                    <a:ext cx="33911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>
                        <a:latin typeface="Helvetica" pitchFamily="2" charset="0"/>
                      </a:rPr>
                      <a:t>dg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  <p:sp>
                <p:nvSpPr>
                  <p:cNvPr id="52" name="TextBox 30">
                    <a:extLst>
                      <a:ext uri="{FF2B5EF4-FFF2-40B4-BE49-F238E27FC236}">
                        <a16:creationId xmlns:a16="http://schemas.microsoft.com/office/drawing/2014/main" id="{45B28317-1BC9-0083-95CD-2BBDBF7DBEC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787990" y="6101849"/>
                    <a:ext cx="36447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i="1" dirty="0" err="1">
                        <a:latin typeface="Helvetica" pitchFamily="2" charset="0"/>
                      </a:rPr>
                      <a:t>cnt</a:t>
                    </a:r>
                    <a:endParaRPr lang="zh-CN" altLang="en-US" sz="800" i="1" dirty="0">
                      <a:latin typeface="Helvetica" pitchFamily="2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3305683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emp" id="{FBF33D0E-E0EE-F34C-9372-F1582E94FFC8}" vid="{3D4EC240-48E7-BC4A-9F7A-934F0423D57D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13207</TotalTime>
  <Words>63</Words>
  <Application>Microsoft Macintosh PowerPoint</Application>
  <PresentationFormat>A4 210 x 297 mm</PresentationFormat>
  <Paragraphs>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watanab1466@icloud.com</dc:creator>
  <cp:lastModifiedBy>ywatanab1466@icloud.com</cp:lastModifiedBy>
  <cp:revision>95</cp:revision>
  <cp:lastPrinted>2022-09-20T09:24:24Z</cp:lastPrinted>
  <dcterms:created xsi:type="dcterms:W3CDTF">2021-09-09T00:34:29Z</dcterms:created>
  <dcterms:modified xsi:type="dcterms:W3CDTF">2024-02-27T10:26:19Z</dcterms:modified>
</cp:coreProperties>
</file>